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6" r:id="rId3"/>
    <p:sldId id="263" r:id="rId4"/>
    <p:sldId id="257" r:id="rId5"/>
    <p:sldId id="259" r:id="rId6"/>
    <p:sldId id="258" r:id="rId7"/>
    <p:sldId id="261" r:id="rId8"/>
    <p:sldId id="262" r:id="rId9"/>
    <p:sldId id="264" r:id="rId10"/>
  </p:sldIdLst>
  <p:sldSz cx="42808525" cy="30279975"/>
  <p:notesSz cx="7104063" cy="10234613"/>
  <p:defaultTextStyle>
    <a:defPPr>
      <a:defRPr lang="en-US"/>
    </a:defPPr>
    <a:lvl1pPr marL="0" algn="l" defTabSz="4176431" rtl="0" eaLnBrk="1" latinLnBrk="0" hangingPunct="1">
      <a:defRPr sz="8200" kern="1200">
        <a:solidFill>
          <a:schemeClr val="tx1"/>
        </a:solidFill>
        <a:latin typeface="+mn-lt"/>
        <a:ea typeface="+mn-ea"/>
        <a:cs typeface="+mn-cs"/>
      </a:defRPr>
    </a:lvl1pPr>
    <a:lvl2pPr marL="2088215" algn="l" defTabSz="4176431" rtl="0" eaLnBrk="1" latinLnBrk="0" hangingPunct="1">
      <a:defRPr sz="8200" kern="1200">
        <a:solidFill>
          <a:schemeClr val="tx1"/>
        </a:solidFill>
        <a:latin typeface="+mn-lt"/>
        <a:ea typeface="+mn-ea"/>
        <a:cs typeface="+mn-cs"/>
      </a:defRPr>
    </a:lvl2pPr>
    <a:lvl3pPr marL="4176431" algn="l" defTabSz="4176431" rtl="0" eaLnBrk="1" latinLnBrk="0" hangingPunct="1">
      <a:defRPr sz="8200" kern="1200">
        <a:solidFill>
          <a:schemeClr val="tx1"/>
        </a:solidFill>
        <a:latin typeface="+mn-lt"/>
        <a:ea typeface="+mn-ea"/>
        <a:cs typeface="+mn-cs"/>
      </a:defRPr>
    </a:lvl3pPr>
    <a:lvl4pPr marL="6264646" algn="l" defTabSz="4176431" rtl="0" eaLnBrk="1" latinLnBrk="0" hangingPunct="1">
      <a:defRPr sz="8200" kern="1200">
        <a:solidFill>
          <a:schemeClr val="tx1"/>
        </a:solidFill>
        <a:latin typeface="+mn-lt"/>
        <a:ea typeface="+mn-ea"/>
        <a:cs typeface="+mn-cs"/>
      </a:defRPr>
    </a:lvl4pPr>
    <a:lvl5pPr marL="8352861" algn="l" defTabSz="4176431" rtl="0" eaLnBrk="1" latinLnBrk="0" hangingPunct="1">
      <a:defRPr sz="8200" kern="1200">
        <a:solidFill>
          <a:schemeClr val="tx1"/>
        </a:solidFill>
        <a:latin typeface="+mn-lt"/>
        <a:ea typeface="+mn-ea"/>
        <a:cs typeface="+mn-cs"/>
      </a:defRPr>
    </a:lvl5pPr>
    <a:lvl6pPr marL="10441076" algn="l" defTabSz="4176431" rtl="0" eaLnBrk="1" latinLnBrk="0" hangingPunct="1">
      <a:defRPr sz="8200" kern="1200">
        <a:solidFill>
          <a:schemeClr val="tx1"/>
        </a:solidFill>
        <a:latin typeface="+mn-lt"/>
        <a:ea typeface="+mn-ea"/>
        <a:cs typeface="+mn-cs"/>
      </a:defRPr>
    </a:lvl6pPr>
    <a:lvl7pPr marL="12529292" algn="l" defTabSz="4176431" rtl="0" eaLnBrk="1" latinLnBrk="0" hangingPunct="1">
      <a:defRPr sz="8200" kern="1200">
        <a:solidFill>
          <a:schemeClr val="tx1"/>
        </a:solidFill>
        <a:latin typeface="+mn-lt"/>
        <a:ea typeface="+mn-ea"/>
        <a:cs typeface="+mn-cs"/>
      </a:defRPr>
    </a:lvl7pPr>
    <a:lvl8pPr marL="14617507" algn="l" defTabSz="4176431" rtl="0" eaLnBrk="1" latinLnBrk="0" hangingPunct="1">
      <a:defRPr sz="8200" kern="1200">
        <a:solidFill>
          <a:schemeClr val="tx1"/>
        </a:solidFill>
        <a:latin typeface="+mn-lt"/>
        <a:ea typeface="+mn-ea"/>
        <a:cs typeface="+mn-cs"/>
      </a:defRPr>
    </a:lvl8pPr>
    <a:lvl9pPr marL="16705722" algn="l" defTabSz="4176431" rtl="0" eaLnBrk="1" latinLnBrk="0" hangingPunct="1">
      <a:defRPr sz="82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28" d="100"/>
          <a:sy n="28" d="100"/>
        </p:scale>
        <p:origin x="-1002" y="-138"/>
      </p:cViewPr>
      <p:guideLst>
        <p:guide orient="horz" pos="9537"/>
        <p:guide pos="1348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210640" y="9406420"/>
            <a:ext cx="36387246" cy="64905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421279" y="17158652"/>
            <a:ext cx="29965968" cy="773821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20882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41764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62646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83528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044107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25292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461750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670572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AE298-1C5B-47B9-925C-30FE64037809}" type="datetimeFigureOut">
              <a:rPr lang="en-US" smtClean="0"/>
              <a:t>2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70EF8-EA7F-4DF1-85C5-1D4D29207B4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9110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AE298-1C5B-47B9-925C-30FE64037809}" type="datetimeFigureOut">
              <a:rPr lang="en-US" smtClean="0"/>
              <a:t>2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70EF8-EA7F-4DF1-85C5-1D4D29207B4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96666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1036181" y="1212605"/>
            <a:ext cx="9631918" cy="2583610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140426" y="1212605"/>
            <a:ext cx="28182279" cy="2583610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AE298-1C5B-47B9-925C-30FE64037809}" type="datetimeFigureOut">
              <a:rPr lang="en-US" smtClean="0"/>
              <a:t>2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70EF8-EA7F-4DF1-85C5-1D4D29207B4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68699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AE298-1C5B-47B9-925C-30FE64037809}" type="datetimeFigureOut">
              <a:rPr lang="en-US" smtClean="0"/>
              <a:t>2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70EF8-EA7F-4DF1-85C5-1D4D29207B4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15394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381579" y="19457690"/>
            <a:ext cx="36387246" cy="6013939"/>
          </a:xfrm>
        </p:spPr>
        <p:txBody>
          <a:bodyPr anchor="t"/>
          <a:lstStyle>
            <a:lvl1pPr algn="l">
              <a:defRPr sz="183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381579" y="12833948"/>
            <a:ext cx="36387246" cy="6623742"/>
          </a:xfrm>
        </p:spPr>
        <p:txBody>
          <a:bodyPr anchor="b"/>
          <a:lstStyle>
            <a:lvl1pPr marL="0" indent="0">
              <a:buNone/>
              <a:defRPr sz="9100">
                <a:solidFill>
                  <a:schemeClr val="tx1">
                    <a:tint val="75000"/>
                  </a:schemeClr>
                </a:solidFill>
              </a:defRPr>
            </a:lvl1pPr>
            <a:lvl2pPr marL="2088215" indent="0">
              <a:buNone/>
              <a:defRPr sz="8200">
                <a:solidFill>
                  <a:schemeClr val="tx1">
                    <a:tint val="75000"/>
                  </a:schemeClr>
                </a:solidFill>
              </a:defRPr>
            </a:lvl2pPr>
            <a:lvl3pPr marL="4176431" indent="0">
              <a:buNone/>
              <a:defRPr sz="7300">
                <a:solidFill>
                  <a:schemeClr val="tx1">
                    <a:tint val="75000"/>
                  </a:schemeClr>
                </a:solidFill>
              </a:defRPr>
            </a:lvl3pPr>
            <a:lvl4pPr marL="6264646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4pPr>
            <a:lvl5pPr marL="8352861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5pPr>
            <a:lvl6pPr marL="10441076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6pPr>
            <a:lvl7pPr marL="12529292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7pPr>
            <a:lvl8pPr marL="14617507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8pPr>
            <a:lvl9pPr marL="16705722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AE298-1C5B-47B9-925C-30FE64037809}" type="datetimeFigureOut">
              <a:rPr lang="en-US" smtClean="0"/>
              <a:t>2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70EF8-EA7F-4DF1-85C5-1D4D29207B4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29278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140426" y="7065330"/>
            <a:ext cx="18907099" cy="19983384"/>
          </a:xfrm>
        </p:spPr>
        <p:txBody>
          <a:bodyPr/>
          <a:lstStyle>
            <a:lvl1pPr>
              <a:defRPr sz="12800"/>
            </a:lvl1pPr>
            <a:lvl2pPr>
              <a:defRPr sz="11000"/>
            </a:lvl2pPr>
            <a:lvl3pPr>
              <a:defRPr sz="9100"/>
            </a:lvl3pPr>
            <a:lvl4pPr>
              <a:defRPr sz="8200"/>
            </a:lvl4pPr>
            <a:lvl5pPr>
              <a:defRPr sz="8200"/>
            </a:lvl5pPr>
            <a:lvl6pPr>
              <a:defRPr sz="8200"/>
            </a:lvl6pPr>
            <a:lvl7pPr>
              <a:defRPr sz="8200"/>
            </a:lvl7pPr>
            <a:lvl8pPr>
              <a:defRPr sz="8200"/>
            </a:lvl8pPr>
            <a:lvl9pPr>
              <a:defRPr sz="8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1761000" y="7065330"/>
            <a:ext cx="18907099" cy="19983384"/>
          </a:xfrm>
        </p:spPr>
        <p:txBody>
          <a:bodyPr/>
          <a:lstStyle>
            <a:lvl1pPr>
              <a:defRPr sz="12800"/>
            </a:lvl1pPr>
            <a:lvl2pPr>
              <a:defRPr sz="11000"/>
            </a:lvl2pPr>
            <a:lvl3pPr>
              <a:defRPr sz="9100"/>
            </a:lvl3pPr>
            <a:lvl4pPr>
              <a:defRPr sz="8200"/>
            </a:lvl4pPr>
            <a:lvl5pPr>
              <a:defRPr sz="8200"/>
            </a:lvl5pPr>
            <a:lvl6pPr>
              <a:defRPr sz="8200"/>
            </a:lvl6pPr>
            <a:lvl7pPr>
              <a:defRPr sz="8200"/>
            </a:lvl7pPr>
            <a:lvl8pPr>
              <a:defRPr sz="8200"/>
            </a:lvl8pPr>
            <a:lvl9pPr>
              <a:defRPr sz="8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AE298-1C5B-47B9-925C-30FE64037809}" type="datetimeFigureOut">
              <a:rPr lang="en-US" smtClean="0"/>
              <a:t>2/1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70EF8-EA7F-4DF1-85C5-1D4D29207B4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31510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140426" y="6777950"/>
            <a:ext cx="18914533" cy="2824727"/>
          </a:xfrm>
        </p:spPr>
        <p:txBody>
          <a:bodyPr anchor="b"/>
          <a:lstStyle>
            <a:lvl1pPr marL="0" indent="0">
              <a:buNone/>
              <a:defRPr sz="11000" b="1"/>
            </a:lvl1pPr>
            <a:lvl2pPr marL="2088215" indent="0">
              <a:buNone/>
              <a:defRPr sz="9100" b="1"/>
            </a:lvl2pPr>
            <a:lvl3pPr marL="4176431" indent="0">
              <a:buNone/>
              <a:defRPr sz="8200" b="1"/>
            </a:lvl3pPr>
            <a:lvl4pPr marL="6264646" indent="0">
              <a:buNone/>
              <a:defRPr sz="7300" b="1"/>
            </a:lvl4pPr>
            <a:lvl5pPr marL="8352861" indent="0">
              <a:buNone/>
              <a:defRPr sz="7300" b="1"/>
            </a:lvl5pPr>
            <a:lvl6pPr marL="10441076" indent="0">
              <a:buNone/>
              <a:defRPr sz="7300" b="1"/>
            </a:lvl6pPr>
            <a:lvl7pPr marL="12529292" indent="0">
              <a:buNone/>
              <a:defRPr sz="7300" b="1"/>
            </a:lvl7pPr>
            <a:lvl8pPr marL="14617507" indent="0">
              <a:buNone/>
              <a:defRPr sz="7300" b="1"/>
            </a:lvl8pPr>
            <a:lvl9pPr marL="16705722" indent="0">
              <a:buNone/>
              <a:defRPr sz="73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140426" y="9602677"/>
            <a:ext cx="18914533" cy="17446034"/>
          </a:xfrm>
        </p:spPr>
        <p:txBody>
          <a:bodyPr/>
          <a:lstStyle>
            <a:lvl1pPr>
              <a:defRPr sz="11000"/>
            </a:lvl1pPr>
            <a:lvl2pPr>
              <a:defRPr sz="9100"/>
            </a:lvl2pPr>
            <a:lvl3pPr>
              <a:defRPr sz="8200"/>
            </a:lvl3pPr>
            <a:lvl4pPr>
              <a:defRPr sz="7300"/>
            </a:lvl4pPr>
            <a:lvl5pPr>
              <a:defRPr sz="7300"/>
            </a:lvl5pPr>
            <a:lvl6pPr>
              <a:defRPr sz="7300"/>
            </a:lvl6pPr>
            <a:lvl7pPr>
              <a:defRPr sz="7300"/>
            </a:lvl7pPr>
            <a:lvl8pPr>
              <a:defRPr sz="7300"/>
            </a:lvl8pPr>
            <a:lvl9pPr>
              <a:defRPr sz="7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1746138" y="6777950"/>
            <a:ext cx="18921963" cy="2824727"/>
          </a:xfrm>
        </p:spPr>
        <p:txBody>
          <a:bodyPr anchor="b"/>
          <a:lstStyle>
            <a:lvl1pPr marL="0" indent="0">
              <a:buNone/>
              <a:defRPr sz="11000" b="1"/>
            </a:lvl1pPr>
            <a:lvl2pPr marL="2088215" indent="0">
              <a:buNone/>
              <a:defRPr sz="9100" b="1"/>
            </a:lvl2pPr>
            <a:lvl3pPr marL="4176431" indent="0">
              <a:buNone/>
              <a:defRPr sz="8200" b="1"/>
            </a:lvl3pPr>
            <a:lvl4pPr marL="6264646" indent="0">
              <a:buNone/>
              <a:defRPr sz="7300" b="1"/>
            </a:lvl4pPr>
            <a:lvl5pPr marL="8352861" indent="0">
              <a:buNone/>
              <a:defRPr sz="7300" b="1"/>
            </a:lvl5pPr>
            <a:lvl6pPr marL="10441076" indent="0">
              <a:buNone/>
              <a:defRPr sz="7300" b="1"/>
            </a:lvl6pPr>
            <a:lvl7pPr marL="12529292" indent="0">
              <a:buNone/>
              <a:defRPr sz="7300" b="1"/>
            </a:lvl7pPr>
            <a:lvl8pPr marL="14617507" indent="0">
              <a:buNone/>
              <a:defRPr sz="7300" b="1"/>
            </a:lvl8pPr>
            <a:lvl9pPr marL="16705722" indent="0">
              <a:buNone/>
              <a:defRPr sz="73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1746138" y="9602677"/>
            <a:ext cx="18921963" cy="17446034"/>
          </a:xfrm>
        </p:spPr>
        <p:txBody>
          <a:bodyPr/>
          <a:lstStyle>
            <a:lvl1pPr>
              <a:defRPr sz="11000"/>
            </a:lvl1pPr>
            <a:lvl2pPr>
              <a:defRPr sz="9100"/>
            </a:lvl2pPr>
            <a:lvl3pPr>
              <a:defRPr sz="8200"/>
            </a:lvl3pPr>
            <a:lvl4pPr>
              <a:defRPr sz="7300"/>
            </a:lvl4pPr>
            <a:lvl5pPr>
              <a:defRPr sz="7300"/>
            </a:lvl5pPr>
            <a:lvl6pPr>
              <a:defRPr sz="7300"/>
            </a:lvl6pPr>
            <a:lvl7pPr>
              <a:defRPr sz="7300"/>
            </a:lvl7pPr>
            <a:lvl8pPr>
              <a:defRPr sz="7300"/>
            </a:lvl8pPr>
            <a:lvl9pPr>
              <a:defRPr sz="7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AE298-1C5B-47B9-925C-30FE64037809}" type="datetimeFigureOut">
              <a:rPr lang="en-US" smtClean="0"/>
              <a:t>2/1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70EF8-EA7F-4DF1-85C5-1D4D29207B4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76419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AE298-1C5B-47B9-925C-30FE64037809}" type="datetimeFigureOut">
              <a:rPr lang="en-US" smtClean="0"/>
              <a:t>2/1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70EF8-EA7F-4DF1-85C5-1D4D29207B4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33935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AE298-1C5B-47B9-925C-30FE64037809}" type="datetimeFigureOut">
              <a:rPr lang="en-US" smtClean="0"/>
              <a:t>2/1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70EF8-EA7F-4DF1-85C5-1D4D29207B4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08258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40428" y="1205591"/>
            <a:ext cx="14083710" cy="5130774"/>
          </a:xfrm>
        </p:spPr>
        <p:txBody>
          <a:bodyPr anchor="b"/>
          <a:lstStyle>
            <a:lvl1pPr algn="l">
              <a:defRPr sz="91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6736944" y="1205594"/>
            <a:ext cx="23931155" cy="25843120"/>
          </a:xfrm>
        </p:spPr>
        <p:txBody>
          <a:bodyPr/>
          <a:lstStyle>
            <a:lvl1pPr>
              <a:defRPr sz="14600"/>
            </a:lvl1pPr>
            <a:lvl2pPr>
              <a:defRPr sz="12800"/>
            </a:lvl2pPr>
            <a:lvl3pPr>
              <a:defRPr sz="11000"/>
            </a:lvl3pPr>
            <a:lvl4pPr>
              <a:defRPr sz="9100"/>
            </a:lvl4pPr>
            <a:lvl5pPr>
              <a:defRPr sz="9100"/>
            </a:lvl5pPr>
            <a:lvl6pPr>
              <a:defRPr sz="9100"/>
            </a:lvl6pPr>
            <a:lvl7pPr>
              <a:defRPr sz="9100"/>
            </a:lvl7pPr>
            <a:lvl8pPr>
              <a:defRPr sz="9100"/>
            </a:lvl8pPr>
            <a:lvl9pPr>
              <a:defRPr sz="9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140428" y="6336367"/>
            <a:ext cx="14083710" cy="20712346"/>
          </a:xfrm>
        </p:spPr>
        <p:txBody>
          <a:bodyPr/>
          <a:lstStyle>
            <a:lvl1pPr marL="0" indent="0">
              <a:buNone/>
              <a:defRPr sz="6400"/>
            </a:lvl1pPr>
            <a:lvl2pPr marL="2088215" indent="0">
              <a:buNone/>
              <a:defRPr sz="5500"/>
            </a:lvl2pPr>
            <a:lvl3pPr marL="4176431" indent="0">
              <a:buNone/>
              <a:defRPr sz="4600"/>
            </a:lvl3pPr>
            <a:lvl4pPr marL="6264646" indent="0">
              <a:buNone/>
              <a:defRPr sz="4100"/>
            </a:lvl4pPr>
            <a:lvl5pPr marL="8352861" indent="0">
              <a:buNone/>
              <a:defRPr sz="4100"/>
            </a:lvl5pPr>
            <a:lvl6pPr marL="10441076" indent="0">
              <a:buNone/>
              <a:defRPr sz="4100"/>
            </a:lvl6pPr>
            <a:lvl7pPr marL="12529292" indent="0">
              <a:buNone/>
              <a:defRPr sz="4100"/>
            </a:lvl7pPr>
            <a:lvl8pPr marL="14617507" indent="0">
              <a:buNone/>
              <a:defRPr sz="4100"/>
            </a:lvl8pPr>
            <a:lvl9pPr marL="16705722" indent="0">
              <a:buNone/>
              <a:defRPr sz="41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AE298-1C5B-47B9-925C-30FE64037809}" type="datetimeFigureOut">
              <a:rPr lang="en-US" smtClean="0"/>
              <a:t>2/1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70EF8-EA7F-4DF1-85C5-1D4D29207B4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33463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0771" y="21195982"/>
            <a:ext cx="25685115" cy="2502306"/>
          </a:xfrm>
        </p:spPr>
        <p:txBody>
          <a:bodyPr anchor="b"/>
          <a:lstStyle>
            <a:lvl1pPr algn="l">
              <a:defRPr sz="91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8390771" y="2705572"/>
            <a:ext cx="25685115" cy="18167985"/>
          </a:xfrm>
        </p:spPr>
        <p:txBody>
          <a:bodyPr/>
          <a:lstStyle>
            <a:lvl1pPr marL="0" indent="0">
              <a:buNone/>
              <a:defRPr sz="14600"/>
            </a:lvl1pPr>
            <a:lvl2pPr marL="2088215" indent="0">
              <a:buNone/>
              <a:defRPr sz="12800"/>
            </a:lvl2pPr>
            <a:lvl3pPr marL="4176431" indent="0">
              <a:buNone/>
              <a:defRPr sz="11000"/>
            </a:lvl3pPr>
            <a:lvl4pPr marL="6264646" indent="0">
              <a:buNone/>
              <a:defRPr sz="9100"/>
            </a:lvl4pPr>
            <a:lvl5pPr marL="8352861" indent="0">
              <a:buNone/>
              <a:defRPr sz="9100"/>
            </a:lvl5pPr>
            <a:lvl6pPr marL="10441076" indent="0">
              <a:buNone/>
              <a:defRPr sz="9100"/>
            </a:lvl6pPr>
            <a:lvl7pPr marL="12529292" indent="0">
              <a:buNone/>
              <a:defRPr sz="9100"/>
            </a:lvl7pPr>
            <a:lvl8pPr marL="14617507" indent="0">
              <a:buNone/>
              <a:defRPr sz="9100"/>
            </a:lvl8pPr>
            <a:lvl9pPr marL="16705722" indent="0">
              <a:buNone/>
              <a:defRPr sz="91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0771" y="23698288"/>
            <a:ext cx="25685115" cy="3553689"/>
          </a:xfrm>
        </p:spPr>
        <p:txBody>
          <a:bodyPr/>
          <a:lstStyle>
            <a:lvl1pPr marL="0" indent="0">
              <a:buNone/>
              <a:defRPr sz="6400"/>
            </a:lvl1pPr>
            <a:lvl2pPr marL="2088215" indent="0">
              <a:buNone/>
              <a:defRPr sz="5500"/>
            </a:lvl2pPr>
            <a:lvl3pPr marL="4176431" indent="0">
              <a:buNone/>
              <a:defRPr sz="4600"/>
            </a:lvl3pPr>
            <a:lvl4pPr marL="6264646" indent="0">
              <a:buNone/>
              <a:defRPr sz="4100"/>
            </a:lvl4pPr>
            <a:lvl5pPr marL="8352861" indent="0">
              <a:buNone/>
              <a:defRPr sz="4100"/>
            </a:lvl5pPr>
            <a:lvl6pPr marL="10441076" indent="0">
              <a:buNone/>
              <a:defRPr sz="4100"/>
            </a:lvl6pPr>
            <a:lvl7pPr marL="12529292" indent="0">
              <a:buNone/>
              <a:defRPr sz="4100"/>
            </a:lvl7pPr>
            <a:lvl8pPr marL="14617507" indent="0">
              <a:buNone/>
              <a:defRPr sz="4100"/>
            </a:lvl8pPr>
            <a:lvl9pPr marL="16705722" indent="0">
              <a:buNone/>
              <a:defRPr sz="41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AE298-1C5B-47B9-925C-30FE64037809}" type="datetimeFigureOut">
              <a:rPr lang="en-US" smtClean="0"/>
              <a:t>2/1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70EF8-EA7F-4DF1-85C5-1D4D29207B4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88948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140426" y="1212603"/>
            <a:ext cx="38527673" cy="5046663"/>
          </a:xfrm>
          <a:prstGeom prst="rect">
            <a:avLst/>
          </a:prstGeom>
        </p:spPr>
        <p:txBody>
          <a:bodyPr vert="horz" lIns="417643" tIns="208822" rIns="417643" bIns="208822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140426" y="7065330"/>
            <a:ext cx="38527673" cy="19983384"/>
          </a:xfrm>
          <a:prstGeom prst="rect">
            <a:avLst/>
          </a:prstGeom>
        </p:spPr>
        <p:txBody>
          <a:bodyPr vert="horz" lIns="417643" tIns="208822" rIns="417643" bIns="208822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140426" y="28065053"/>
            <a:ext cx="9988656" cy="1612128"/>
          </a:xfrm>
          <a:prstGeom prst="rect">
            <a:avLst/>
          </a:prstGeom>
        </p:spPr>
        <p:txBody>
          <a:bodyPr vert="horz" lIns="417643" tIns="208822" rIns="417643" bIns="208822" rtlCol="0" anchor="ctr"/>
          <a:lstStyle>
            <a:lvl1pPr algn="l">
              <a:defRPr sz="5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BAE298-1C5B-47B9-925C-30FE64037809}" type="datetimeFigureOut">
              <a:rPr lang="en-US" smtClean="0"/>
              <a:t>2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4626246" y="28065053"/>
            <a:ext cx="13556033" cy="1612128"/>
          </a:xfrm>
          <a:prstGeom prst="rect">
            <a:avLst/>
          </a:prstGeom>
        </p:spPr>
        <p:txBody>
          <a:bodyPr vert="horz" lIns="417643" tIns="208822" rIns="417643" bIns="208822" rtlCol="0" anchor="ctr"/>
          <a:lstStyle>
            <a:lvl1pPr algn="ctr">
              <a:defRPr sz="5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0679443" y="28065053"/>
            <a:ext cx="9988656" cy="1612128"/>
          </a:xfrm>
          <a:prstGeom prst="rect">
            <a:avLst/>
          </a:prstGeom>
        </p:spPr>
        <p:txBody>
          <a:bodyPr vert="horz" lIns="417643" tIns="208822" rIns="417643" bIns="208822" rtlCol="0" anchor="ctr"/>
          <a:lstStyle>
            <a:lvl1pPr algn="r">
              <a:defRPr sz="5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F70EF8-EA7F-4DF1-85C5-1D4D29207B4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34364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176431" rtl="0" eaLnBrk="1" latinLnBrk="0" hangingPunct="1">
        <a:spcBef>
          <a:spcPct val="0"/>
        </a:spcBef>
        <a:buNone/>
        <a:defRPr sz="201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66161" indent="-1566161" algn="l" defTabSz="4176431" rtl="0" eaLnBrk="1" latinLnBrk="0" hangingPunct="1">
        <a:spcBef>
          <a:spcPct val="20000"/>
        </a:spcBef>
        <a:buFont typeface="Arial" panose="020B0604020202020204" pitchFamily="34" charset="0"/>
        <a:buChar char="•"/>
        <a:defRPr sz="14600" kern="1200">
          <a:solidFill>
            <a:schemeClr val="tx1"/>
          </a:solidFill>
          <a:latin typeface="+mn-lt"/>
          <a:ea typeface="+mn-ea"/>
          <a:cs typeface="+mn-cs"/>
        </a:defRPr>
      </a:lvl1pPr>
      <a:lvl2pPr marL="3393350" indent="-1305135" algn="l" defTabSz="4176431" rtl="0" eaLnBrk="1" latinLnBrk="0" hangingPunct="1">
        <a:spcBef>
          <a:spcPct val="20000"/>
        </a:spcBef>
        <a:buFont typeface="Arial" panose="020B0604020202020204" pitchFamily="34" charset="0"/>
        <a:buChar char="–"/>
        <a:defRPr sz="12800" kern="1200">
          <a:solidFill>
            <a:schemeClr val="tx1"/>
          </a:solidFill>
          <a:latin typeface="+mn-lt"/>
          <a:ea typeface="+mn-ea"/>
          <a:cs typeface="+mn-cs"/>
        </a:defRPr>
      </a:lvl2pPr>
      <a:lvl3pPr marL="5220538" indent="-1044108" algn="l" defTabSz="4176431" rtl="0" eaLnBrk="1" latinLnBrk="0" hangingPunct="1">
        <a:spcBef>
          <a:spcPct val="20000"/>
        </a:spcBef>
        <a:buFont typeface="Arial" panose="020B0604020202020204" pitchFamily="34" charset="0"/>
        <a:buChar char="•"/>
        <a:defRPr sz="11000" kern="1200">
          <a:solidFill>
            <a:schemeClr val="tx1"/>
          </a:solidFill>
          <a:latin typeface="+mn-lt"/>
          <a:ea typeface="+mn-ea"/>
          <a:cs typeface="+mn-cs"/>
        </a:defRPr>
      </a:lvl3pPr>
      <a:lvl4pPr marL="7308753" indent="-1044108" algn="l" defTabSz="4176431" rtl="0" eaLnBrk="1" latinLnBrk="0" hangingPunct="1">
        <a:spcBef>
          <a:spcPct val="20000"/>
        </a:spcBef>
        <a:buFont typeface="Arial" panose="020B0604020202020204" pitchFamily="34" charset="0"/>
        <a:buChar char="–"/>
        <a:defRPr sz="9100" kern="1200">
          <a:solidFill>
            <a:schemeClr val="tx1"/>
          </a:solidFill>
          <a:latin typeface="+mn-lt"/>
          <a:ea typeface="+mn-ea"/>
          <a:cs typeface="+mn-cs"/>
        </a:defRPr>
      </a:lvl4pPr>
      <a:lvl5pPr marL="9396969" indent="-1044108" algn="l" defTabSz="4176431" rtl="0" eaLnBrk="1" latinLnBrk="0" hangingPunct="1">
        <a:spcBef>
          <a:spcPct val="20000"/>
        </a:spcBef>
        <a:buFont typeface="Arial" panose="020B0604020202020204" pitchFamily="34" charset="0"/>
        <a:buChar char="»"/>
        <a:defRPr sz="9100" kern="1200">
          <a:solidFill>
            <a:schemeClr val="tx1"/>
          </a:solidFill>
          <a:latin typeface="+mn-lt"/>
          <a:ea typeface="+mn-ea"/>
          <a:cs typeface="+mn-cs"/>
        </a:defRPr>
      </a:lvl5pPr>
      <a:lvl6pPr marL="11485184" indent="-1044108" algn="l" defTabSz="4176431" rtl="0" eaLnBrk="1" latinLnBrk="0" hangingPunct="1">
        <a:spcBef>
          <a:spcPct val="20000"/>
        </a:spcBef>
        <a:buFont typeface="Arial" panose="020B0604020202020204" pitchFamily="34" charset="0"/>
        <a:buChar char="•"/>
        <a:defRPr sz="9100" kern="1200">
          <a:solidFill>
            <a:schemeClr val="tx1"/>
          </a:solidFill>
          <a:latin typeface="+mn-lt"/>
          <a:ea typeface="+mn-ea"/>
          <a:cs typeface="+mn-cs"/>
        </a:defRPr>
      </a:lvl6pPr>
      <a:lvl7pPr marL="13573399" indent="-1044108" algn="l" defTabSz="4176431" rtl="0" eaLnBrk="1" latinLnBrk="0" hangingPunct="1">
        <a:spcBef>
          <a:spcPct val="20000"/>
        </a:spcBef>
        <a:buFont typeface="Arial" panose="020B0604020202020204" pitchFamily="34" charset="0"/>
        <a:buChar char="•"/>
        <a:defRPr sz="9100" kern="1200">
          <a:solidFill>
            <a:schemeClr val="tx1"/>
          </a:solidFill>
          <a:latin typeface="+mn-lt"/>
          <a:ea typeface="+mn-ea"/>
          <a:cs typeface="+mn-cs"/>
        </a:defRPr>
      </a:lvl7pPr>
      <a:lvl8pPr marL="15661615" indent="-1044108" algn="l" defTabSz="4176431" rtl="0" eaLnBrk="1" latinLnBrk="0" hangingPunct="1">
        <a:spcBef>
          <a:spcPct val="20000"/>
        </a:spcBef>
        <a:buFont typeface="Arial" panose="020B0604020202020204" pitchFamily="34" charset="0"/>
        <a:buChar char="•"/>
        <a:defRPr sz="9100" kern="1200">
          <a:solidFill>
            <a:schemeClr val="tx1"/>
          </a:solidFill>
          <a:latin typeface="+mn-lt"/>
          <a:ea typeface="+mn-ea"/>
          <a:cs typeface="+mn-cs"/>
        </a:defRPr>
      </a:lvl8pPr>
      <a:lvl9pPr marL="17749830" indent="-1044108" algn="l" defTabSz="4176431" rtl="0" eaLnBrk="1" latinLnBrk="0" hangingPunct="1">
        <a:spcBef>
          <a:spcPct val="20000"/>
        </a:spcBef>
        <a:buFont typeface="Arial" panose="020B0604020202020204" pitchFamily="34" charset="0"/>
        <a:buChar char="•"/>
        <a:defRPr sz="9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176431" rtl="0" eaLnBrk="1" latinLnBrk="0" hangingPunct="1">
        <a:defRPr sz="8200" kern="1200">
          <a:solidFill>
            <a:schemeClr val="tx1"/>
          </a:solidFill>
          <a:latin typeface="+mn-lt"/>
          <a:ea typeface="+mn-ea"/>
          <a:cs typeface="+mn-cs"/>
        </a:defRPr>
      </a:lvl1pPr>
      <a:lvl2pPr marL="2088215" algn="l" defTabSz="4176431" rtl="0" eaLnBrk="1" latinLnBrk="0" hangingPunct="1">
        <a:defRPr sz="8200" kern="1200">
          <a:solidFill>
            <a:schemeClr val="tx1"/>
          </a:solidFill>
          <a:latin typeface="+mn-lt"/>
          <a:ea typeface="+mn-ea"/>
          <a:cs typeface="+mn-cs"/>
        </a:defRPr>
      </a:lvl2pPr>
      <a:lvl3pPr marL="4176431" algn="l" defTabSz="4176431" rtl="0" eaLnBrk="1" latinLnBrk="0" hangingPunct="1">
        <a:defRPr sz="8200" kern="1200">
          <a:solidFill>
            <a:schemeClr val="tx1"/>
          </a:solidFill>
          <a:latin typeface="+mn-lt"/>
          <a:ea typeface="+mn-ea"/>
          <a:cs typeface="+mn-cs"/>
        </a:defRPr>
      </a:lvl3pPr>
      <a:lvl4pPr marL="6264646" algn="l" defTabSz="4176431" rtl="0" eaLnBrk="1" latinLnBrk="0" hangingPunct="1">
        <a:defRPr sz="8200" kern="1200">
          <a:solidFill>
            <a:schemeClr val="tx1"/>
          </a:solidFill>
          <a:latin typeface="+mn-lt"/>
          <a:ea typeface="+mn-ea"/>
          <a:cs typeface="+mn-cs"/>
        </a:defRPr>
      </a:lvl4pPr>
      <a:lvl5pPr marL="8352861" algn="l" defTabSz="4176431" rtl="0" eaLnBrk="1" latinLnBrk="0" hangingPunct="1">
        <a:defRPr sz="8200" kern="1200">
          <a:solidFill>
            <a:schemeClr val="tx1"/>
          </a:solidFill>
          <a:latin typeface="+mn-lt"/>
          <a:ea typeface="+mn-ea"/>
          <a:cs typeface="+mn-cs"/>
        </a:defRPr>
      </a:lvl5pPr>
      <a:lvl6pPr marL="10441076" algn="l" defTabSz="4176431" rtl="0" eaLnBrk="1" latinLnBrk="0" hangingPunct="1">
        <a:defRPr sz="8200" kern="1200">
          <a:solidFill>
            <a:schemeClr val="tx1"/>
          </a:solidFill>
          <a:latin typeface="+mn-lt"/>
          <a:ea typeface="+mn-ea"/>
          <a:cs typeface="+mn-cs"/>
        </a:defRPr>
      </a:lvl6pPr>
      <a:lvl7pPr marL="12529292" algn="l" defTabSz="4176431" rtl="0" eaLnBrk="1" latinLnBrk="0" hangingPunct="1">
        <a:defRPr sz="8200" kern="1200">
          <a:solidFill>
            <a:schemeClr val="tx1"/>
          </a:solidFill>
          <a:latin typeface="+mn-lt"/>
          <a:ea typeface="+mn-ea"/>
          <a:cs typeface="+mn-cs"/>
        </a:defRPr>
      </a:lvl7pPr>
      <a:lvl8pPr marL="14617507" algn="l" defTabSz="4176431" rtl="0" eaLnBrk="1" latinLnBrk="0" hangingPunct="1">
        <a:defRPr sz="8200" kern="1200">
          <a:solidFill>
            <a:schemeClr val="tx1"/>
          </a:solidFill>
          <a:latin typeface="+mn-lt"/>
          <a:ea typeface="+mn-ea"/>
          <a:cs typeface="+mn-cs"/>
        </a:defRPr>
      </a:lvl8pPr>
      <a:lvl9pPr marL="16705722" algn="l" defTabSz="4176431" rtl="0" eaLnBrk="1" latinLnBrk="0" hangingPunct="1">
        <a:defRPr sz="8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7.wdp"/><Relationship Id="rId7" Type="http://schemas.microsoft.com/office/2007/relationships/hdphoto" Target="../media/hdphoto9.wdp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.png"/><Relationship Id="rId5" Type="http://schemas.microsoft.com/office/2007/relationships/hdphoto" Target="../media/hdphoto8.wdp"/><Relationship Id="rId4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5" Type="http://schemas.microsoft.com/office/2007/relationships/hdphoto" Target="../media/hdphoto10.wdp"/><Relationship Id="rId4" Type="http://schemas.openxmlformats.org/officeDocument/2006/relationships/image" Target="../media/image10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13" Type="http://schemas.microsoft.com/office/2007/relationships/hdphoto" Target="../media/hdphoto16.wdp"/><Relationship Id="rId3" Type="http://schemas.microsoft.com/office/2007/relationships/hdphoto" Target="../media/hdphoto11.wdp"/><Relationship Id="rId7" Type="http://schemas.microsoft.com/office/2007/relationships/hdphoto" Target="../media/hdphoto13.wdp"/><Relationship Id="rId12" Type="http://schemas.openxmlformats.org/officeDocument/2006/relationships/image" Target="../media/image16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.png"/><Relationship Id="rId11" Type="http://schemas.microsoft.com/office/2007/relationships/hdphoto" Target="../media/hdphoto15.wdp"/><Relationship Id="rId5" Type="http://schemas.microsoft.com/office/2007/relationships/hdphoto" Target="../media/hdphoto12.wdp"/><Relationship Id="rId10" Type="http://schemas.openxmlformats.org/officeDocument/2006/relationships/image" Target="../media/image15.png"/><Relationship Id="rId4" Type="http://schemas.openxmlformats.org/officeDocument/2006/relationships/image" Target="../media/image12.png"/><Relationship Id="rId9" Type="http://schemas.microsoft.com/office/2007/relationships/hdphoto" Target="../media/hdphoto14.wdp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png"/><Relationship Id="rId3" Type="http://schemas.microsoft.com/office/2007/relationships/hdphoto" Target="../media/hdphoto17.wdp"/><Relationship Id="rId7" Type="http://schemas.microsoft.com/office/2007/relationships/hdphoto" Target="../media/hdphoto19.wdp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png"/><Relationship Id="rId5" Type="http://schemas.microsoft.com/office/2007/relationships/hdphoto" Target="../media/hdphoto18.wdp"/><Relationship Id="rId4" Type="http://schemas.openxmlformats.org/officeDocument/2006/relationships/image" Target="../media/image18.png"/><Relationship Id="rId9" Type="http://schemas.microsoft.com/office/2007/relationships/hdphoto" Target="../media/hdphoto20.wdp"/></Relationships>
</file>

<file path=ppt/slides/_rels/slide8.xml.rels><?xml version="1.0" encoding="UTF-8" standalone="yes"?>
<Relationships xmlns="http://schemas.openxmlformats.org/package/2006/relationships"><Relationship Id="rId3" Type="http://schemas.microsoft.com/office/2007/relationships/hdphoto" Target="../media/hdphoto21.wdp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Relationship Id="rId5" Type="http://schemas.microsoft.com/office/2007/relationships/hdphoto" Target="../media/hdphoto22.wdp"/><Relationship Id="rId4" Type="http://schemas.openxmlformats.org/officeDocument/2006/relationships/image" Target="../media/image22.png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ieren 3"/>
          <p:cNvGrpSpPr/>
          <p:nvPr/>
        </p:nvGrpSpPr>
        <p:grpSpPr>
          <a:xfrm>
            <a:off x="3874415" y="1468769"/>
            <a:ext cx="36408145" cy="20277743"/>
            <a:chOff x="3874415" y="1468769"/>
            <a:chExt cx="36408145" cy="20277743"/>
          </a:xfrm>
        </p:grpSpPr>
        <p:sp>
          <p:nvSpPr>
            <p:cNvPr id="150" name="Rechteck 149"/>
            <p:cNvSpPr/>
            <p:nvPr/>
          </p:nvSpPr>
          <p:spPr>
            <a:xfrm>
              <a:off x="3874415" y="1468769"/>
              <a:ext cx="36408145" cy="20029925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lIns="417643" tIns="208822" rIns="417643" bIns="208822" rtlCol="0" anchor="ctr"/>
            <a:lstStyle/>
            <a:p>
              <a:pPr algn="ctr"/>
              <a:endParaRPr lang="de-DE"/>
            </a:p>
          </p:txBody>
        </p:sp>
        <p:sp>
          <p:nvSpPr>
            <p:cNvPr id="152" name="Rechteck 151"/>
            <p:cNvSpPr/>
            <p:nvPr/>
          </p:nvSpPr>
          <p:spPr>
            <a:xfrm>
              <a:off x="22078488" y="1468769"/>
              <a:ext cx="8427811" cy="20029925"/>
            </a:xfrm>
            <a:prstGeom prst="rect">
              <a:avLst/>
            </a:prstGeom>
            <a:solidFill>
              <a:schemeClr val="bg1">
                <a:alpha val="38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417643" tIns="208822" rIns="417643" bIns="208822" rtlCol="0" anchor="ctr"/>
            <a:lstStyle/>
            <a:p>
              <a:pPr algn="ctr"/>
              <a:endParaRPr lang="de-DE"/>
            </a:p>
          </p:txBody>
        </p:sp>
        <p:sp>
          <p:nvSpPr>
            <p:cNvPr id="151" name="Rechteck 150"/>
            <p:cNvSpPr/>
            <p:nvPr/>
          </p:nvSpPr>
          <p:spPr>
            <a:xfrm>
              <a:off x="3874415" y="1468769"/>
              <a:ext cx="8427811" cy="20029925"/>
            </a:xfrm>
            <a:prstGeom prst="rect">
              <a:avLst/>
            </a:prstGeom>
            <a:solidFill>
              <a:schemeClr val="bg1">
                <a:alpha val="38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417643" tIns="208822" rIns="417643" bIns="208822" rtlCol="0" anchor="ctr"/>
            <a:lstStyle/>
            <a:p>
              <a:pPr algn="ctr"/>
              <a:endParaRPr lang="de-DE"/>
            </a:p>
          </p:txBody>
        </p:sp>
        <p:sp>
          <p:nvSpPr>
            <p:cNvPr id="106" name="Textfeld 105"/>
            <p:cNvSpPr txBox="1"/>
            <p:nvPr/>
          </p:nvSpPr>
          <p:spPr>
            <a:xfrm rot="16200000">
              <a:off x="38394639" y="9016301"/>
              <a:ext cx="1589677" cy="1008622"/>
            </a:xfrm>
            <a:prstGeom prst="rect">
              <a:avLst/>
            </a:prstGeom>
            <a:noFill/>
          </p:spPr>
          <p:txBody>
            <a:bodyPr wrap="square" lIns="417643" tIns="208822" rIns="417643" bIns="208822" rtlCol="0">
              <a:spAutoFit/>
            </a:bodyPr>
            <a:lstStyle/>
            <a:p>
              <a:r>
                <a:rPr lang="de-DE" sz="3700" b="1" dirty="0"/>
                <a:t>n</a:t>
              </a:r>
            </a:p>
          </p:txBody>
        </p:sp>
        <p:sp>
          <p:nvSpPr>
            <p:cNvPr id="7" name="Textfeld 6"/>
            <p:cNvSpPr txBox="1"/>
            <p:nvPr/>
          </p:nvSpPr>
          <p:spPr>
            <a:xfrm>
              <a:off x="5221072" y="5283992"/>
              <a:ext cx="6068024" cy="1837495"/>
            </a:xfrm>
            <a:prstGeom prst="rect">
              <a:avLst/>
            </a:prstGeom>
            <a:ln/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wrap="square" lIns="417643" tIns="208822" rIns="417643" bIns="208822" rtlCol="0">
              <a:spAutoFit/>
            </a:bodyPr>
            <a:lstStyle/>
            <a:p>
              <a:pPr algn="ctr"/>
              <a:r>
                <a:rPr lang="de-DE" sz="4600" dirty="0" err="1" smtClean="0"/>
                <a:t>Perform</a:t>
              </a:r>
              <a:r>
                <a:rPr lang="de-DE" sz="4600" dirty="0" smtClean="0"/>
                <a:t> </a:t>
              </a:r>
              <a:r>
                <a:rPr lang="de-DE" sz="4600" dirty="0" err="1"/>
                <a:t>two</a:t>
              </a:r>
              <a:r>
                <a:rPr lang="de-DE" sz="4600" dirty="0"/>
                <a:t> </a:t>
              </a:r>
              <a:r>
                <a:rPr lang="de-DE" sz="4600" dirty="0" err="1"/>
                <a:t>assemblies</a:t>
              </a:r>
              <a:endParaRPr lang="de-DE" sz="4600" dirty="0"/>
            </a:p>
          </p:txBody>
        </p:sp>
        <p:sp>
          <p:nvSpPr>
            <p:cNvPr id="14" name="Textfeld 13"/>
            <p:cNvSpPr txBox="1"/>
            <p:nvPr/>
          </p:nvSpPr>
          <p:spPr>
            <a:xfrm>
              <a:off x="5221072" y="8155663"/>
              <a:ext cx="6068024" cy="2545381"/>
            </a:xfrm>
            <a:prstGeom prst="rect">
              <a:avLst/>
            </a:prstGeom>
            <a:ln/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wrap="square" lIns="417643" tIns="208822" rIns="417643" bIns="208822" rtlCol="0">
              <a:spAutoFit/>
            </a:bodyPr>
            <a:lstStyle/>
            <a:p>
              <a:pPr algn="ctr"/>
              <a:r>
                <a:rPr lang="de-DE" sz="4600" dirty="0" err="1"/>
                <a:t>C</a:t>
              </a:r>
              <a:r>
                <a:rPr lang="de-DE" sz="4600" dirty="0" err="1" smtClean="0"/>
                <a:t>ompare</a:t>
              </a:r>
              <a:r>
                <a:rPr lang="de-DE" sz="4600" dirty="0" smtClean="0"/>
                <a:t>  </a:t>
              </a:r>
              <a:r>
                <a:rPr lang="de-DE" sz="4600" dirty="0" err="1" smtClean="0"/>
                <a:t>assemblies</a:t>
              </a:r>
              <a:r>
                <a:rPr lang="de-DE" sz="4600" dirty="0" smtClean="0"/>
                <a:t> </a:t>
              </a:r>
              <a:endParaRPr lang="de-DE" sz="4600" dirty="0"/>
            </a:p>
            <a:p>
              <a:pPr algn="ctr"/>
              <a:r>
                <a:rPr lang="de-DE" sz="4600" dirty="0"/>
                <a:t>Split assembly1 at </a:t>
              </a:r>
              <a:r>
                <a:rPr lang="de-DE" sz="4600" dirty="0" err="1"/>
                <a:t>discrepancies</a:t>
              </a:r>
              <a:endParaRPr lang="de-DE" sz="4600" dirty="0"/>
            </a:p>
          </p:txBody>
        </p:sp>
        <p:sp>
          <p:nvSpPr>
            <p:cNvPr id="15" name="Textfeld 14"/>
            <p:cNvSpPr txBox="1"/>
            <p:nvPr/>
          </p:nvSpPr>
          <p:spPr>
            <a:xfrm>
              <a:off x="5221072" y="11652951"/>
              <a:ext cx="6068024" cy="2545381"/>
            </a:xfrm>
            <a:prstGeom prst="rect">
              <a:avLst/>
            </a:prstGeom>
            <a:ln/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wrap="square" lIns="417643" tIns="208822" rIns="417643" bIns="208822" rtlCol="0">
              <a:spAutoFit/>
            </a:bodyPr>
            <a:lstStyle/>
            <a:p>
              <a:pPr algn="ctr"/>
              <a:r>
                <a:rPr lang="de-DE" sz="4600" dirty="0" err="1"/>
                <a:t>M</a:t>
              </a:r>
              <a:r>
                <a:rPr lang="de-DE" sz="4600" dirty="0" err="1" smtClean="0"/>
                <a:t>ap</a:t>
              </a:r>
              <a:r>
                <a:rPr lang="de-DE" sz="4600" dirty="0" smtClean="0"/>
                <a:t> </a:t>
              </a:r>
              <a:r>
                <a:rPr lang="de-DE" sz="4600" dirty="0" err="1"/>
                <a:t>reads</a:t>
              </a:r>
              <a:endParaRPr lang="de-DE" sz="4600" dirty="0"/>
            </a:p>
            <a:p>
              <a:pPr algn="ctr"/>
              <a:r>
                <a:rPr lang="de-DE" sz="4600" dirty="0" err="1"/>
                <a:t>A</a:t>
              </a:r>
              <a:r>
                <a:rPr lang="de-DE" sz="4600" dirty="0" err="1" smtClean="0"/>
                <a:t>ssemble</a:t>
              </a:r>
              <a:r>
                <a:rPr lang="de-DE" sz="4600" dirty="0" smtClean="0"/>
                <a:t> </a:t>
              </a:r>
              <a:r>
                <a:rPr lang="de-DE" sz="4600" dirty="0" err="1"/>
                <a:t>unmapped</a:t>
              </a:r>
              <a:endParaRPr lang="de-DE" sz="4600" dirty="0"/>
            </a:p>
            <a:p>
              <a:pPr algn="ctr"/>
              <a:r>
                <a:rPr lang="de-DE" sz="4600" dirty="0"/>
                <a:t>A</a:t>
              </a:r>
              <a:r>
                <a:rPr lang="de-DE" sz="4600" dirty="0" smtClean="0"/>
                <a:t>dd </a:t>
              </a:r>
              <a:r>
                <a:rPr lang="de-DE" sz="4600" dirty="0" err="1"/>
                <a:t>to</a:t>
              </a:r>
              <a:r>
                <a:rPr lang="de-DE" sz="4600" dirty="0"/>
                <a:t> assembly1</a:t>
              </a:r>
            </a:p>
          </p:txBody>
        </p:sp>
        <p:sp>
          <p:nvSpPr>
            <p:cNvPr id="16" name="Textfeld 15"/>
            <p:cNvSpPr txBox="1"/>
            <p:nvPr/>
          </p:nvSpPr>
          <p:spPr>
            <a:xfrm>
              <a:off x="5221072" y="15150240"/>
              <a:ext cx="6068024" cy="3961153"/>
            </a:xfrm>
            <a:prstGeom prst="rect">
              <a:avLst/>
            </a:prstGeom>
            <a:ln/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wrap="square" lIns="417643" tIns="208822" rIns="417643" bIns="208822" rtlCol="0">
              <a:spAutoFit/>
            </a:bodyPr>
            <a:lstStyle/>
            <a:p>
              <a:pPr algn="ctr"/>
              <a:r>
                <a:rPr lang="de-DE" sz="4600" dirty="0" err="1"/>
                <a:t>M</a:t>
              </a:r>
              <a:r>
                <a:rPr lang="de-DE" sz="4600" dirty="0" err="1" smtClean="0"/>
                <a:t>ap</a:t>
              </a:r>
              <a:r>
                <a:rPr lang="de-DE" sz="4600" dirty="0" smtClean="0"/>
                <a:t> </a:t>
              </a:r>
              <a:r>
                <a:rPr lang="de-DE" sz="4600" dirty="0" err="1"/>
                <a:t>long</a:t>
              </a:r>
              <a:r>
                <a:rPr lang="de-DE" sz="4600" dirty="0"/>
                <a:t> </a:t>
              </a:r>
              <a:r>
                <a:rPr lang="de-DE" sz="4600" dirty="0" err="1"/>
                <a:t>reads</a:t>
              </a:r>
              <a:r>
                <a:rPr lang="de-DE" sz="4600" dirty="0"/>
                <a:t> /</a:t>
              </a:r>
            </a:p>
            <a:p>
              <a:pPr algn="ctr"/>
              <a:r>
                <a:rPr lang="de-DE" sz="4600" dirty="0" err="1"/>
                <a:t>M</a:t>
              </a:r>
              <a:r>
                <a:rPr lang="de-DE" sz="4600" dirty="0" err="1" smtClean="0"/>
                <a:t>ap</a:t>
              </a:r>
              <a:r>
                <a:rPr lang="de-DE" sz="4600" dirty="0" smtClean="0"/>
                <a:t> </a:t>
              </a:r>
              <a:r>
                <a:rPr lang="de-DE" sz="4600" dirty="0" err="1"/>
                <a:t>as</a:t>
              </a:r>
              <a:r>
                <a:rPr lang="de-DE" sz="4600" dirty="0"/>
                <a:t> </a:t>
              </a:r>
              <a:r>
                <a:rPr lang="de-DE" sz="4600" dirty="0" err="1"/>
                <a:t>paired</a:t>
              </a:r>
              <a:r>
                <a:rPr lang="de-DE" sz="4600" dirty="0"/>
                <a:t> </a:t>
              </a:r>
              <a:r>
                <a:rPr lang="de-DE" sz="4600" dirty="0" err="1"/>
                <a:t>ends</a:t>
              </a:r>
              <a:endParaRPr lang="de-DE" sz="4600" dirty="0"/>
            </a:p>
            <a:p>
              <a:pPr algn="ctr"/>
              <a:r>
                <a:rPr lang="de-DE" sz="4600" dirty="0" err="1"/>
                <a:t>to</a:t>
              </a:r>
              <a:r>
                <a:rPr lang="de-DE" sz="4600" dirty="0"/>
                <a:t> assembly1</a:t>
              </a:r>
            </a:p>
            <a:p>
              <a:pPr algn="ctr"/>
              <a:r>
                <a:rPr lang="de-DE" sz="4600" dirty="0"/>
                <a:t>S</a:t>
              </a:r>
              <a:r>
                <a:rPr lang="de-DE" sz="4600" dirty="0" smtClean="0"/>
                <a:t>plit </a:t>
              </a:r>
              <a:r>
                <a:rPr lang="de-DE" sz="4600" dirty="0" err="1"/>
                <a:t>contigs</a:t>
              </a:r>
              <a:r>
                <a:rPr lang="de-DE" sz="4600" dirty="0"/>
                <a:t> at </a:t>
              </a:r>
              <a:r>
                <a:rPr lang="de-DE" sz="4600" dirty="0" err="1"/>
                <a:t>regions</a:t>
              </a:r>
              <a:r>
                <a:rPr lang="de-DE" sz="4600" dirty="0"/>
                <a:t> </a:t>
              </a:r>
              <a:r>
                <a:rPr lang="de-DE" sz="4600" dirty="0" err="1"/>
                <a:t>of</a:t>
              </a:r>
              <a:r>
                <a:rPr lang="de-DE" sz="4600" dirty="0"/>
                <a:t> </a:t>
              </a:r>
              <a:r>
                <a:rPr lang="de-DE" sz="4600" dirty="0" err="1"/>
                <a:t>no</a:t>
              </a:r>
              <a:r>
                <a:rPr lang="de-DE" sz="4600" dirty="0"/>
                <a:t> </a:t>
              </a:r>
              <a:r>
                <a:rPr lang="de-DE" sz="4600" dirty="0" err="1"/>
                <a:t>support</a:t>
              </a:r>
              <a:endParaRPr lang="de-DE" sz="4600" dirty="0"/>
            </a:p>
          </p:txBody>
        </p:sp>
        <p:sp>
          <p:nvSpPr>
            <p:cNvPr id="17" name="Textfeld 16"/>
            <p:cNvSpPr txBox="1"/>
            <p:nvPr/>
          </p:nvSpPr>
          <p:spPr>
            <a:xfrm>
              <a:off x="13637282" y="5273842"/>
              <a:ext cx="6068024" cy="2545381"/>
            </a:xfrm>
            <a:prstGeom prst="rect">
              <a:avLst/>
            </a:prstGeom>
            <a:ln/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wrap="square" lIns="417643" tIns="208822" rIns="417643" bIns="208822" rtlCol="0">
              <a:spAutoFit/>
            </a:bodyPr>
            <a:lstStyle/>
            <a:p>
              <a:pPr algn="ctr"/>
              <a:r>
                <a:rPr lang="de-DE" sz="4600" dirty="0" err="1"/>
                <a:t>M</a:t>
              </a:r>
              <a:r>
                <a:rPr lang="de-DE" sz="4600" dirty="0" err="1" smtClean="0"/>
                <a:t>ap</a:t>
              </a:r>
              <a:r>
                <a:rPr lang="de-DE" sz="4600" dirty="0" smtClean="0"/>
                <a:t> </a:t>
              </a:r>
              <a:r>
                <a:rPr lang="de-DE" sz="4600" dirty="0" err="1"/>
                <a:t>contigs</a:t>
              </a:r>
              <a:r>
                <a:rPr lang="de-DE" sz="4600" dirty="0"/>
                <a:t> / </a:t>
              </a:r>
              <a:r>
                <a:rPr lang="de-DE" sz="4600" dirty="0" err="1"/>
                <a:t>scaffolds</a:t>
              </a:r>
              <a:r>
                <a:rPr lang="de-DE" sz="4600" dirty="0"/>
                <a:t> </a:t>
              </a:r>
              <a:r>
                <a:rPr lang="de-DE" sz="4600" dirty="0" err="1"/>
                <a:t>against</a:t>
              </a:r>
              <a:r>
                <a:rPr lang="de-DE" sz="4600" dirty="0"/>
                <a:t> </a:t>
              </a:r>
              <a:r>
                <a:rPr lang="de-DE" sz="4600" dirty="0" err="1"/>
                <a:t>reference</a:t>
              </a:r>
              <a:r>
                <a:rPr lang="de-DE" sz="4600" dirty="0"/>
                <a:t> n</a:t>
              </a:r>
            </a:p>
          </p:txBody>
        </p:sp>
        <p:sp>
          <p:nvSpPr>
            <p:cNvPr id="18" name="Textfeld 17"/>
            <p:cNvSpPr txBox="1"/>
            <p:nvPr/>
          </p:nvSpPr>
          <p:spPr>
            <a:xfrm>
              <a:off x="13637282" y="8878709"/>
              <a:ext cx="6068024" cy="2545381"/>
            </a:xfrm>
            <a:prstGeom prst="rect">
              <a:avLst/>
            </a:prstGeom>
            <a:ln/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wrap="square" lIns="417643" tIns="208822" rIns="417643" bIns="208822" rtlCol="0">
              <a:spAutoFit/>
            </a:bodyPr>
            <a:lstStyle/>
            <a:p>
              <a:pPr algn="ctr"/>
              <a:r>
                <a:rPr lang="de-DE" sz="4600" dirty="0" err="1"/>
                <a:t>R</a:t>
              </a:r>
              <a:r>
                <a:rPr lang="de-DE" sz="4600" dirty="0" err="1" smtClean="0"/>
                <a:t>esolve</a:t>
              </a:r>
              <a:r>
                <a:rPr lang="de-DE" sz="4600" dirty="0" smtClean="0"/>
                <a:t> </a:t>
              </a:r>
              <a:r>
                <a:rPr lang="de-DE" sz="4600" dirty="0" err="1"/>
                <a:t>breakpoint</a:t>
              </a:r>
              <a:r>
                <a:rPr lang="de-DE" sz="4600" dirty="0"/>
                <a:t> </a:t>
              </a:r>
              <a:r>
                <a:rPr lang="de-DE" sz="4600" dirty="0" err="1"/>
                <a:t>graph</a:t>
              </a:r>
              <a:r>
                <a:rPr lang="de-DE" sz="4600" dirty="0"/>
                <a:t> </a:t>
              </a:r>
              <a:r>
                <a:rPr lang="de-DE" sz="4600" dirty="0" err="1"/>
                <a:t>and</a:t>
              </a:r>
              <a:r>
                <a:rPr lang="de-DE" sz="4600" dirty="0"/>
                <a:t> </a:t>
              </a:r>
              <a:r>
                <a:rPr lang="de-DE" sz="4600" dirty="0" err="1"/>
                <a:t>order</a:t>
              </a:r>
              <a:r>
                <a:rPr lang="de-DE" sz="4600" dirty="0"/>
                <a:t> </a:t>
              </a:r>
              <a:r>
                <a:rPr lang="de-DE" sz="4600" dirty="0" err="1"/>
                <a:t>contigs</a:t>
              </a:r>
              <a:endParaRPr lang="de-DE" sz="4600" dirty="0"/>
            </a:p>
          </p:txBody>
        </p:sp>
        <p:cxnSp>
          <p:nvCxnSpPr>
            <p:cNvPr id="20" name="Gerade Verbindung mit Pfeil 19"/>
            <p:cNvCxnSpPr/>
            <p:nvPr/>
          </p:nvCxnSpPr>
          <p:spPr>
            <a:xfrm flipH="1">
              <a:off x="8253291" y="3650627"/>
              <a:ext cx="3586" cy="1545992"/>
            </a:xfrm>
            <a:prstGeom prst="straightConnector1">
              <a:avLst/>
            </a:prstGeom>
            <a:ln w="1016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Textfeld 20"/>
            <p:cNvSpPr txBox="1"/>
            <p:nvPr/>
          </p:nvSpPr>
          <p:spPr>
            <a:xfrm>
              <a:off x="6062060" y="2486239"/>
              <a:ext cx="4382462" cy="991109"/>
            </a:xfrm>
            <a:prstGeom prst="rect">
              <a:avLst/>
            </a:prstGeom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wrap="square" lIns="417643" tIns="208822" rIns="417643" bIns="208822" rtlCol="0">
              <a:spAutoFit/>
            </a:bodyPr>
            <a:lstStyle/>
            <a:p>
              <a:pPr algn="ctr"/>
              <a:r>
                <a:rPr lang="de-DE" sz="3700" b="1" dirty="0" err="1"/>
                <a:t>N</a:t>
              </a:r>
              <a:r>
                <a:rPr lang="de-DE" sz="3700" b="1" dirty="0" err="1" smtClean="0"/>
                <a:t>oisy</a:t>
              </a:r>
              <a:r>
                <a:rPr lang="de-DE" sz="3700" b="1" dirty="0" smtClean="0"/>
                <a:t> </a:t>
              </a:r>
              <a:r>
                <a:rPr lang="de-DE" sz="3700" b="1" dirty="0" err="1"/>
                <a:t>long</a:t>
              </a:r>
              <a:r>
                <a:rPr lang="de-DE" sz="3700" b="1" dirty="0"/>
                <a:t> </a:t>
              </a:r>
              <a:r>
                <a:rPr lang="de-DE" sz="3700" b="1" dirty="0" err="1"/>
                <a:t>reads</a:t>
              </a:r>
              <a:endParaRPr lang="de-DE" sz="3700" b="1" dirty="0"/>
            </a:p>
          </p:txBody>
        </p:sp>
        <p:sp>
          <p:nvSpPr>
            <p:cNvPr id="22" name="Textfeld 21"/>
            <p:cNvSpPr txBox="1"/>
            <p:nvPr/>
          </p:nvSpPr>
          <p:spPr>
            <a:xfrm>
              <a:off x="14220536" y="1942674"/>
              <a:ext cx="4901525" cy="2468437"/>
            </a:xfrm>
            <a:prstGeom prst="rect">
              <a:avLst/>
            </a:prstGeom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wrap="square" lIns="417643" tIns="208822" rIns="417643" bIns="208822" rtlCol="0">
              <a:spAutoFit/>
            </a:bodyPr>
            <a:lstStyle/>
            <a:p>
              <a:r>
                <a:rPr lang="de-DE" sz="3700" b="1" dirty="0"/>
                <a:t>R</a:t>
              </a:r>
              <a:r>
                <a:rPr lang="de-DE" sz="3700" b="1" dirty="0" smtClean="0"/>
                <a:t>eferences </a:t>
              </a:r>
              <a:r>
                <a:rPr lang="de-DE" sz="3700" b="1" dirty="0"/>
                <a:t>(1,2…n)</a:t>
              </a:r>
            </a:p>
            <a:p>
              <a:r>
                <a:rPr lang="de-DE" sz="3200" dirty="0"/>
                <a:t>Optional: </a:t>
              </a:r>
              <a:r>
                <a:rPr lang="de-DE" sz="3200" dirty="0" err="1"/>
                <a:t>contigs</a:t>
              </a:r>
              <a:r>
                <a:rPr lang="de-DE" sz="3200" dirty="0"/>
                <a:t> </a:t>
              </a:r>
              <a:r>
                <a:rPr lang="de-DE" sz="3200" dirty="0" err="1"/>
                <a:t>from</a:t>
              </a:r>
              <a:r>
                <a:rPr lang="de-DE" sz="3200" dirty="0"/>
                <a:t> </a:t>
              </a:r>
              <a:r>
                <a:rPr lang="de-DE" sz="3200" dirty="0" err="1"/>
                <a:t>other</a:t>
              </a:r>
              <a:r>
                <a:rPr lang="de-DE" sz="3200" dirty="0"/>
                <a:t> </a:t>
              </a:r>
              <a:r>
                <a:rPr lang="de-DE" sz="3200" dirty="0" err="1"/>
                <a:t>assembly</a:t>
              </a:r>
              <a:r>
                <a:rPr lang="de-DE" sz="3200" dirty="0"/>
                <a:t> </a:t>
              </a:r>
              <a:r>
                <a:rPr lang="de-DE" sz="3200" dirty="0" err="1"/>
                <a:t>tool</a:t>
              </a:r>
              <a:r>
                <a:rPr lang="de-DE" sz="3200" dirty="0"/>
                <a:t>, will </a:t>
              </a:r>
              <a:r>
                <a:rPr lang="de-DE" sz="3200" dirty="0" err="1"/>
                <a:t>skip</a:t>
              </a:r>
              <a:r>
                <a:rPr lang="de-DE" sz="3200" dirty="0"/>
                <a:t> step1</a:t>
              </a:r>
            </a:p>
          </p:txBody>
        </p:sp>
        <p:cxnSp>
          <p:nvCxnSpPr>
            <p:cNvPr id="26" name="Gerade Verbindung mit Pfeil 25"/>
            <p:cNvCxnSpPr/>
            <p:nvPr/>
          </p:nvCxnSpPr>
          <p:spPr>
            <a:xfrm flipH="1">
              <a:off x="16671301" y="3650627"/>
              <a:ext cx="16343" cy="1545992"/>
            </a:xfrm>
            <a:prstGeom prst="straightConnector1">
              <a:avLst/>
            </a:prstGeom>
            <a:ln w="1016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feld 30"/>
            <p:cNvSpPr txBox="1"/>
            <p:nvPr/>
          </p:nvSpPr>
          <p:spPr>
            <a:xfrm>
              <a:off x="13637282" y="12463179"/>
              <a:ext cx="6068024" cy="1129609"/>
            </a:xfrm>
            <a:prstGeom prst="rect">
              <a:avLst/>
            </a:prstGeom>
            <a:ln/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wrap="square" lIns="417643" tIns="208822" rIns="417643" bIns="208822" rtlCol="0">
              <a:spAutoFit/>
            </a:bodyPr>
            <a:lstStyle/>
            <a:p>
              <a:pPr algn="ctr"/>
              <a:r>
                <a:rPr lang="de-DE" sz="4600" dirty="0" err="1"/>
                <a:t>B</a:t>
              </a:r>
              <a:r>
                <a:rPr lang="de-DE" sz="4600" dirty="0" err="1" smtClean="0"/>
                <a:t>uild</a:t>
              </a:r>
              <a:r>
                <a:rPr lang="de-DE" sz="4600" dirty="0" smtClean="0"/>
                <a:t> </a:t>
              </a:r>
              <a:r>
                <a:rPr lang="de-DE" sz="4600" dirty="0" err="1"/>
                <a:t>scaffolds</a:t>
              </a:r>
              <a:endParaRPr lang="de-DE" sz="4600" dirty="0"/>
            </a:p>
          </p:txBody>
        </p:sp>
        <p:sp>
          <p:nvSpPr>
            <p:cNvPr id="32" name="Bogen 31"/>
            <p:cNvSpPr/>
            <p:nvPr/>
          </p:nvSpPr>
          <p:spPr>
            <a:xfrm>
              <a:off x="18363554" y="7651155"/>
              <a:ext cx="3040711" cy="4851081"/>
            </a:xfrm>
            <a:prstGeom prst="arc">
              <a:avLst>
                <a:gd name="adj1" fmla="val 16106324"/>
                <a:gd name="adj2" fmla="val 5428753"/>
              </a:avLst>
            </a:prstGeom>
            <a:ln w="101600"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lIns="417643" tIns="208822" rIns="417643" bIns="208822" rtlCol="0" anchor="ctr"/>
            <a:lstStyle/>
            <a:p>
              <a:pPr algn="ctr"/>
              <a:endParaRPr lang="de-DE"/>
            </a:p>
          </p:txBody>
        </p:sp>
        <p:grpSp>
          <p:nvGrpSpPr>
            <p:cNvPr id="42" name="Gruppieren 41"/>
            <p:cNvGrpSpPr/>
            <p:nvPr/>
          </p:nvGrpSpPr>
          <p:grpSpPr>
            <a:xfrm>
              <a:off x="11290891" y="6517897"/>
              <a:ext cx="2346393" cy="8838115"/>
              <a:chOff x="2411760" y="1476214"/>
              <a:chExt cx="501195" cy="2001712"/>
            </a:xfrm>
          </p:grpSpPr>
          <p:cxnSp>
            <p:nvCxnSpPr>
              <p:cNvPr id="27" name="Gerade Verbindung mit Pfeil 26"/>
              <p:cNvCxnSpPr/>
              <p:nvPr/>
            </p:nvCxnSpPr>
            <p:spPr>
              <a:xfrm>
                <a:off x="2732935" y="1476214"/>
                <a:ext cx="180020" cy="2"/>
              </a:xfrm>
              <a:prstGeom prst="straightConnector1">
                <a:avLst/>
              </a:prstGeom>
              <a:ln w="10160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Gerade Verbindung mit Pfeil 33"/>
              <p:cNvCxnSpPr/>
              <p:nvPr/>
            </p:nvCxnSpPr>
            <p:spPr>
              <a:xfrm>
                <a:off x="2732935" y="1476216"/>
                <a:ext cx="0" cy="2001710"/>
              </a:xfrm>
              <a:prstGeom prst="straightConnector1">
                <a:avLst/>
              </a:prstGeom>
              <a:ln w="101600">
                <a:solidFill>
                  <a:schemeClr val="tx1"/>
                </a:solidFill>
                <a:headEnd type="non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Gerade Verbindung mit Pfeil 37"/>
              <p:cNvCxnSpPr/>
              <p:nvPr/>
            </p:nvCxnSpPr>
            <p:spPr>
              <a:xfrm flipH="1">
                <a:off x="2411760" y="3477926"/>
                <a:ext cx="321175" cy="0"/>
              </a:xfrm>
              <a:prstGeom prst="straightConnector1">
                <a:avLst/>
              </a:prstGeom>
              <a:ln w="101600">
                <a:solidFill>
                  <a:schemeClr val="tx1"/>
                </a:solidFill>
                <a:headEnd type="non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3" name="Textfeld 42"/>
            <p:cNvSpPr txBox="1"/>
            <p:nvPr/>
          </p:nvSpPr>
          <p:spPr>
            <a:xfrm rot="16200000">
              <a:off x="20244461" y="9376341"/>
              <a:ext cx="1589677" cy="1008622"/>
            </a:xfrm>
            <a:prstGeom prst="rect">
              <a:avLst/>
            </a:prstGeom>
            <a:noFill/>
          </p:spPr>
          <p:txBody>
            <a:bodyPr wrap="square" lIns="417643" tIns="208822" rIns="417643" bIns="208822" rtlCol="0">
              <a:spAutoFit/>
            </a:bodyPr>
            <a:lstStyle/>
            <a:p>
              <a:r>
                <a:rPr lang="de-DE" sz="3700" b="1" dirty="0"/>
                <a:t>n</a:t>
              </a:r>
            </a:p>
          </p:txBody>
        </p:sp>
        <p:cxnSp>
          <p:nvCxnSpPr>
            <p:cNvPr id="48" name="Gerade Verbindung mit Pfeil 47"/>
            <p:cNvCxnSpPr/>
            <p:nvPr/>
          </p:nvCxnSpPr>
          <p:spPr>
            <a:xfrm flipH="1">
              <a:off x="26306932" y="3650629"/>
              <a:ext cx="1793" cy="1378189"/>
            </a:xfrm>
            <a:prstGeom prst="straightConnector1">
              <a:avLst/>
            </a:prstGeom>
            <a:ln w="1016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Textfeld 48"/>
            <p:cNvSpPr txBox="1"/>
            <p:nvPr/>
          </p:nvSpPr>
          <p:spPr>
            <a:xfrm>
              <a:off x="24117491" y="2486239"/>
              <a:ext cx="4382462" cy="991109"/>
            </a:xfrm>
            <a:prstGeom prst="rect">
              <a:avLst/>
            </a:prstGeom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wrap="square" lIns="417643" tIns="208822" rIns="417643" bIns="208822" rtlCol="0">
              <a:spAutoFit/>
            </a:bodyPr>
            <a:lstStyle/>
            <a:p>
              <a:r>
                <a:rPr lang="de-DE" sz="3700" b="1" dirty="0" err="1"/>
                <a:t>N</a:t>
              </a:r>
              <a:r>
                <a:rPr lang="de-DE" sz="3700" b="1" dirty="0" err="1" smtClean="0"/>
                <a:t>oisy</a:t>
              </a:r>
              <a:r>
                <a:rPr lang="de-DE" sz="3700" b="1" dirty="0" smtClean="0"/>
                <a:t> </a:t>
              </a:r>
              <a:r>
                <a:rPr lang="de-DE" sz="3700" b="1" dirty="0" err="1"/>
                <a:t>long</a:t>
              </a:r>
              <a:r>
                <a:rPr lang="de-DE" sz="3700" b="1" dirty="0"/>
                <a:t> </a:t>
              </a:r>
              <a:r>
                <a:rPr lang="de-DE" sz="3700" b="1" dirty="0" err="1"/>
                <a:t>reads</a:t>
              </a:r>
              <a:endParaRPr lang="de-DE" sz="3700" b="1" dirty="0"/>
            </a:p>
          </p:txBody>
        </p:sp>
        <p:sp>
          <p:nvSpPr>
            <p:cNvPr id="50" name="Textfeld 49"/>
            <p:cNvSpPr txBox="1"/>
            <p:nvPr/>
          </p:nvSpPr>
          <p:spPr>
            <a:xfrm>
              <a:off x="23274710" y="5196618"/>
              <a:ext cx="6068024" cy="1837495"/>
            </a:xfrm>
            <a:prstGeom prst="rect">
              <a:avLst/>
            </a:prstGeom>
            <a:ln/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wrap="square" lIns="417643" tIns="208822" rIns="417643" bIns="208822" rtlCol="0">
              <a:spAutoFit/>
            </a:bodyPr>
            <a:lstStyle/>
            <a:p>
              <a:pPr algn="ctr"/>
              <a:r>
                <a:rPr lang="de-DE" sz="4600" dirty="0" err="1"/>
                <a:t>M</a:t>
              </a:r>
              <a:r>
                <a:rPr lang="de-DE" sz="4600" dirty="0" err="1" smtClean="0"/>
                <a:t>ap</a:t>
              </a:r>
              <a:r>
                <a:rPr lang="de-DE" sz="4600" dirty="0" smtClean="0"/>
                <a:t> </a:t>
              </a:r>
              <a:r>
                <a:rPr lang="de-DE" sz="4600" dirty="0" err="1"/>
                <a:t>reads</a:t>
              </a:r>
              <a:r>
                <a:rPr lang="de-DE" sz="4600" dirty="0"/>
                <a:t> </a:t>
              </a:r>
              <a:r>
                <a:rPr lang="de-DE" sz="4600" dirty="0" err="1"/>
                <a:t>to</a:t>
              </a:r>
              <a:r>
                <a:rPr lang="de-DE" sz="4600" dirty="0"/>
                <a:t> </a:t>
              </a:r>
              <a:r>
                <a:rPr lang="de-DE" sz="4600" dirty="0" err="1"/>
                <a:t>scaffolds</a:t>
              </a:r>
              <a:endParaRPr lang="de-DE" sz="4600" dirty="0"/>
            </a:p>
          </p:txBody>
        </p:sp>
        <p:sp>
          <p:nvSpPr>
            <p:cNvPr id="51" name="Textfeld 50"/>
            <p:cNvSpPr txBox="1"/>
            <p:nvPr/>
          </p:nvSpPr>
          <p:spPr>
            <a:xfrm>
              <a:off x="23274710" y="8014643"/>
              <a:ext cx="6068024" cy="2545381"/>
            </a:xfrm>
            <a:prstGeom prst="rect">
              <a:avLst/>
            </a:prstGeom>
            <a:ln/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wrap="square" lIns="417643" tIns="208822" rIns="417643" bIns="208822" rtlCol="0">
              <a:spAutoFit/>
            </a:bodyPr>
            <a:lstStyle/>
            <a:p>
              <a:pPr algn="ctr"/>
              <a:r>
                <a:rPr lang="de-DE" sz="4600" dirty="0" err="1"/>
                <a:t>E</a:t>
              </a:r>
              <a:r>
                <a:rPr lang="de-DE" sz="4600" dirty="0" err="1" smtClean="0"/>
                <a:t>xtract</a:t>
              </a:r>
              <a:r>
                <a:rPr lang="de-DE" sz="4600" dirty="0" smtClean="0"/>
                <a:t> </a:t>
              </a:r>
              <a:r>
                <a:rPr lang="de-DE" sz="4600" dirty="0" err="1"/>
                <a:t>reads</a:t>
              </a:r>
              <a:r>
                <a:rPr lang="de-DE" sz="4600" dirty="0"/>
                <a:t> at </a:t>
              </a:r>
              <a:r>
                <a:rPr lang="de-DE" sz="4600" dirty="0" err="1"/>
                <a:t>scaffold</a:t>
              </a:r>
              <a:r>
                <a:rPr lang="de-DE" sz="4600" dirty="0"/>
                <a:t> </a:t>
              </a:r>
              <a:r>
                <a:rPr lang="de-DE" sz="4600" dirty="0" err="1"/>
                <a:t>gaps</a:t>
              </a:r>
              <a:r>
                <a:rPr lang="de-DE" sz="4600" dirty="0"/>
                <a:t> </a:t>
              </a:r>
              <a:r>
                <a:rPr lang="de-DE" sz="4600" dirty="0" err="1"/>
                <a:t>to</a:t>
              </a:r>
              <a:r>
                <a:rPr lang="de-DE" sz="4600" dirty="0"/>
                <a:t> </a:t>
              </a:r>
              <a:r>
                <a:rPr lang="de-DE" sz="4600" dirty="0" err="1"/>
                <a:t>distinct</a:t>
              </a:r>
              <a:r>
                <a:rPr lang="de-DE" sz="4600" dirty="0"/>
                <a:t> </a:t>
              </a:r>
              <a:r>
                <a:rPr lang="de-DE" sz="4600" dirty="0" err="1"/>
                <a:t>files</a:t>
              </a:r>
              <a:endParaRPr lang="de-DE" sz="4600" dirty="0"/>
            </a:p>
          </p:txBody>
        </p:sp>
        <p:sp>
          <p:nvSpPr>
            <p:cNvPr id="52" name="Textfeld 51"/>
            <p:cNvSpPr txBox="1"/>
            <p:nvPr/>
          </p:nvSpPr>
          <p:spPr>
            <a:xfrm>
              <a:off x="23274710" y="11652949"/>
              <a:ext cx="6068024" cy="1129609"/>
            </a:xfrm>
            <a:prstGeom prst="rect">
              <a:avLst/>
            </a:prstGeom>
            <a:ln/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wrap="square" lIns="417643" tIns="208822" rIns="417643" bIns="208822" rtlCol="0">
              <a:spAutoFit/>
            </a:bodyPr>
            <a:lstStyle/>
            <a:p>
              <a:pPr algn="ctr"/>
              <a:r>
                <a:rPr lang="de-DE" sz="4600" dirty="0"/>
                <a:t>R</a:t>
              </a:r>
              <a:r>
                <a:rPr lang="de-DE" sz="4600" dirty="0" smtClean="0"/>
                <a:t>e-</a:t>
              </a:r>
              <a:r>
                <a:rPr lang="de-DE" sz="4600" dirty="0" err="1" smtClean="0"/>
                <a:t>assemble</a:t>
              </a:r>
              <a:r>
                <a:rPr lang="de-DE" sz="4600" dirty="0" smtClean="0"/>
                <a:t> </a:t>
              </a:r>
              <a:r>
                <a:rPr lang="de-DE" sz="4600" dirty="0" err="1"/>
                <a:t>each</a:t>
              </a:r>
              <a:r>
                <a:rPr lang="de-DE" sz="4600" dirty="0"/>
                <a:t> </a:t>
              </a:r>
              <a:r>
                <a:rPr lang="de-DE" sz="4600" dirty="0" err="1"/>
                <a:t>file</a:t>
              </a:r>
              <a:endParaRPr lang="de-DE" sz="4600" dirty="0"/>
            </a:p>
          </p:txBody>
        </p:sp>
        <p:sp>
          <p:nvSpPr>
            <p:cNvPr id="53" name="Textfeld 52"/>
            <p:cNvSpPr txBox="1"/>
            <p:nvPr/>
          </p:nvSpPr>
          <p:spPr>
            <a:xfrm>
              <a:off x="23274710" y="13922086"/>
              <a:ext cx="6068024" cy="3253267"/>
            </a:xfrm>
            <a:prstGeom prst="rect">
              <a:avLst/>
            </a:prstGeom>
            <a:ln/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wrap="square" lIns="417643" tIns="208822" rIns="417643" bIns="208822" rtlCol="0">
              <a:spAutoFit/>
            </a:bodyPr>
            <a:lstStyle/>
            <a:p>
              <a:pPr algn="ctr"/>
              <a:r>
                <a:rPr lang="de-DE" sz="4600" dirty="0"/>
                <a:t>R</a:t>
              </a:r>
              <a:r>
                <a:rPr lang="de-DE" sz="4600" dirty="0" smtClean="0"/>
                <a:t>e-</a:t>
              </a:r>
              <a:r>
                <a:rPr lang="de-DE" sz="4600" dirty="0" err="1" smtClean="0"/>
                <a:t>assemble</a:t>
              </a:r>
              <a:r>
                <a:rPr lang="de-DE" sz="4600" dirty="0" smtClean="0"/>
                <a:t> </a:t>
              </a:r>
              <a:r>
                <a:rPr lang="de-DE" sz="4600" dirty="0" err="1"/>
                <a:t>whole</a:t>
              </a:r>
              <a:r>
                <a:rPr lang="de-DE" sz="4600" dirty="0"/>
                <a:t> </a:t>
              </a:r>
              <a:r>
                <a:rPr lang="de-DE" sz="4600" dirty="0" err="1"/>
                <a:t>genome</a:t>
              </a:r>
              <a:r>
                <a:rPr lang="de-DE" sz="4600" dirty="0"/>
                <a:t> </a:t>
              </a:r>
              <a:r>
                <a:rPr lang="de-DE" sz="4600" dirty="0" err="1"/>
                <a:t>from</a:t>
              </a:r>
              <a:r>
                <a:rPr lang="de-DE" sz="4600" dirty="0"/>
                <a:t> </a:t>
              </a:r>
              <a:r>
                <a:rPr lang="de-DE" sz="4600" dirty="0" err="1"/>
                <a:t>prior</a:t>
              </a:r>
              <a:r>
                <a:rPr lang="de-DE" sz="4600" dirty="0"/>
                <a:t> </a:t>
              </a:r>
              <a:r>
                <a:rPr lang="de-DE" sz="4600" dirty="0" err="1"/>
                <a:t>contigs</a:t>
              </a:r>
              <a:r>
                <a:rPr lang="de-DE" sz="4600" dirty="0"/>
                <a:t> </a:t>
              </a:r>
              <a:r>
                <a:rPr lang="de-DE" sz="4600" dirty="0" err="1"/>
                <a:t>and</a:t>
              </a:r>
              <a:r>
                <a:rPr lang="de-DE" sz="4600" dirty="0"/>
                <a:t> </a:t>
              </a:r>
              <a:r>
                <a:rPr lang="de-DE" sz="4600" dirty="0" err="1"/>
                <a:t>re-assembled</a:t>
              </a:r>
              <a:r>
                <a:rPr lang="de-DE" sz="4600" dirty="0"/>
                <a:t> </a:t>
              </a:r>
              <a:r>
                <a:rPr lang="de-DE" sz="4600" dirty="0" err="1"/>
                <a:t>gaps</a:t>
              </a:r>
              <a:endParaRPr lang="de-DE" sz="4600" dirty="0"/>
            </a:p>
          </p:txBody>
        </p:sp>
        <p:grpSp>
          <p:nvGrpSpPr>
            <p:cNvPr id="62" name="Gruppieren 61"/>
            <p:cNvGrpSpPr/>
            <p:nvPr/>
          </p:nvGrpSpPr>
          <p:grpSpPr>
            <a:xfrm>
              <a:off x="16687645" y="6104550"/>
              <a:ext cx="6548473" cy="8243350"/>
              <a:chOff x="3564519" y="1370686"/>
              <a:chExt cx="1398769" cy="1867006"/>
            </a:xfrm>
          </p:grpSpPr>
          <p:cxnSp>
            <p:nvCxnSpPr>
              <p:cNvPr id="55" name="Gerade Verbindung mit Pfeil 54"/>
              <p:cNvCxnSpPr/>
              <p:nvPr/>
            </p:nvCxnSpPr>
            <p:spPr>
              <a:xfrm>
                <a:off x="4802316" y="1372040"/>
                <a:ext cx="160972" cy="0"/>
              </a:xfrm>
              <a:prstGeom prst="straightConnector1">
                <a:avLst/>
              </a:prstGeom>
              <a:ln w="10160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Gerade Verbindung mit Pfeil 55"/>
              <p:cNvCxnSpPr/>
              <p:nvPr/>
            </p:nvCxnSpPr>
            <p:spPr>
              <a:xfrm>
                <a:off x="4802316" y="1370686"/>
                <a:ext cx="0" cy="1863960"/>
              </a:xfrm>
              <a:prstGeom prst="straightConnector1">
                <a:avLst/>
              </a:prstGeom>
              <a:ln w="101600">
                <a:solidFill>
                  <a:schemeClr val="tx1"/>
                </a:solidFill>
                <a:headEnd type="non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Gerade Verbindung mit Pfeil 56"/>
              <p:cNvCxnSpPr/>
              <p:nvPr/>
            </p:nvCxnSpPr>
            <p:spPr>
              <a:xfrm flipH="1">
                <a:off x="3564519" y="3237692"/>
                <a:ext cx="1237797" cy="0"/>
              </a:xfrm>
              <a:prstGeom prst="straightConnector1">
                <a:avLst/>
              </a:prstGeom>
              <a:ln w="101600">
                <a:solidFill>
                  <a:schemeClr val="tx1"/>
                </a:solidFill>
                <a:headEnd type="non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Gerade Verbindung mit Pfeil 89"/>
              <p:cNvCxnSpPr/>
              <p:nvPr/>
            </p:nvCxnSpPr>
            <p:spPr>
              <a:xfrm>
                <a:off x="3564519" y="3092763"/>
                <a:ext cx="0" cy="141883"/>
              </a:xfrm>
              <a:prstGeom prst="straightConnector1">
                <a:avLst/>
              </a:prstGeom>
              <a:ln w="101600">
                <a:solidFill>
                  <a:schemeClr val="tx1"/>
                </a:solidFill>
                <a:headEnd type="non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64" name="Gerade Verbindung mit Pfeil 63"/>
            <p:cNvCxnSpPr/>
            <p:nvPr/>
          </p:nvCxnSpPr>
          <p:spPr>
            <a:xfrm>
              <a:off x="30858625" y="6138978"/>
              <a:ext cx="842781" cy="9"/>
            </a:xfrm>
            <a:prstGeom prst="straightConnector1">
              <a:avLst/>
            </a:prstGeom>
            <a:ln w="1016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Gerade Verbindung mit Pfeil 64"/>
            <p:cNvCxnSpPr/>
            <p:nvPr/>
          </p:nvCxnSpPr>
          <p:spPr>
            <a:xfrm>
              <a:off x="30843411" y="6137077"/>
              <a:ext cx="50252" cy="11864328"/>
            </a:xfrm>
            <a:prstGeom prst="straightConnector1">
              <a:avLst/>
            </a:prstGeom>
            <a:ln w="101600"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Gerade Verbindung mit Pfeil 65"/>
            <p:cNvCxnSpPr/>
            <p:nvPr/>
          </p:nvCxnSpPr>
          <p:spPr>
            <a:xfrm flipH="1">
              <a:off x="26306934" y="18020307"/>
              <a:ext cx="4586729" cy="0"/>
            </a:xfrm>
            <a:prstGeom prst="straightConnector1">
              <a:avLst/>
            </a:prstGeom>
            <a:ln w="101600"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Gerade Verbindung mit Pfeil 66"/>
            <p:cNvCxnSpPr/>
            <p:nvPr/>
          </p:nvCxnSpPr>
          <p:spPr>
            <a:xfrm>
              <a:off x="26308722" y="17184725"/>
              <a:ext cx="0" cy="827193"/>
            </a:xfrm>
            <a:prstGeom prst="straightConnector1">
              <a:avLst/>
            </a:prstGeom>
            <a:ln w="101600"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Textfeld 82"/>
            <p:cNvSpPr txBox="1"/>
            <p:nvPr/>
          </p:nvSpPr>
          <p:spPr>
            <a:xfrm>
              <a:off x="32528976" y="2486239"/>
              <a:ext cx="4901525" cy="991109"/>
            </a:xfrm>
            <a:prstGeom prst="rect">
              <a:avLst/>
            </a:prstGeom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wrap="square" lIns="417643" tIns="208822" rIns="417643" bIns="208822" rtlCol="0">
              <a:spAutoFit/>
            </a:bodyPr>
            <a:lstStyle/>
            <a:p>
              <a:r>
                <a:rPr lang="de-DE" sz="3700" b="1" dirty="0"/>
                <a:t>R</a:t>
              </a:r>
              <a:r>
                <a:rPr lang="de-DE" sz="3700" b="1" dirty="0" smtClean="0"/>
                <a:t>eferences </a:t>
              </a:r>
              <a:r>
                <a:rPr lang="de-DE" sz="3700" b="1" dirty="0"/>
                <a:t>(1,2…n)</a:t>
              </a:r>
            </a:p>
          </p:txBody>
        </p:sp>
        <p:cxnSp>
          <p:nvCxnSpPr>
            <p:cNvPr id="84" name="Gerade Verbindung mit Pfeil 83"/>
            <p:cNvCxnSpPr/>
            <p:nvPr/>
          </p:nvCxnSpPr>
          <p:spPr>
            <a:xfrm>
              <a:off x="8255084" y="7345843"/>
              <a:ext cx="0" cy="647810"/>
            </a:xfrm>
            <a:prstGeom prst="straightConnector1">
              <a:avLst/>
            </a:prstGeom>
            <a:ln w="1016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Textfeld 84"/>
            <p:cNvSpPr txBox="1"/>
            <p:nvPr/>
          </p:nvSpPr>
          <p:spPr>
            <a:xfrm>
              <a:off x="31818082" y="14283609"/>
              <a:ext cx="6068024" cy="2545381"/>
            </a:xfrm>
            <a:prstGeom prst="rect">
              <a:avLst/>
            </a:prstGeom>
            <a:ln/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wrap="square" lIns="417643" tIns="208822" rIns="417643" bIns="208822" rtlCol="0">
              <a:spAutoFit/>
            </a:bodyPr>
            <a:lstStyle/>
            <a:p>
              <a:pPr algn="ctr"/>
              <a:r>
                <a:rPr lang="de-DE" sz="4600" dirty="0" err="1" smtClean="0"/>
                <a:t>Closing</a:t>
              </a:r>
              <a:r>
                <a:rPr lang="de-DE" sz="4600" dirty="0" smtClean="0"/>
                <a:t> </a:t>
              </a:r>
              <a:r>
                <a:rPr lang="de-DE" sz="4600" dirty="0" err="1"/>
                <a:t>gaps</a:t>
              </a:r>
              <a:r>
                <a:rPr lang="de-DE" sz="4600" dirty="0"/>
                <a:t> </a:t>
              </a:r>
              <a:r>
                <a:rPr lang="de-DE" sz="4600" dirty="0" err="1"/>
                <a:t>by</a:t>
              </a:r>
              <a:r>
                <a:rPr lang="de-DE" sz="4600" dirty="0"/>
                <a:t> </a:t>
              </a:r>
              <a:r>
                <a:rPr lang="de-DE" sz="4600" dirty="0" err="1"/>
                <a:t>finding</a:t>
              </a:r>
              <a:r>
                <a:rPr lang="de-DE" sz="4600" dirty="0"/>
                <a:t> </a:t>
              </a:r>
              <a:r>
                <a:rPr lang="de-DE" sz="4600" dirty="0" err="1"/>
                <a:t>overlaps</a:t>
              </a:r>
              <a:r>
                <a:rPr lang="de-DE" sz="4600" dirty="0"/>
                <a:t> </a:t>
              </a:r>
              <a:r>
                <a:rPr lang="de-DE" sz="4600" dirty="0" err="1"/>
                <a:t>of</a:t>
              </a:r>
              <a:r>
                <a:rPr lang="de-DE" sz="4600" dirty="0"/>
                <a:t> </a:t>
              </a:r>
              <a:r>
                <a:rPr lang="de-DE" sz="4600" dirty="0" err="1"/>
                <a:t>neighbouring</a:t>
              </a:r>
              <a:r>
                <a:rPr lang="de-DE" sz="4600" dirty="0"/>
                <a:t> </a:t>
              </a:r>
              <a:r>
                <a:rPr lang="de-DE" sz="4600" dirty="0" err="1"/>
                <a:t>contigs</a:t>
              </a:r>
              <a:r>
                <a:rPr lang="de-DE" sz="4600" dirty="0"/>
                <a:t> </a:t>
              </a:r>
            </a:p>
          </p:txBody>
        </p:sp>
        <p:cxnSp>
          <p:nvCxnSpPr>
            <p:cNvPr id="87" name="Gerade Verbindung mit Pfeil 86"/>
            <p:cNvCxnSpPr/>
            <p:nvPr/>
          </p:nvCxnSpPr>
          <p:spPr>
            <a:xfrm>
              <a:off x="8255084" y="10805121"/>
              <a:ext cx="0" cy="647810"/>
            </a:xfrm>
            <a:prstGeom prst="straightConnector1">
              <a:avLst/>
            </a:prstGeom>
            <a:ln w="1016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Gerade Verbindung mit Pfeil 87"/>
            <p:cNvCxnSpPr/>
            <p:nvPr/>
          </p:nvCxnSpPr>
          <p:spPr>
            <a:xfrm>
              <a:off x="8255084" y="14334451"/>
              <a:ext cx="0" cy="647810"/>
            </a:xfrm>
            <a:prstGeom prst="straightConnector1">
              <a:avLst/>
            </a:prstGeom>
            <a:ln w="1016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Gerade Verbindung mit Pfeil 91"/>
            <p:cNvCxnSpPr/>
            <p:nvPr/>
          </p:nvCxnSpPr>
          <p:spPr>
            <a:xfrm>
              <a:off x="16671294" y="7966287"/>
              <a:ext cx="0" cy="647810"/>
            </a:xfrm>
            <a:prstGeom prst="straightConnector1">
              <a:avLst/>
            </a:prstGeom>
            <a:ln w="1016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Gerade Verbindung mit Pfeil 92"/>
            <p:cNvCxnSpPr/>
            <p:nvPr/>
          </p:nvCxnSpPr>
          <p:spPr>
            <a:xfrm>
              <a:off x="16671294" y="11599107"/>
              <a:ext cx="0" cy="647810"/>
            </a:xfrm>
            <a:prstGeom prst="straightConnector1">
              <a:avLst/>
            </a:prstGeom>
            <a:ln w="1016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1" name="Textfeld 100"/>
            <p:cNvSpPr txBox="1"/>
            <p:nvPr/>
          </p:nvSpPr>
          <p:spPr>
            <a:xfrm>
              <a:off x="31781416" y="4913621"/>
              <a:ext cx="6068024" cy="2545381"/>
            </a:xfrm>
            <a:prstGeom prst="rect">
              <a:avLst/>
            </a:prstGeom>
            <a:ln/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wrap="square" lIns="417643" tIns="208822" rIns="417643" bIns="208822" rtlCol="0">
              <a:spAutoFit/>
            </a:bodyPr>
            <a:lstStyle/>
            <a:p>
              <a:pPr algn="ctr"/>
              <a:r>
                <a:rPr lang="de-DE" sz="4600" dirty="0" err="1"/>
                <a:t>M</a:t>
              </a:r>
              <a:r>
                <a:rPr lang="de-DE" sz="4600" dirty="0" err="1" smtClean="0"/>
                <a:t>ap</a:t>
              </a:r>
              <a:r>
                <a:rPr lang="de-DE" sz="4600" dirty="0" smtClean="0"/>
                <a:t> </a:t>
              </a:r>
              <a:r>
                <a:rPr lang="de-DE" sz="4600" dirty="0" err="1"/>
                <a:t>contigs</a:t>
              </a:r>
              <a:r>
                <a:rPr lang="de-DE" sz="4600" dirty="0"/>
                <a:t> / </a:t>
              </a:r>
              <a:r>
                <a:rPr lang="de-DE" sz="4600" dirty="0" err="1"/>
                <a:t>scaffolds</a:t>
              </a:r>
              <a:r>
                <a:rPr lang="de-DE" sz="4600" dirty="0"/>
                <a:t> </a:t>
              </a:r>
              <a:r>
                <a:rPr lang="de-DE" sz="4600" dirty="0" err="1"/>
                <a:t>against</a:t>
              </a:r>
              <a:r>
                <a:rPr lang="de-DE" sz="4600" dirty="0"/>
                <a:t> </a:t>
              </a:r>
              <a:r>
                <a:rPr lang="de-DE" sz="4600" dirty="0" err="1"/>
                <a:t>reference</a:t>
              </a:r>
              <a:r>
                <a:rPr lang="de-DE" sz="4600" dirty="0"/>
                <a:t> n</a:t>
              </a:r>
            </a:p>
          </p:txBody>
        </p:sp>
        <p:sp>
          <p:nvSpPr>
            <p:cNvPr id="102" name="Textfeld 101"/>
            <p:cNvSpPr txBox="1"/>
            <p:nvPr/>
          </p:nvSpPr>
          <p:spPr>
            <a:xfrm>
              <a:off x="31781416" y="8518488"/>
              <a:ext cx="6068024" cy="2545381"/>
            </a:xfrm>
            <a:prstGeom prst="rect">
              <a:avLst/>
            </a:prstGeom>
            <a:ln/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wrap="square" lIns="417643" tIns="208822" rIns="417643" bIns="208822" rtlCol="0">
              <a:spAutoFit/>
            </a:bodyPr>
            <a:lstStyle/>
            <a:p>
              <a:pPr algn="ctr"/>
              <a:r>
                <a:rPr lang="de-DE" sz="4600" dirty="0" err="1"/>
                <a:t>R</a:t>
              </a:r>
              <a:r>
                <a:rPr lang="de-DE" sz="4600" dirty="0" err="1" smtClean="0"/>
                <a:t>esolve</a:t>
              </a:r>
              <a:r>
                <a:rPr lang="de-DE" sz="4600" dirty="0" smtClean="0"/>
                <a:t> </a:t>
              </a:r>
              <a:r>
                <a:rPr lang="de-DE" sz="4600" dirty="0" err="1"/>
                <a:t>breakpoint</a:t>
              </a:r>
              <a:r>
                <a:rPr lang="de-DE" sz="4600" dirty="0"/>
                <a:t> </a:t>
              </a:r>
              <a:r>
                <a:rPr lang="de-DE" sz="4600" dirty="0" err="1"/>
                <a:t>graph</a:t>
              </a:r>
              <a:r>
                <a:rPr lang="de-DE" sz="4600" dirty="0"/>
                <a:t> </a:t>
              </a:r>
              <a:r>
                <a:rPr lang="de-DE" sz="4600" dirty="0" err="1"/>
                <a:t>and</a:t>
              </a:r>
              <a:r>
                <a:rPr lang="de-DE" sz="4600" dirty="0"/>
                <a:t> </a:t>
              </a:r>
              <a:r>
                <a:rPr lang="de-DE" sz="4600" dirty="0" err="1"/>
                <a:t>order</a:t>
              </a:r>
              <a:r>
                <a:rPr lang="de-DE" sz="4600" dirty="0"/>
                <a:t> </a:t>
              </a:r>
              <a:r>
                <a:rPr lang="de-DE" sz="4600" dirty="0" err="1"/>
                <a:t>contigs</a:t>
              </a:r>
              <a:endParaRPr lang="de-DE" sz="4600" dirty="0"/>
            </a:p>
          </p:txBody>
        </p:sp>
        <p:cxnSp>
          <p:nvCxnSpPr>
            <p:cNvPr id="103" name="Gerade Verbindung mit Pfeil 102"/>
            <p:cNvCxnSpPr/>
            <p:nvPr/>
          </p:nvCxnSpPr>
          <p:spPr>
            <a:xfrm flipH="1">
              <a:off x="34813640" y="3650627"/>
              <a:ext cx="38455" cy="1135062"/>
            </a:xfrm>
            <a:prstGeom prst="straightConnector1">
              <a:avLst/>
            </a:prstGeom>
            <a:ln w="1016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4" name="Textfeld 103"/>
            <p:cNvSpPr txBox="1"/>
            <p:nvPr/>
          </p:nvSpPr>
          <p:spPr>
            <a:xfrm>
              <a:off x="31818082" y="12102959"/>
              <a:ext cx="6068024" cy="1129609"/>
            </a:xfrm>
            <a:prstGeom prst="rect">
              <a:avLst/>
            </a:prstGeom>
            <a:ln/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wrap="square" lIns="417643" tIns="208822" rIns="417643" bIns="208822" rtlCol="0">
              <a:spAutoFit/>
            </a:bodyPr>
            <a:lstStyle/>
            <a:p>
              <a:pPr algn="ctr"/>
              <a:r>
                <a:rPr lang="de-DE" sz="4600" dirty="0" err="1"/>
                <a:t>B</a:t>
              </a:r>
              <a:r>
                <a:rPr lang="de-DE" sz="4600" dirty="0" err="1" smtClean="0"/>
                <a:t>uild</a:t>
              </a:r>
              <a:r>
                <a:rPr lang="de-DE" sz="4600" dirty="0" smtClean="0"/>
                <a:t> </a:t>
              </a:r>
              <a:r>
                <a:rPr lang="de-DE" sz="4600" dirty="0" err="1"/>
                <a:t>scaffolds</a:t>
              </a:r>
              <a:endParaRPr lang="de-DE" sz="4600" dirty="0"/>
            </a:p>
          </p:txBody>
        </p:sp>
        <p:sp>
          <p:nvSpPr>
            <p:cNvPr id="105" name="Bogen 104"/>
            <p:cNvSpPr/>
            <p:nvPr/>
          </p:nvSpPr>
          <p:spPr>
            <a:xfrm>
              <a:off x="36513732" y="7363123"/>
              <a:ext cx="3040711" cy="4827300"/>
            </a:xfrm>
            <a:prstGeom prst="arc">
              <a:avLst>
                <a:gd name="adj1" fmla="val 16178149"/>
                <a:gd name="adj2" fmla="val 5428753"/>
              </a:avLst>
            </a:prstGeom>
            <a:ln w="101600"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lIns="417643" tIns="208822" rIns="417643" bIns="208822" rtlCol="0" anchor="ctr"/>
            <a:lstStyle/>
            <a:p>
              <a:pPr algn="ctr"/>
              <a:endParaRPr lang="de-DE"/>
            </a:p>
          </p:txBody>
        </p:sp>
        <p:cxnSp>
          <p:nvCxnSpPr>
            <p:cNvPr id="107" name="Gerade Verbindung mit Pfeil 106"/>
            <p:cNvCxnSpPr/>
            <p:nvPr/>
          </p:nvCxnSpPr>
          <p:spPr>
            <a:xfrm>
              <a:off x="34815428" y="7606066"/>
              <a:ext cx="0" cy="647810"/>
            </a:xfrm>
            <a:prstGeom prst="straightConnector1">
              <a:avLst/>
            </a:prstGeom>
            <a:ln w="1016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Gerade Verbindung mit Pfeil 107"/>
            <p:cNvCxnSpPr/>
            <p:nvPr/>
          </p:nvCxnSpPr>
          <p:spPr>
            <a:xfrm>
              <a:off x="34815428" y="11238886"/>
              <a:ext cx="0" cy="647810"/>
            </a:xfrm>
            <a:prstGeom prst="straightConnector1">
              <a:avLst/>
            </a:prstGeom>
            <a:ln w="1016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Gerade Verbindung mit Pfeil 108"/>
            <p:cNvCxnSpPr/>
            <p:nvPr/>
          </p:nvCxnSpPr>
          <p:spPr>
            <a:xfrm>
              <a:off x="34815428" y="13370150"/>
              <a:ext cx="0" cy="647810"/>
            </a:xfrm>
            <a:prstGeom prst="straightConnector1">
              <a:avLst/>
            </a:prstGeom>
            <a:ln w="1016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Gerade Verbindung mit Pfeil 110"/>
            <p:cNvCxnSpPr/>
            <p:nvPr/>
          </p:nvCxnSpPr>
          <p:spPr>
            <a:xfrm>
              <a:off x="26308722" y="7115379"/>
              <a:ext cx="0" cy="647810"/>
            </a:xfrm>
            <a:prstGeom prst="straightConnector1">
              <a:avLst/>
            </a:prstGeom>
            <a:ln w="1016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Gerade Verbindung mit Pfeil 111"/>
            <p:cNvCxnSpPr/>
            <p:nvPr/>
          </p:nvCxnSpPr>
          <p:spPr>
            <a:xfrm>
              <a:off x="26308722" y="10805121"/>
              <a:ext cx="0" cy="647810"/>
            </a:xfrm>
            <a:prstGeom prst="straightConnector1">
              <a:avLst/>
            </a:prstGeom>
            <a:ln w="1016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Gerade Verbindung mit Pfeil 112"/>
            <p:cNvCxnSpPr/>
            <p:nvPr/>
          </p:nvCxnSpPr>
          <p:spPr>
            <a:xfrm>
              <a:off x="26308722" y="12902501"/>
              <a:ext cx="0" cy="647810"/>
            </a:xfrm>
            <a:prstGeom prst="straightConnector1">
              <a:avLst/>
            </a:prstGeom>
            <a:ln w="1016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Gerade Verbindung mit Pfeil 118"/>
            <p:cNvCxnSpPr/>
            <p:nvPr/>
          </p:nvCxnSpPr>
          <p:spPr>
            <a:xfrm>
              <a:off x="34845070" y="16837587"/>
              <a:ext cx="7027" cy="967414"/>
            </a:xfrm>
            <a:prstGeom prst="straightConnector1">
              <a:avLst/>
            </a:prstGeom>
            <a:ln w="1016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6" name="Textfeld 125"/>
            <p:cNvSpPr txBox="1"/>
            <p:nvPr/>
          </p:nvSpPr>
          <p:spPr>
            <a:xfrm rot="16200000">
              <a:off x="10402185" y="12153592"/>
              <a:ext cx="2807927" cy="1406608"/>
            </a:xfrm>
            <a:prstGeom prst="rect">
              <a:avLst/>
            </a:prstGeom>
            <a:noFill/>
          </p:spPr>
          <p:txBody>
            <a:bodyPr wrap="square" lIns="417643" tIns="208822" rIns="417643" bIns="208822" rtlCol="0">
              <a:spAutoFit/>
            </a:bodyPr>
            <a:lstStyle/>
            <a:p>
              <a:pPr algn="ctr"/>
              <a:r>
                <a:rPr lang="de-DE" sz="3200" dirty="0"/>
                <a:t>M</a:t>
              </a:r>
              <a:r>
                <a:rPr lang="de-DE" sz="3200" dirty="0" smtClean="0"/>
                <a:t>inimap2 </a:t>
              </a:r>
              <a:r>
                <a:rPr lang="de-DE" sz="3200" dirty="0"/>
                <a:t>/ </a:t>
              </a:r>
              <a:r>
                <a:rPr lang="de-DE" sz="3200" dirty="0" smtClean="0"/>
                <a:t>Wtdbg2.2 </a:t>
              </a:r>
              <a:endParaRPr lang="de-DE" sz="3200" dirty="0"/>
            </a:p>
          </p:txBody>
        </p:sp>
        <p:sp>
          <p:nvSpPr>
            <p:cNvPr id="128" name="Textfeld 127"/>
            <p:cNvSpPr txBox="1"/>
            <p:nvPr/>
          </p:nvSpPr>
          <p:spPr>
            <a:xfrm rot="16200000">
              <a:off x="10155963" y="8911025"/>
              <a:ext cx="2807927" cy="914165"/>
            </a:xfrm>
            <a:prstGeom prst="rect">
              <a:avLst/>
            </a:prstGeom>
            <a:noFill/>
          </p:spPr>
          <p:txBody>
            <a:bodyPr wrap="square" lIns="417643" tIns="208822" rIns="417643" bIns="208822" rtlCol="0">
              <a:spAutoFit/>
            </a:bodyPr>
            <a:lstStyle/>
            <a:p>
              <a:pPr algn="ctr"/>
              <a:r>
                <a:rPr lang="de-DE" sz="3200" dirty="0"/>
                <a:t>M</a:t>
              </a:r>
              <a:r>
                <a:rPr lang="de-DE" sz="3200" dirty="0" smtClean="0"/>
                <a:t>inimap2 </a:t>
              </a:r>
              <a:endParaRPr lang="de-DE" sz="3200" dirty="0"/>
            </a:p>
          </p:txBody>
        </p:sp>
        <p:sp>
          <p:nvSpPr>
            <p:cNvPr id="129" name="Textfeld 128"/>
            <p:cNvSpPr txBox="1"/>
            <p:nvPr/>
          </p:nvSpPr>
          <p:spPr>
            <a:xfrm rot="16200000">
              <a:off x="10155963" y="5700133"/>
              <a:ext cx="2807927" cy="914165"/>
            </a:xfrm>
            <a:prstGeom prst="rect">
              <a:avLst/>
            </a:prstGeom>
            <a:noFill/>
          </p:spPr>
          <p:txBody>
            <a:bodyPr wrap="square" lIns="417643" tIns="208822" rIns="417643" bIns="208822" rtlCol="0">
              <a:spAutoFit/>
            </a:bodyPr>
            <a:lstStyle/>
            <a:p>
              <a:pPr algn="ctr"/>
              <a:r>
                <a:rPr lang="de-DE" sz="3200" dirty="0"/>
                <a:t>W</a:t>
              </a:r>
              <a:r>
                <a:rPr lang="de-DE" sz="3200" dirty="0" smtClean="0"/>
                <a:t>tdbg2.2</a:t>
              </a:r>
              <a:endParaRPr lang="de-DE" sz="3200" dirty="0"/>
            </a:p>
          </p:txBody>
        </p:sp>
        <p:sp>
          <p:nvSpPr>
            <p:cNvPr id="130" name="Textfeld 129"/>
            <p:cNvSpPr txBox="1"/>
            <p:nvPr/>
          </p:nvSpPr>
          <p:spPr>
            <a:xfrm rot="16200000">
              <a:off x="9333409" y="16848874"/>
              <a:ext cx="4453036" cy="914165"/>
            </a:xfrm>
            <a:prstGeom prst="rect">
              <a:avLst/>
            </a:prstGeom>
            <a:noFill/>
          </p:spPr>
          <p:txBody>
            <a:bodyPr wrap="square" lIns="417643" tIns="208822" rIns="417643" bIns="208822" rtlCol="0">
              <a:spAutoFit/>
            </a:bodyPr>
            <a:lstStyle/>
            <a:p>
              <a:pPr algn="ctr"/>
              <a:r>
                <a:rPr lang="de-DE" sz="3200" dirty="0"/>
                <a:t>M</a:t>
              </a:r>
              <a:r>
                <a:rPr lang="de-DE" sz="3200" dirty="0" smtClean="0"/>
                <a:t>inimap2 / </a:t>
              </a:r>
              <a:r>
                <a:rPr lang="de-DE" sz="3200" dirty="0" err="1" smtClean="0"/>
                <a:t>Bedtools</a:t>
              </a:r>
              <a:r>
                <a:rPr lang="de-DE" sz="3200" dirty="0" smtClean="0"/>
                <a:t> </a:t>
              </a:r>
              <a:endParaRPr lang="de-DE" sz="3200" dirty="0"/>
            </a:p>
          </p:txBody>
        </p:sp>
        <p:sp>
          <p:nvSpPr>
            <p:cNvPr id="131" name="Textfeld 130"/>
            <p:cNvSpPr txBox="1"/>
            <p:nvPr/>
          </p:nvSpPr>
          <p:spPr>
            <a:xfrm rot="16200000">
              <a:off x="18580899" y="6078141"/>
              <a:ext cx="2807927" cy="914165"/>
            </a:xfrm>
            <a:prstGeom prst="rect">
              <a:avLst/>
            </a:prstGeom>
            <a:noFill/>
          </p:spPr>
          <p:txBody>
            <a:bodyPr wrap="square" lIns="417643" tIns="208822" rIns="417643" bIns="208822" rtlCol="0">
              <a:spAutoFit/>
            </a:bodyPr>
            <a:lstStyle/>
            <a:p>
              <a:pPr algn="ctr"/>
              <a:r>
                <a:rPr lang="de-DE" sz="3200" dirty="0"/>
                <a:t>Last </a:t>
              </a:r>
              <a:r>
                <a:rPr lang="de-DE" sz="3200" dirty="0" err="1"/>
                <a:t>aligner</a:t>
              </a:r>
              <a:endParaRPr lang="de-DE" sz="3200" dirty="0"/>
            </a:p>
          </p:txBody>
        </p:sp>
        <p:sp>
          <p:nvSpPr>
            <p:cNvPr id="132" name="Textfeld 131"/>
            <p:cNvSpPr txBox="1"/>
            <p:nvPr/>
          </p:nvSpPr>
          <p:spPr>
            <a:xfrm rot="16200000">
              <a:off x="18580899" y="9585392"/>
              <a:ext cx="2807927" cy="914165"/>
            </a:xfrm>
            <a:prstGeom prst="rect">
              <a:avLst/>
            </a:prstGeom>
            <a:noFill/>
          </p:spPr>
          <p:txBody>
            <a:bodyPr wrap="square" lIns="417643" tIns="208822" rIns="417643" bIns="208822" rtlCol="0">
              <a:spAutoFit/>
            </a:bodyPr>
            <a:lstStyle/>
            <a:p>
              <a:pPr algn="ctr"/>
              <a:r>
                <a:rPr lang="de-DE" sz="3200" dirty="0"/>
                <a:t>R</a:t>
              </a:r>
              <a:r>
                <a:rPr lang="de-DE" sz="3200" dirty="0" smtClean="0"/>
                <a:t>agout </a:t>
              </a:r>
              <a:r>
                <a:rPr lang="de-DE" sz="3200" dirty="0"/>
                <a:t>v1.0</a:t>
              </a:r>
            </a:p>
          </p:txBody>
        </p:sp>
        <p:sp>
          <p:nvSpPr>
            <p:cNvPr id="133" name="Textfeld 132"/>
            <p:cNvSpPr txBox="1"/>
            <p:nvPr/>
          </p:nvSpPr>
          <p:spPr>
            <a:xfrm rot="16200000">
              <a:off x="28229971" y="5679562"/>
              <a:ext cx="2807927" cy="914165"/>
            </a:xfrm>
            <a:prstGeom prst="rect">
              <a:avLst/>
            </a:prstGeom>
            <a:noFill/>
          </p:spPr>
          <p:txBody>
            <a:bodyPr wrap="square" lIns="417643" tIns="208822" rIns="417643" bIns="208822" rtlCol="0">
              <a:spAutoFit/>
            </a:bodyPr>
            <a:lstStyle/>
            <a:p>
              <a:pPr algn="ctr"/>
              <a:r>
                <a:rPr lang="de-DE" sz="3200" dirty="0"/>
                <a:t>M</a:t>
              </a:r>
              <a:r>
                <a:rPr lang="de-DE" sz="3200" dirty="0" smtClean="0"/>
                <a:t>inimap2 </a:t>
              </a:r>
              <a:endParaRPr lang="de-DE" sz="3200" dirty="0"/>
            </a:p>
          </p:txBody>
        </p:sp>
        <p:sp>
          <p:nvSpPr>
            <p:cNvPr id="134" name="Textfeld 133"/>
            <p:cNvSpPr txBox="1"/>
            <p:nvPr/>
          </p:nvSpPr>
          <p:spPr>
            <a:xfrm rot="16200000">
              <a:off x="28229971" y="11718952"/>
              <a:ext cx="2807927" cy="914165"/>
            </a:xfrm>
            <a:prstGeom prst="rect">
              <a:avLst/>
            </a:prstGeom>
            <a:noFill/>
          </p:spPr>
          <p:txBody>
            <a:bodyPr wrap="square" lIns="417643" tIns="208822" rIns="417643" bIns="208822" rtlCol="0">
              <a:spAutoFit/>
            </a:bodyPr>
            <a:lstStyle/>
            <a:p>
              <a:pPr algn="ctr"/>
              <a:r>
                <a:rPr lang="de-DE" sz="3200" dirty="0"/>
                <a:t>W</a:t>
              </a:r>
              <a:r>
                <a:rPr lang="de-DE" sz="3200" dirty="0" smtClean="0"/>
                <a:t>tdbg2.2</a:t>
              </a:r>
              <a:endParaRPr lang="de-DE" sz="3200" dirty="0"/>
            </a:p>
          </p:txBody>
        </p:sp>
        <p:sp>
          <p:nvSpPr>
            <p:cNvPr id="135" name="Textfeld 134"/>
            <p:cNvSpPr txBox="1"/>
            <p:nvPr/>
          </p:nvSpPr>
          <p:spPr>
            <a:xfrm rot="16200000">
              <a:off x="28476193" y="14793394"/>
              <a:ext cx="2807927" cy="1406608"/>
            </a:xfrm>
            <a:prstGeom prst="rect">
              <a:avLst/>
            </a:prstGeom>
            <a:noFill/>
          </p:spPr>
          <p:txBody>
            <a:bodyPr wrap="square" lIns="417643" tIns="208822" rIns="417643" bIns="208822" rtlCol="0">
              <a:spAutoFit/>
            </a:bodyPr>
            <a:lstStyle/>
            <a:p>
              <a:pPr algn="ctr"/>
              <a:r>
                <a:rPr lang="de-DE" sz="3200" dirty="0"/>
                <a:t>W</a:t>
              </a:r>
              <a:r>
                <a:rPr lang="de-DE" sz="3200" dirty="0" smtClean="0"/>
                <a:t>tdbg2.2 </a:t>
              </a:r>
              <a:r>
                <a:rPr lang="de-DE" sz="3200" dirty="0"/>
                <a:t>/ </a:t>
              </a:r>
              <a:r>
                <a:rPr lang="de-DE" sz="3200" dirty="0" err="1"/>
                <a:t>B</a:t>
              </a:r>
              <a:r>
                <a:rPr lang="de-DE" sz="3200" dirty="0" err="1" smtClean="0"/>
                <a:t>edtools</a:t>
              </a:r>
              <a:endParaRPr lang="de-DE" sz="3200" dirty="0"/>
            </a:p>
          </p:txBody>
        </p:sp>
        <p:sp>
          <p:nvSpPr>
            <p:cNvPr id="136" name="Textfeld 135"/>
            <p:cNvSpPr txBox="1"/>
            <p:nvPr/>
          </p:nvSpPr>
          <p:spPr>
            <a:xfrm rot="16200000">
              <a:off x="36782721" y="5732572"/>
              <a:ext cx="2807927" cy="914165"/>
            </a:xfrm>
            <a:prstGeom prst="rect">
              <a:avLst/>
            </a:prstGeom>
            <a:noFill/>
          </p:spPr>
          <p:txBody>
            <a:bodyPr wrap="square" lIns="417643" tIns="208822" rIns="417643" bIns="208822" rtlCol="0">
              <a:spAutoFit/>
            </a:bodyPr>
            <a:lstStyle/>
            <a:p>
              <a:pPr algn="ctr"/>
              <a:r>
                <a:rPr lang="de-DE" sz="3200" dirty="0"/>
                <a:t>Last </a:t>
              </a:r>
              <a:r>
                <a:rPr lang="de-DE" sz="3200" dirty="0" err="1"/>
                <a:t>aligner</a:t>
              </a:r>
              <a:endParaRPr lang="de-DE" sz="3200" dirty="0"/>
            </a:p>
          </p:txBody>
        </p:sp>
        <p:sp>
          <p:nvSpPr>
            <p:cNvPr id="137" name="Textfeld 136"/>
            <p:cNvSpPr txBox="1"/>
            <p:nvPr/>
          </p:nvSpPr>
          <p:spPr>
            <a:xfrm rot="16200000">
              <a:off x="36782721" y="9318501"/>
              <a:ext cx="2807927" cy="914165"/>
            </a:xfrm>
            <a:prstGeom prst="rect">
              <a:avLst/>
            </a:prstGeom>
            <a:noFill/>
          </p:spPr>
          <p:txBody>
            <a:bodyPr wrap="square" lIns="417643" tIns="208822" rIns="417643" bIns="208822" rtlCol="0">
              <a:spAutoFit/>
            </a:bodyPr>
            <a:lstStyle/>
            <a:p>
              <a:pPr algn="ctr"/>
              <a:r>
                <a:rPr lang="de-DE" sz="3200" dirty="0"/>
                <a:t>R</a:t>
              </a:r>
              <a:r>
                <a:rPr lang="de-DE" sz="3200" dirty="0" smtClean="0"/>
                <a:t>agout </a:t>
              </a:r>
              <a:r>
                <a:rPr lang="de-DE" sz="3200" dirty="0"/>
                <a:t>v1.0</a:t>
              </a:r>
            </a:p>
          </p:txBody>
        </p:sp>
        <p:sp>
          <p:nvSpPr>
            <p:cNvPr id="138" name="Textfeld 137"/>
            <p:cNvSpPr txBox="1"/>
            <p:nvPr/>
          </p:nvSpPr>
          <p:spPr>
            <a:xfrm rot="16200000">
              <a:off x="28410973" y="8599580"/>
              <a:ext cx="2938367" cy="1406608"/>
            </a:xfrm>
            <a:prstGeom prst="rect">
              <a:avLst/>
            </a:prstGeom>
            <a:noFill/>
          </p:spPr>
          <p:txBody>
            <a:bodyPr wrap="square" lIns="417643" tIns="208822" rIns="417643" bIns="208822" rtlCol="0">
              <a:spAutoFit/>
            </a:bodyPr>
            <a:lstStyle/>
            <a:p>
              <a:pPr algn="ctr"/>
              <a:r>
                <a:rPr lang="de-DE" sz="3200" dirty="0" err="1"/>
                <a:t>B</a:t>
              </a:r>
              <a:r>
                <a:rPr lang="de-DE" sz="3200" dirty="0" err="1" smtClean="0"/>
                <a:t>edtools</a:t>
              </a:r>
              <a:r>
                <a:rPr lang="de-DE" sz="3200" dirty="0" smtClean="0"/>
                <a:t> </a:t>
              </a:r>
              <a:r>
                <a:rPr lang="de-DE" sz="3200" dirty="0"/>
                <a:t>/ </a:t>
              </a:r>
              <a:r>
                <a:rPr lang="de-DE" sz="3200" dirty="0" err="1"/>
                <a:t>A</a:t>
              </a:r>
              <a:r>
                <a:rPr lang="de-DE" sz="3200" dirty="0" err="1" smtClean="0"/>
                <a:t>wk</a:t>
              </a:r>
              <a:r>
                <a:rPr lang="de-DE" sz="3200" dirty="0" smtClean="0"/>
                <a:t> </a:t>
              </a:r>
              <a:r>
                <a:rPr lang="de-DE" sz="3200" dirty="0" err="1"/>
                <a:t>scripts</a:t>
              </a:r>
              <a:endParaRPr lang="de-DE" sz="3200" dirty="0"/>
            </a:p>
          </p:txBody>
        </p:sp>
        <p:sp>
          <p:nvSpPr>
            <p:cNvPr id="139" name="Textfeld 138"/>
            <p:cNvSpPr txBox="1"/>
            <p:nvPr/>
          </p:nvSpPr>
          <p:spPr>
            <a:xfrm rot="16200000">
              <a:off x="36859270" y="14801668"/>
              <a:ext cx="3147272" cy="1406608"/>
            </a:xfrm>
            <a:prstGeom prst="rect">
              <a:avLst/>
            </a:prstGeom>
            <a:noFill/>
          </p:spPr>
          <p:txBody>
            <a:bodyPr wrap="square" lIns="417643" tIns="208822" rIns="417643" bIns="208822" rtlCol="0">
              <a:spAutoFit/>
            </a:bodyPr>
            <a:lstStyle/>
            <a:p>
              <a:pPr algn="ctr"/>
              <a:r>
                <a:rPr lang="de-DE" sz="3200" dirty="0"/>
                <a:t>Last </a:t>
              </a:r>
              <a:r>
                <a:rPr lang="de-DE" sz="3200" dirty="0" err="1"/>
                <a:t>aligner</a:t>
              </a:r>
              <a:r>
                <a:rPr lang="de-DE" sz="3200" dirty="0"/>
                <a:t> /  </a:t>
              </a:r>
              <a:r>
                <a:rPr lang="de-DE" sz="3200" dirty="0" smtClean="0"/>
                <a:t>Perl </a:t>
              </a:r>
              <a:r>
                <a:rPr lang="de-DE" sz="3200" dirty="0" err="1"/>
                <a:t>scripts</a:t>
              </a:r>
              <a:endParaRPr lang="de-DE" sz="3200" dirty="0"/>
            </a:p>
          </p:txBody>
        </p:sp>
        <p:sp>
          <p:nvSpPr>
            <p:cNvPr id="140" name="Textfeld 139"/>
            <p:cNvSpPr txBox="1"/>
            <p:nvPr/>
          </p:nvSpPr>
          <p:spPr>
            <a:xfrm rot="16200000">
              <a:off x="36859270" y="11943218"/>
              <a:ext cx="3147272" cy="1406608"/>
            </a:xfrm>
            <a:prstGeom prst="rect">
              <a:avLst/>
            </a:prstGeom>
            <a:noFill/>
          </p:spPr>
          <p:txBody>
            <a:bodyPr wrap="square" lIns="417643" tIns="208822" rIns="417643" bIns="208822" rtlCol="0">
              <a:spAutoFit/>
            </a:bodyPr>
            <a:lstStyle/>
            <a:p>
              <a:pPr algn="ctr"/>
              <a:r>
                <a:rPr lang="de-DE" sz="3200" dirty="0" smtClean="0"/>
                <a:t>Perl</a:t>
              </a:r>
            </a:p>
            <a:p>
              <a:pPr algn="ctr"/>
              <a:r>
                <a:rPr lang="de-DE" sz="3200" dirty="0" smtClean="0"/>
                <a:t> </a:t>
              </a:r>
              <a:r>
                <a:rPr lang="de-DE" sz="3200" dirty="0" err="1"/>
                <a:t>script</a:t>
              </a:r>
              <a:endParaRPr lang="de-DE" sz="3200" dirty="0"/>
            </a:p>
          </p:txBody>
        </p:sp>
        <p:sp>
          <p:nvSpPr>
            <p:cNvPr id="141" name="Textfeld 140"/>
            <p:cNvSpPr txBox="1"/>
            <p:nvPr/>
          </p:nvSpPr>
          <p:spPr>
            <a:xfrm rot="16200000">
              <a:off x="18657448" y="12300246"/>
              <a:ext cx="3147272" cy="1406608"/>
            </a:xfrm>
            <a:prstGeom prst="rect">
              <a:avLst/>
            </a:prstGeom>
            <a:noFill/>
          </p:spPr>
          <p:txBody>
            <a:bodyPr wrap="square" lIns="417643" tIns="208822" rIns="417643" bIns="208822" rtlCol="0">
              <a:spAutoFit/>
            </a:bodyPr>
            <a:lstStyle/>
            <a:p>
              <a:pPr algn="ctr"/>
              <a:r>
                <a:rPr lang="de-DE" sz="3200" dirty="0" smtClean="0"/>
                <a:t>Perl</a:t>
              </a:r>
            </a:p>
            <a:p>
              <a:pPr algn="ctr"/>
              <a:r>
                <a:rPr lang="de-DE" sz="3200" dirty="0" smtClean="0"/>
                <a:t> </a:t>
              </a:r>
              <a:r>
                <a:rPr lang="de-DE" sz="3200" dirty="0" err="1"/>
                <a:t>script</a:t>
              </a:r>
              <a:endParaRPr lang="de-DE" sz="3200" dirty="0"/>
            </a:p>
          </p:txBody>
        </p:sp>
        <p:sp>
          <p:nvSpPr>
            <p:cNvPr id="143" name="Textfeld 142"/>
            <p:cNvSpPr txBox="1"/>
            <p:nvPr/>
          </p:nvSpPr>
          <p:spPr>
            <a:xfrm>
              <a:off x="31818082" y="17868080"/>
              <a:ext cx="6068024" cy="1129609"/>
            </a:xfrm>
            <a:prstGeom prst="rect">
              <a:avLst/>
            </a:prstGeom>
            <a:ln/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wrap="square" lIns="417643" tIns="208822" rIns="417643" bIns="208822" rtlCol="0">
              <a:spAutoFit/>
            </a:bodyPr>
            <a:lstStyle/>
            <a:p>
              <a:pPr algn="ctr"/>
              <a:r>
                <a:rPr lang="de-DE" sz="4600" dirty="0"/>
                <a:t>CSA </a:t>
              </a:r>
              <a:r>
                <a:rPr lang="de-DE" sz="4600" dirty="0" err="1"/>
                <a:t>output</a:t>
              </a:r>
              <a:endParaRPr lang="de-DE" sz="4600" dirty="0"/>
            </a:p>
          </p:txBody>
        </p:sp>
        <p:sp>
          <p:nvSpPr>
            <p:cNvPr id="163" name="Textfeld 162"/>
            <p:cNvSpPr txBox="1"/>
            <p:nvPr/>
          </p:nvSpPr>
          <p:spPr>
            <a:xfrm>
              <a:off x="3874420" y="19909020"/>
              <a:ext cx="8427811" cy="1129609"/>
            </a:xfrm>
            <a:prstGeom prst="rect">
              <a:avLst/>
            </a:prstGeom>
            <a:noFill/>
          </p:spPr>
          <p:txBody>
            <a:bodyPr wrap="square" lIns="417643" tIns="208822" rIns="417643" bIns="208822" rtlCol="0">
              <a:spAutoFit/>
            </a:bodyPr>
            <a:lstStyle/>
            <a:p>
              <a:pPr algn="ctr"/>
              <a:r>
                <a:rPr lang="de-DE" sz="4600" b="1" dirty="0" err="1"/>
                <a:t>S</a:t>
              </a:r>
              <a:r>
                <a:rPr lang="de-DE" sz="4600" b="1" dirty="0" err="1" smtClean="0"/>
                <a:t>tep</a:t>
              </a:r>
              <a:r>
                <a:rPr lang="de-DE" sz="4600" b="1" dirty="0" smtClean="0"/>
                <a:t> </a:t>
              </a:r>
              <a:r>
                <a:rPr lang="de-DE" sz="4600" b="1" dirty="0"/>
                <a:t>1: </a:t>
              </a:r>
              <a:r>
                <a:rPr lang="de-DE" sz="4600" b="1" dirty="0" smtClean="0"/>
                <a:t>Long </a:t>
              </a:r>
              <a:r>
                <a:rPr lang="de-DE" sz="4600" b="1" dirty="0" err="1"/>
                <a:t>read</a:t>
              </a:r>
              <a:r>
                <a:rPr lang="de-DE" sz="4600" b="1" dirty="0"/>
                <a:t> </a:t>
              </a:r>
              <a:r>
                <a:rPr lang="de-DE" sz="4600" b="1" dirty="0" err="1"/>
                <a:t>assembly</a:t>
              </a:r>
              <a:endParaRPr lang="de-DE" sz="4600" b="1" dirty="0"/>
            </a:p>
          </p:txBody>
        </p:sp>
        <p:sp>
          <p:nvSpPr>
            <p:cNvPr id="164" name="Textfeld 163"/>
            <p:cNvSpPr txBox="1"/>
            <p:nvPr/>
          </p:nvSpPr>
          <p:spPr>
            <a:xfrm>
              <a:off x="12302226" y="19909017"/>
              <a:ext cx="9776261" cy="1837495"/>
            </a:xfrm>
            <a:prstGeom prst="rect">
              <a:avLst/>
            </a:prstGeom>
            <a:noFill/>
          </p:spPr>
          <p:txBody>
            <a:bodyPr wrap="square" lIns="417643" tIns="208822" rIns="417643" bIns="208822" rtlCol="0">
              <a:spAutoFit/>
            </a:bodyPr>
            <a:lstStyle/>
            <a:p>
              <a:pPr algn="ctr"/>
              <a:r>
                <a:rPr lang="de-DE" sz="4600" b="1" dirty="0" err="1"/>
                <a:t>S</a:t>
              </a:r>
              <a:r>
                <a:rPr lang="de-DE" sz="4600" b="1" dirty="0" err="1" smtClean="0"/>
                <a:t>tep</a:t>
              </a:r>
              <a:r>
                <a:rPr lang="de-DE" sz="4600" b="1" dirty="0" smtClean="0"/>
                <a:t> </a:t>
              </a:r>
              <a:r>
                <a:rPr lang="de-DE" sz="4600" b="1" dirty="0"/>
                <a:t>2: </a:t>
              </a:r>
              <a:r>
                <a:rPr lang="de-DE" sz="4600" b="1" dirty="0" err="1"/>
                <a:t>Scaffold</a:t>
              </a:r>
              <a:r>
                <a:rPr lang="de-DE" sz="4600" b="1" dirty="0"/>
                <a:t> </a:t>
              </a:r>
              <a:r>
                <a:rPr lang="de-DE" sz="4600" b="1" dirty="0" err="1"/>
                <a:t>according</a:t>
              </a:r>
              <a:r>
                <a:rPr lang="de-DE" sz="4600" b="1" dirty="0"/>
                <a:t> </a:t>
              </a:r>
              <a:r>
                <a:rPr lang="de-DE" sz="4600" b="1" dirty="0" err="1"/>
                <a:t>to</a:t>
              </a:r>
              <a:r>
                <a:rPr lang="de-DE" sz="4600" b="1" dirty="0"/>
                <a:t> </a:t>
              </a:r>
              <a:r>
                <a:rPr lang="de-DE" sz="4600" b="1" dirty="0" err="1"/>
                <a:t>reference</a:t>
              </a:r>
              <a:endParaRPr lang="de-DE" sz="4600" b="1" dirty="0"/>
            </a:p>
          </p:txBody>
        </p:sp>
        <p:sp>
          <p:nvSpPr>
            <p:cNvPr id="165" name="Textfeld 164"/>
            <p:cNvSpPr txBox="1"/>
            <p:nvPr/>
          </p:nvSpPr>
          <p:spPr>
            <a:xfrm>
              <a:off x="22078488" y="19909017"/>
              <a:ext cx="8427811" cy="1837495"/>
            </a:xfrm>
            <a:prstGeom prst="rect">
              <a:avLst/>
            </a:prstGeom>
            <a:noFill/>
          </p:spPr>
          <p:txBody>
            <a:bodyPr wrap="square" lIns="417643" tIns="208822" rIns="417643" bIns="208822" rtlCol="0">
              <a:spAutoFit/>
            </a:bodyPr>
            <a:lstStyle/>
            <a:p>
              <a:pPr algn="ctr"/>
              <a:r>
                <a:rPr lang="de-DE" sz="4600" b="1" dirty="0" err="1"/>
                <a:t>S</a:t>
              </a:r>
              <a:r>
                <a:rPr lang="de-DE" sz="4600" b="1" dirty="0" err="1" smtClean="0"/>
                <a:t>tep</a:t>
              </a:r>
              <a:r>
                <a:rPr lang="de-DE" sz="4600" b="1" dirty="0" smtClean="0"/>
                <a:t> </a:t>
              </a:r>
              <a:r>
                <a:rPr lang="de-DE" sz="4600" b="1" dirty="0"/>
                <a:t>3: </a:t>
              </a:r>
              <a:r>
                <a:rPr lang="de-DE" sz="4600" b="1" dirty="0" err="1" smtClean="0"/>
                <a:t>Local</a:t>
              </a:r>
              <a:r>
                <a:rPr lang="de-DE" sz="4600" b="1" dirty="0" smtClean="0"/>
                <a:t> </a:t>
              </a:r>
              <a:r>
                <a:rPr lang="de-DE" sz="4600" b="1" dirty="0" err="1"/>
                <a:t>re-assembly</a:t>
              </a:r>
              <a:r>
                <a:rPr lang="de-DE" sz="4600" b="1" dirty="0"/>
                <a:t> </a:t>
              </a:r>
              <a:r>
                <a:rPr lang="de-DE" sz="4600" b="1" dirty="0" err="1"/>
                <a:t>and</a:t>
              </a:r>
              <a:r>
                <a:rPr lang="de-DE" sz="4600" b="1" dirty="0"/>
                <a:t> </a:t>
              </a:r>
              <a:r>
                <a:rPr lang="de-DE" sz="4600" b="1" dirty="0" err="1"/>
                <a:t>gap</a:t>
              </a:r>
              <a:r>
                <a:rPr lang="de-DE" sz="4600" b="1" dirty="0"/>
                <a:t> </a:t>
              </a:r>
              <a:r>
                <a:rPr lang="de-DE" sz="4600" b="1" dirty="0" err="1"/>
                <a:t>closure</a:t>
              </a:r>
              <a:endParaRPr lang="de-DE" sz="4600" b="1" dirty="0"/>
            </a:p>
          </p:txBody>
        </p:sp>
        <p:sp>
          <p:nvSpPr>
            <p:cNvPr id="166" name="Textfeld 165"/>
            <p:cNvSpPr txBox="1"/>
            <p:nvPr/>
          </p:nvSpPr>
          <p:spPr>
            <a:xfrm>
              <a:off x="30506299" y="19909017"/>
              <a:ext cx="9776261" cy="1837495"/>
            </a:xfrm>
            <a:prstGeom prst="rect">
              <a:avLst/>
            </a:prstGeom>
            <a:noFill/>
          </p:spPr>
          <p:txBody>
            <a:bodyPr wrap="square" lIns="417643" tIns="208822" rIns="417643" bIns="208822" rtlCol="0">
              <a:spAutoFit/>
            </a:bodyPr>
            <a:lstStyle/>
            <a:p>
              <a:pPr algn="ctr"/>
              <a:r>
                <a:rPr lang="de-DE" sz="4600" b="1" dirty="0" err="1" smtClean="0"/>
                <a:t>Step</a:t>
              </a:r>
              <a:r>
                <a:rPr lang="de-DE" sz="4600" b="1" dirty="0" smtClean="0"/>
                <a:t> </a:t>
              </a:r>
              <a:r>
                <a:rPr lang="de-DE" sz="4600" b="1" dirty="0"/>
                <a:t>4: </a:t>
              </a:r>
              <a:r>
                <a:rPr lang="de-DE" sz="4600" b="1" dirty="0" err="1"/>
                <a:t>Scaffold</a:t>
              </a:r>
              <a:r>
                <a:rPr lang="de-DE" sz="4600" b="1" dirty="0"/>
                <a:t> </a:t>
              </a:r>
              <a:r>
                <a:rPr lang="de-DE" sz="4600" b="1" dirty="0" err="1"/>
                <a:t>according</a:t>
              </a:r>
              <a:r>
                <a:rPr lang="de-DE" sz="4600" b="1" dirty="0"/>
                <a:t> </a:t>
              </a:r>
              <a:r>
                <a:rPr lang="de-DE" sz="4600" b="1" dirty="0" err="1"/>
                <a:t>to</a:t>
              </a:r>
              <a:r>
                <a:rPr lang="de-DE" sz="4600" b="1" dirty="0"/>
                <a:t> </a:t>
              </a:r>
              <a:r>
                <a:rPr lang="de-DE" sz="4600" b="1" dirty="0" err="1"/>
                <a:t>reference</a:t>
              </a:r>
              <a:r>
                <a:rPr lang="de-DE" sz="4600" b="1" dirty="0"/>
                <a:t> </a:t>
              </a:r>
              <a:r>
                <a:rPr lang="de-DE" sz="4600" b="1" dirty="0" err="1"/>
                <a:t>and</a:t>
              </a:r>
              <a:r>
                <a:rPr lang="de-DE" sz="4600" b="1" dirty="0"/>
                <a:t> final </a:t>
              </a:r>
              <a:r>
                <a:rPr lang="de-DE" sz="4600" b="1" dirty="0" err="1"/>
                <a:t>gap</a:t>
              </a:r>
              <a:r>
                <a:rPr lang="de-DE" sz="4600" b="1" dirty="0"/>
                <a:t> </a:t>
              </a:r>
              <a:r>
                <a:rPr lang="de-DE" sz="4600" b="1" dirty="0" err="1"/>
                <a:t>closure</a:t>
              </a:r>
              <a:endParaRPr lang="de-DE" sz="4600" b="1" dirty="0"/>
            </a:p>
          </p:txBody>
        </p:sp>
      </p:grpSp>
      <p:sp>
        <p:nvSpPr>
          <p:cNvPr id="2" name="Rectangle 1"/>
          <p:cNvSpPr/>
          <p:nvPr/>
        </p:nvSpPr>
        <p:spPr>
          <a:xfrm>
            <a:off x="3874415" y="22196771"/>
            <a:ext cx="18528919" cy="120032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7200" b="1" dirty="0"/>
              <a:t>Figure 1: </a:t>
            </a:r>
            <a:r>
              <a:rPr lang="en-GB" sz="7200" dirty="0"/>
              <a:t>Flowchart of the four step CSA pipeline.</a:t>
            </a:r>
            <a:endParaRPr lang="en-US" sz="7200" dirty="0"/>
          </a:p>
        </p:txBody>
      </p:sp>
    </p:spTree>
    <p:extLst>
      <p:ext uri="{BB962C8B-B14F-4D97-AF65-F5344CB8AC3E}">
        <p14:creationId xmlns:p14="http://schemas.microsoft.com/office/powerpoint/2010/main" val="37771429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Rectangle 111"/>
          <p:cNvSpPr/>
          <p:nvPr/>
        </p:nvSpPr>
        <p:spPr>
          <a:xfrm>
            <a:off x="270313" y="28074541"/>
            <a:ext cx="37804200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7200" b="1" dirty="0"/>
              <a:t>Figure </a:t>
            </a:r>
            <a:r>
              <a:rPr lang="en-GB" sz="7200" b="1" dirty="0" smtClean="0"/>
              <a:t>2: </a:t>
            </a:r>
            <a:r>
              <a:rPr lang="en-GB" sz="7200" dirty="0" smtClean="0"/>
              <a:t>Dot plots of CSA results against reference genomes under best-case (top row) and diverged reference scenarios (bottom row) for mammal, bird and fish genomes.</a:t>
            </a:r>
            <a:endParaRPr lang="en-US" sz="7200" dirty="0"/>
          </a:p>
        </p:txBody>
      </p:sp>
      <p:grpSp>
        <p:nvGrpSpPr>
          <p:cNvPr id="23" name="Gruppieren 22"/>
          <p:cNvGrpSpPr/>
          <p:nvPr/>
        </p:nvGrpSpPr>
        <p:grpSpPr>
          <a:xfrm>
            <a:off x="809974" y="-7326509"/>
            <a:ext cx="26354928" cy="35257034"/>
            <a:chOff x="809974" y="-7326509"/>
            <a:chExt cx="26354928" cy="35257034"/>
          </a:xfrm>
        </p:grpSpPr>
        <p:sp>
          <p:nvSpPr>
            <p:cNvPr id="111" name="Rechteck 149"/>
            <p:cNvSpPr/>
            <p:nvPr/>
          </p:nvSpPr>
          <p:spPr>
            <a:xfrm>
              <a:off x="809974" y="-7326509"/>
              <a:ext cx="26354928" cy="35230148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lIns="417643" tIns="208822" rIns="417643" bIns="208822" rtlCol="0" anchor="ctr"/>
            <a:lstStyle/>
            <a:p>
              <a:pPr algn="ctr"/>
              <a:endParaRPr lang="de-DE"/>
            </a:p>
          </p:txBody>
        </p:sp>
        <p:grpSp>
          <p:nvGrpSpPr>
            <p:cNvPr id="6" name="Group 5"/>
            <p:cNvGrpSpPr/>
            <p:nvPr/>
          </p:nvGrpSpPr>
          <p:grpSpPr>
            <a:xfrm>
              <a:off x="815124" y="-7209379"/>
              <a:ext cx="12798542" cy="11703704"/>
              <a:chOff x="953480" y="890290"/>
              <a:chExt cx="12798542" cy="11703704"/>
            </a:xfrm>
          </p:grpSpPr>
          <p:pic>
            <p:nvPicPr>
              <p:cNvPr id="1035" name="Picture 11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sharpenSoften amount="30000"/>
                        </a14:imgEffect>
                        <a14:imgEffect>
                          <a14:brightnessContrast contras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834" r="15859"/>
              <a:stretch/>
            </p:blipFill>
            <p:spPr bwMode="auto">
              <a:xfrm>
                <a:off x="1260022" y="932091"/>
                <a:ext cx="12492000" cy="1143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sp>
            <p:nvSpPr>
              <p:cNvPr id="4" name="TextBox 3"/>
              <p:cNvSpPr txBox="1"/>
              <p:nvPr/>
            </p:nvSpPr>
            <p:spPr>
              <a:xfrm>
                <a:off x="1177515" y="890290"/>
                <a:ext cx="6640359" cy="1129609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r>
                  <a:rPr lang="de-DE" sz="4600" i="1" dirty="0"/>
                  <a:t>H. sapiens</a:t>
                </a:r>
                <a:r>
                  <a:rPr lang="de-DE" sz="4600" dirty="0"/>
                  <a:t>: best-</a:t>
                </a:r>
                <a:r>
                  <a:rPr lang="de-DE" sz="4600" dirty="0" err="1"/>
                  <a:t>case</a:t>
                </a:r>
                <a:endParaRPr lang="en-US" sz="4600" dirty="0"/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>
                <a:off x="3966341" y="11602885"/>
                <a:ext cx="7079362" cy="991109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pPr algn="ctr"/>
                <a:r>
                  <a:rPr lang="de-DE" sz="3700" dirty="0"/>
                  <a:t>Reference (GRCh38)</a:t>
                </a:r>
                <a:endParaRPr lang="en-US" sz="3700" dirty="0"/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 rot="16200000">
                <a:off x="-1377604" y="5707464"/>
                <a:ext cx="5670789" cy="1008622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pPr algn="ctr"/>
                <a:r>
                  <a:rPr lang="de-DE" sz="3700" dirty="0"/>
                  <a:t>CSA (60X SMRT+GRCh38)</a:t>
                </a:r>
                <a:endParaRPr lang="en-US" sz="3700" dirty="0"/>
              </a:p>
            </p:txBody>
          </p:sp>
        </p:grpSp>
        <p:grpSp>
          <p:nvGrpSpPr>
            <p:cNvPr id="12" name="Group 11"/>
            <p:cNvGrpSpPr/>
            <p:nvPr/>
          </p:nvGrpSpPr>
          <p:grpSpPr>
            <a:xfrm>
              <a:off x="1557660" y="4473530"/>
              <a:ext cx="11313471" cy="11741958"/>
              <a:chOff x="15411880" y="763695"/>
              <a:chExt cx="11313471" cy="11741958"/>
            </a:xfrm>
          </p:grpSpPr>
          <p:grpSp>
            <p:nvGrpSpPr>
              <p:cNvPr id="7" name="Group 6"/>
              <p:cNvGrpSpPr/>
              <p:nvPr/>
            </p:nvGrpSpPr>
            <p:grpSpPr>
              <a:xfrm>
                <a:off x="15411880" y="763695"/>
                <a:ext cx="11313471" cy="11490345"/>
                <a:chOff x="15411880" y="763695"/>
                <a:chExt cx="11313471" cy="11490345"/>
              </a:xfrm>
            </p:grpSpPr>
            <p:pic>
              <p:nvPicPr>
                <p:cNvPr id="1036" name="Picture 12"/>
                <p:cNvPicPr>
                  <a:picLocks noChangeAspect="1" noChangeArrowheads="1"/>
                </p:cNvPicPr>
                <p:nvPr/>
              </p:nvPicPr>
              <p:blipFill rotWithShape="1">
                <a:blip r:embed="rId4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sharpenSoften amount="30000"/>
                          </a14:imgEffect>
                          <a14:imgEffect>
                            <a14:brightnessContrast contras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9775" r="19795"/>
                <a:stretch/>
              </p:blipFill>
              <p:spPr bwMode="auto">
                <a:xfrm>
                  <a:off x="15673351" y="824040"/>
                  <a:ext cx="11052000" cy="11430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  <p:sp>
              <p:nvSpPr>
                <p:cNvPr id="8" name="TextBox 7"/>
                <p:cNvSpPr txBox="1"/>
                <p:nvPr/>
              </p:nvSpPr>
              <p:spPr>
                <a:xfrm>
                  <a:off x="15673351" y="763695"/>
                  <a:ext cx="7416474" cy="1129609"/>
                </a:xfrm>
                <a:prstGeom prst="rect">
                  <a:avLst/>
                </a:prstGeom>
                <a:noFill/>
              </p:spPr>
              <p:txBody>
                <a:bodyPr wrap="square" lIns="417643" tIns="208822" rIns="417643" bIns="208822" rtlCol="0">
                  <a:spAutoFit/>
                </a:bodyPr>
                <a:lstStyle/>
                <a:p>
                  <a:r>
                    <a:rPr lang="de-DE" sz="4600" i="1" dirty="0"/>
                    <a:t>T. </a:t>
                  </a:r>
                  <a:r>
                    <a:rPr lang="de-DE" sz="4600" i="1" dirty="0" err="1"/>
                    <a:t>guttata</a:t>
                  </a:r>
                  <a:r>
                    <a:rPr lang="de-DE" sz="4600" dirty="0"/>
                    <a:t>: best-</a:t>
                  </a:r>
                  <a:r>
                    <a:rPr lang="de-DE" sz="4600" dirty="0" err="1"/>
                    <a:t>case</a:t>
                  </a:r>
                  <a:endParaRPr lang="en-US" sz="4600" dirty="0"/>
                </a:p>
              </p:txBody>
            </p:sp>
            <p:sp>
              <p:nvSpPr>
                <p:cNvPr id="24" name="TextBox 23"/>
                <p:cNvSpPr txBox="1"/>
                <p:nvPr/>
              </p:nvSpPr>
              <p:spPr>
                <a:xfrm rot="16200000">
                  <a:off x="12418902" y="5707464"/>
                  <a:ext cx="6994577" cy="1008622"/>
                </a:xfrm>
                <a:prstGeom prst="rect">
                  <a:avLst/>
                </a:prstGeom>
                <a:noFill/>
              </p:spPr>
              <p:txBody>
                <a:bodyPr wrap="square" lIns="417643" tIns="208822" rIns="417643" bIns="208822" rtlCol="0">
                  <a:spAutoFit/>
                </a:bodyPr>
                <a:lstStyle/>
                <a:p>
                  <a:pPr algn="ctr"/>
                  <a:r>
                    <a:rPr lang="de-DE" sz="3700" dirty="0"/>
                    <a:t>CSA (96X SMRT+</a:t>
                  </a:r>
                  <a:r>
                    <a:rPr lang="de-DE" sz="3700" i="1" dirty="0"/>
                    <a:t>T</a:t>
                  </a:r>
                  <a:r>
                    <a:rPr lang="de-DE" sz="3700" i="1" dirty="0" smtClean="0"/>
                    <a:t>. </a:t>
                  </a:r>
                  <a:r>
                    <a:rPr lang="de-DE" sz="3700" i="1" dirty="0" err="1" smtClean="0"/>
                    <a:t>guttata</a:t>
                  </a:r>
                  <a:r>
                    <a:rPr lang="de-DE" sz="3700" dirty="0" smtClean="0"/>
                    <a:t> </a:t>
                  </a:r>
                  <a:r>
                    <a:rPr lang="de-DE" sz="3700" dirty="0"/>
                    <a:t>VGP)</a:t>
                  </a:r>
                  <a:endParaRPr lang="en-US" sz="3700" dirty="0"/>
                </a:p>
              </p:txBody>
            </p:sp>
          </p:grpSp>
          <p:sp>
            <p:nvSpPr>
              <p:cNvPr id="18" name="TextBox 17"/>
              <p:cNvSpPr txBox="1"/>
              <p:nvPr/>
            </p:nvSpPr>
            <p:spPr>
              <a:xfrm>
                <a:off x="17703181" y="11514544"/>
                <a:ext cx="7079362" cy="991109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pPr algn="ctr"/>
                <a:r>
                  <a:rPr lang="de-DE" sz="3700" dirty="0"/>
                  <a:t>Reference (</a:t>
                </a:r>
                <a:r>
                  <a:rPr lang="de-DE" sz="3700" i="1" dirty="0"/>
                  <a:t>T</a:t>
                </a:r>
                <a:r>
                  <a:rPr lang="de-DE" sz="3700" i="1" dirty="0" smtClean="0"/>
                  <a:t>. </a:t>
                </a:r>
                <a:r>
                  <a:rPr lang="de-DE" sz="3700" i="1" dirty="0" err="1" smtClean="0"/>
                  <a:t>guttata</a:t>
                </a:r>
                <a:r>
                  <a:rPr lang="de-DE" sz="3700" dirty="0" smtClean="0"/>
                  <a:t> </a:t>
                </a:r>
                <a:r>
                  <a:rPr lang="de-DE" sz="3700" dirty="0"/>
                  <a:t>VGP)</a:t>
                </a:r>
                <a:endParaRPr lang="en-US" sz="3700" dirty="0"/>
              </a:p>
            </p:txBody>
          </p:sp>
        </p:grpSp>
        <p:grpSp>
          <p:nvGrpSpPr>
            <p:cNvPr id="11" name="Group 10"/>
            <p:cNvGrpSpPr/>
            <p:nvPr/>
          </p:nvGrpSpPr>
          <p:grpSpPr>
            <a:xfrm>
              <a:off x="1279059" y="16191292"/>
              <a:ext cx="11870672" cy="11739233"/>
              <a:chOff x="28387206" y="791194"/>
              <a:chExt cx="11870672" cy="11739233"/>
            </a:xfrm>
          </p:grpSpPr>
          <p:grpSp>
            <p:nvGrpSpPr>
              <p:cNvPr id="10" name="Group 9"/>
              <p:cNvGrpSpPr/>
              <p:nvPr/>
            </p:nvGrpSpPr>
            <p:grpSpPr>
              <a:xfrm>
                <a:off x="28387206" y="791194"/>
                <a:ext cx="11870672" cy="11462846"/>
                <a:chOff x="28387206" y="791194"/>
                <a:chExt cx="11870672" cy="11462846"/>
              </a:xfrm>
            </p:grpSpPr>
            <p:pic>
              <p:nvPicPr>
                <p:cNvPr id="1037" name="Picture 13"/>
                <p:cNvPicPr>
                  <a:picLocks noChangeAspect="1" noChangeArrowheads="1"/>
                </p:cNvPicPr>
                <p:nvPr/>
              </p:nvPicPr>
              <p:blipFill rotWithShape="1">
                <a:blip r:embed="rId6">
                  <a:extLst>
                    <a:ext uri="{BEBA8EAE-BF5A-486C-A8C5-ECC9F3942E4B}">
                      <a14:imgProps xmlns:a14="http://schemas.microsoft.com/office/drawing/2010/main">
                        <a14:imgLayer r:embed="rId7">
                          <a14:imgEffect>
                            <a14:sharpenSoften amount="30000"/>
                          </a14:imgEffect>
                          <a14:imgEffect>
                            <a14:brightnessContrast contras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8397" r="18217"/>
                <a:stretch/>
              </p:blipFill>
              <p:spPr bwMode="auto">
                <a:xfrm>
                  <a:off x="28665878" y="824040"/>
                  <a:ext cx="11592000" cy="11430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  <p:sp>
              <p:nvSpPr>
                <p:cNvPr id="9" name="TextBox 8"/>
                <p:cNvSpPr txBox="1"/>
                <p:nvPr/>
              </p:nvSpPr>
              <p:spPr>
                <a:xfrm>
                  <a:off x="28657115" y="791194"/>
                  <a:ext cx="9265658" cy="1129609"/>
                </a:xfrm>
                <a:prstGeom prst="rect">
                  <a:avLst/>
                </a:prstGeom>
                <a:noFill/>
              </p:spPr>
              <p:txBody>
                <a:bodyPr wrap="square" lIns="417643" tIns="208822" rIns="417643" bIns="208822" rtlCol="0">
                  <a:spAutoFit/>
                </a:bodyPr>
                <a:lstStyle/>
                <a:p>
                  <a:r>
                    <a:rPr lang="de-DE" sz="4600" i="1" dirty="0"/>
                    <a:t>S. </a:t>
                  </a:r>
                  <a:r>
                    <a:rPr lang="de-DE" sz="4600" i="1" dirty="0" err="1"/>
                    <a:t>chuatsi</a:t>
                  </a:r>
                  <a:r>
                    <a:rPr lang="de-DE" sz="4600" dirty="0"/>
                    <a:t>: best-</a:t>
                  </a:r>
                  <a:r>
                    <a:rPr lang="de-DE" sz="4600" dirty="0" err="1"/>
                    <a:t>case</a:t>
                  </a:r>
                  <a:r>
                    <a:rPr lang="de-DE" sz="4600" dirty="0"/>
                    <a:t> </a:t>
                  </a:r>
                  <a:endParaRPr lang="en-US" sz="4600" dirty="0"/>
                </a:p>
              </p:txBody>
            </p:sp>
            <p:sp>
              <p:nvSpPr>
                <p:cNvPr id="25" name="TextBox 24"/>
                <p:cNvSpPr txBox="1"/>
                <p:nvPr/>
              </p:nvSpPr>
              <p:spPr>
                <a:xfrm rot="16200000">
                  <a:off x="25394228" y="6034729"/>
                  <a:ext cx="6994577" cy="1008622"/>
                </a:xfrm>
                <a:prstGeom prst="rect">
                  <a:avLst/>
                </a:prstGeom>
                <a:noFill/>
              </p:spPr>
              <p:txBody>
                <a:bodyPr wrap="square" lIns="417643" tIns="208822" rIns="417643" bIns="208822" rtlCol="0">
                  <a:spAutoFit/>
                </a:bodyPr>
                <a:lstStyle/>
                <a:p>
                  <a:pPr algn="ctr"/>
                  <a:r>
                    <a:rPr lang="de-DE" sz="3700" dirty="0"/>
                    <a:t>CSA (50X SMRT+ sinChu7)</a:t>
                  </a:r>
                  <a:endParaRPr lang="en-US" sz="3700" dirty="0"/>
                </a:p>
              </p:txBody>
            </p:sp>
          </p:grpSp>
          <p:sp>
            <p:nvSpPr>
              <p:cNvPr id="20" name="TextBox 19"/>
              <p:cNvSpPr txBox="1"/>
              <p:nvPr/>
            </p:nvSpPr>
            <p:spPr>
              <a:xfrm>
                <a:off x="31244441" y="11539318"/>
                <a:ext cx="7079362" cy="991109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pPr algn="ctr"/>
                <a:r>
                  <a:rPr lang="de-DE" sz="3700" dirty="0"/>
                  <a:t>Reference (sinChu7)</a:t>
                </a:r>
                <a:endParaRPr lang="en-US" sz="3700" dirty="0"/>
              </a:p>
            </p:txBody>
          </p:sp>
        </p:grpSp>
        <p:grpSp>
          <p:nvGrpSpPr>
            <p:cNvPr id="29" name="Group 28"/>
            <p:cNvGrpSpPr/>
            <p:nvPr/>
          </p:nvGrpSpPr>
          <p:grpSpPr>
            <a:xfrm>
              <a:off x="14557178" y="4501779"/>
              <a:ext cx="11743628" cy="11685461"/>
              <a:chOff x="15392178" y="13549042"/>
              <a:chExt cx="11743628" cy="11685461"/>
            </a:xfrm>
          </p:grpSpPr>
          <p:pic>
            <p:nvPicPr>
              <p:cNvPr id="1033" name="Picture 9"/>
              <p:cNvPicPr>
                <a:picLocks noChangeAspect="1" noChangeArrowheads="1"/>
              </p:cNvPicPr>
              <p:nvPr/>
            </p:nvPicPr>
            <p:blipFill rotWithShape="1">
              <a:blip r:embed="rId8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sharpenSoften amount="30000"/>
                        </a14:imgEffect>
                        <a14:imgEffect>
                          <a14:brightnessContrast contras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582" r="19591"/>
              <a:stretch/>
            </p:blipFill>
            <p:spPr bwMode="auto">
              <a:xfrm>
                <a:off x="15680862" y="13549042"/>
                <a:ext cx="11124000" cy="1143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sp>
            <p:nvSpPr>
              <p:cNvPr id="14" name="TextBox 13"/>
              <p:cNvSpPr txBox="1"/>
              <p:nvPr/>
            </p:nvSpPr>
            <p:spPr>
              <a:xfrm>
                <a:off x="15673983" y="13637073"/>
                <a:ext cx="11461823" cy="1129609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r>
                  <a:rPr lang="de-DE" sz="4600" i="1" dirty="0"/>
                  <a:t>T. </a:t>
                </a:r>
                <a:r>
                  <a:rPr lang="de-DE" sz="4600" i="1" dirty="0" err="1"/>
                  <a:t>guttata</a:t>
                </a:r>
                <a:r>
                  <a:rPr lang="de-DE" sz="4600" dirty="0"/>
                  <a:t>: divergent </a:t>
                </a:r>
                <a:r>
                  <a:rPr lang="de-DE" sz="4600" dirty="0" err="1"/>
                  <a:t>genome</a:t>
                </a:r>
                <a:r>
                  <a:rPr lang="de-DE" sz="4600" dirty="0"/>
                  <a:t> (~65 </a:t>
                </a:r>
                <a:r>
                  <a:rPr lang="de-DE" sz="4600" dirty="0" err="1"/>
                  <a:t>Mya</a:t>
                </a:r>
                <a:r>
                  <a:rPr lang="de-DE" sz="4600" dirty="0"/>
                  <a:t>) </a:t>
                </a:r>
                <a:endParaRPr lang="en-US" sz="4600" dirty="0"/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17703181" y="24243394"/>
                <a:ext cx="7079362" cy="991109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pPr algn="ctr"/>
                <a:r>
                  <a:rPr lang="de-DE" sz="3700" dirty="0"/>
                  <a:t>Reference (</a:t>
                </a:r>
                <a:r>
                  <a:rPr lang="de-DE" sz="3700" i="1" dirty="0"/>
                  <a:t>T</a:t>
                </a:r>
                <a:r>
                  <a:rPr lang="de-DE" sz="3700" i="1" dirty="0" smtClean="0"/>
                  <a:t>. </a:t>
                </a:r>
                <a:r>
                  <a:rPr lang="de-DE" sz="3700" i="1" dirty="0" err="1" smtClean="0"/>
                  <a:t>guttata</a:t>
                </a:r>
                <a:r>
                  <a:rPr lang="de-DE" sz="3700" dirty="0" smtClean="0"/>
                  <a:t> </a:t>
                </a:r>
                <a:r>
                  <a:rPr lang="de-DE" sz="3700" dirty="0"/>
                  <a:t>VGP)</a:t>
                </a:r>
                <a:endParaRPr lang="en-US" sz="3700" dirty="0"/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 rot="16200000">
                <a:off x="12399200" y="19086771"/>
                <a:ext cx="6994577" cy="1008622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pPr algn="ctr"/>
                <a:r>
                  <a:rPr lang="de-DE" sz="3700" dirty="0"/>
                  <a:t>CSA (96X SMRT+</a:t>
                </a:r>
                <a:r>
                  <a:rPr lang="de-DE" sz="3700" i="1" dirty="0"/>
                  <a:t>C. </a:t>
                </a:r>
                <a:r>
                  <a:rPr lang="de-DE" sz="3700" i="1" dirty="0" err="1"/>
                  <a:t>anna</a:t>
                </a:r>
                <a:r>
                  <a:rPr lang="de-DE" sz="3700" dirty="0"/>
                  <a:t> VGP)</a:t>
                </a:r>
                <a:endParaRPr lang="en-US" sz="3700" dirty="0"/>
              </a:p>
            </p:txBody>
          </p:sp>
        </p:grpSp>
        <p:grpSp>
          <p:nvGrpSpPr>
            <p:cNvPr id="16" name="Group 15"/>
            <p:cNvGrpSpPr/>
            <p:nvPr/>
          </p:nvGrpSpPr>
          <p:grpSpPr>
            <a:xfrm>
              <a:off x="13916821" y="-7166390"/>
              <a:ext cx="12816542" cy="11685461"/>
              <a:chOff x="953480" y="13549042"/>
              <a:chExt cx="12816542" cy="11685461"/>
            </a:xfrm>
          </p:grpSpPr>
          <p:pic>
            <p:nvPicPr>
              <p:cNvPr id="1034" name="Picture 10"/>
              <p:cNvPicPr>
                <a:picLocks noChangeAspect="1" noChangeArrowheads="1"/>
              </p:cNvPicPr>
              <p:nvPr/>
            </p:nvPicPr>
            <p:blipFill rotWithShape="1">
              <a:blip r:embed="rId10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sharpenSoften amount="30000"/>
                        </a14:imgEffect>
                        <a14:imgEffect>
                          <a14:brightnessContrast contras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639" r="15857"/>
              <a:stretch/>
            </p:blipFill>
            <p:spPr bwMode="auto">
              <a:xfrm>
                <a:off x="1242022" y="13549042"/>
                <a:ext cx="12528000" cy="1143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sp>
            <p:nvSpPr>
              <p:cNvPr id="13" name="TextBox 12"/>
              <p:cNvSpPr txBox="1"/>
              <p:nvPr/>
            </p:nvSpPr>
            <p:spPr>
              <a:xfrm>
                <a:off x="1177516" y="13637073"/>
                <a:ext cx="11461823" cy="1129609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r>
                  <a:rPr lang="de-DE" sz="4600" i="1" dirty="0"/>
                  <a:t>H. sapiens</a:t>
                </a:r>
                <a:r>
                  <a:rPr lang="de-DE" sz="4600" dirty="0"/>
                  <a:t>: divergent </a:t>
                </a:r>
                <a:r>
                  <a:rPr lang="de-DE" sz="4600" dirty="0" err="1"/>
                  <a:t>genome</a:t>
                </a:r>
                <a:r>
                  <a:rPr lang="de-DE" sz="4600" dirty="0"/>
                  <a:t> (~15 </a:t>
                </a:r>
                <a:r>
                  <a:rPr lang="de-DE" sz="4600" dirty="0" err="1"/>
                  <a:t>Mya</a:t>
                </a:r>
                <a:r>
                  <a:rPr lang="de-DE" sz="4600" dirty="0"/>
                  <a:t>) </a:t>
                </a:r>
                <a:endParaRPr lang="en-US" sz="4600" dirty="0"/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3966341" y="24243394"/>
                <a:ext cx="7079362" cy="991109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pPr algn="ctr"/>
                <a:r>
                  <a:rPr lang="de-DE" sz="3700" dirty="0"/>
                  <a:t>Reference (GRCh38)</a:t>
                </a:r>
                <a:endParaRPr lang="en-US" sz="3700" dirty="0"/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 rot="16200000">
                <a:off x="-1377604" y="18759731"/>
                <a:ext cx="5670789" cy="1008622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pPr algn="ctr"/>
                <a:r>
                  <a:rPr lang="de-DE" sz="3700" dirty="0"/>
                  <a:t>CSA (60X SMRT+</a:t>
                </a:r>
                <a:r>
                  <a:rPr lang="de-DE" sz="3700" i="1" dirty="0"/>
                  <a:t>P. </a:t>
                </a:r>
                <a:r>
                  <a:rPr lang="de-DE" sz="3700" i="1" dirty="0" err="1"/>
                  <a:t>abelii</a:t>
                </a:r>
                <a:r>
                  <a:rPr lang="de-DE" sz="3700" dirty="0"/>
                  <a:t>)</a:t>
                </a:r>
                <a:endParaRPr lang="en-US" sz="3700" dirty="0"/>
              </a:p>
            </p:txBody>
          </p:sp>
        </p:grpSp>
        <p:grpSp>
          <p:nvGrpSpPr>
            <p:cNvPr id="30" name="Group 29"/>
            <p:cNvGrpSpPr/>
            <p:nvPr/>
          </p:nvGrpSpPr>
          <p:grpSpPr>
            <a:xfrm>
              <a:off x="14390106" y="16218178"/>
              <a:ext cx="11869972" cy="11685461"/>
              <a:chOff x="28387906" y="13549042"/>
              <a:chExt cx="11869972" cy="11685461"/>
            </a:xfrm>
          </p:grpSpPr>
          <p:pic>
            <p:nvPicPr>
              <p:cNvPr id="1032" name="Picture 8"/>
              <p:cNvPicPr>
                <a:picLocks noChangeAspect="1" noChangeArrowheads="1"/>
              </p:cNvPicPr>
              <p:nvPr/>
            </p:nvPicPr>
            <p:blipFill rotWithShape="1">
              <a:blip r:embed="rId12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sharpenSoften amount="30000"/>
                        </a14:imgEffect>
                        <a14:imgEffect>
                          <a14:brightnessContrast contras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212" r="18416"/>
              <a:stretch/>
            </p:blipFill>
            <p:spPr bwMode="auto">
              <a:xfrm>
                <a:off x="28665878" y="13549042"/>
                <a:ext cx="11592000" cy="1143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sp>
            <p:nvSpPr>
              <p:cNvPr id="15" name="TextBox 14"/>
              <p:cNvSpPr txBox="1"/>
              <p:nvPr/>
            </p:nvSpPr>
            <p:spPr>
              <a:xfrm>
                <a:off x="28575978" y="13664611"/>
                <a:ext cx="11461823" cy="1129609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r>
                  <a:rPr lang="de-DE" sz="4600" i="1" dirty="0"/>
                  <a:t>S. </a:t>
                </a:r>
                <a:r>
                  <a:rPr lang="de-DE" sz="4600" i="1" dirty="0" err="1"/>
                  <a:t>chuatsi</a:t>
                </a:r>
                <a:r>
                  <a:rPr lang="de-DE" sz="4600" dirty="0"/>
                  <a:t>: divergent </a:t>
                </a:r>
                <a:r>
                  <a:rPr lang="de-DE" sz="4600" dirty="0" err="1"/>
                  <a:t>genome</a:t>
                </a:r>
                <a:r>
                  <a:rPr lang="de-DE" sz="4600" dirty="0"/>
                  <a:t> (~65 </a:t>
                </a:r>
                <a:r>
                  <a:rPr lang="de-DE" sz="4600" dirty="0" err="1"/>
                  <a:t>Mya</a:t>
                </a:r>
                <a:r>
                  <a:rPr lang="de-DE" sz="4600" dirty="0"/>
                  <a:t>) </a:t>
                </a:r>
                <a:endParaRPr lang="en-US" sz="4600" dirty="0"/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30922197" y="24243394"/>
                <a:ext cx="7079362" cy="991109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pPr algn="ctr"/>
                <a:r>
                  <a:rPr lang="de-DE" sz="3700" dirty="0"/>
                  <a:t>Reference (sinChu7)</a:t>
                </a:r>
                <a:endParaRPr lang="en-US" sz="3700" dirty="0"/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 rot="16200000">
                <a:off x="25394928" y="18821347"/>
                <a:ext cx="6994577" cy="1008622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pPr algn="ctr"/>
                <a:r>
                  <a:rPr lang="de-DE" sz="3700" dirty="0"/>
                  <a:t>CSA (50X SMRT+ </a:t>
                </a:r>
                <a:r>
                  <a:rPr lang="de-DE" sz="3700" i="1" dirty="0"/>
                  <a:t>P. </a:t>
                </a:r>
                <a:r>
                  <a:rPr lang="de-DE" sz="3700" i="1" dirty="0" err="1"/>
                  <a:t>flavescens</a:t>
                </a:r>
                <a:r>
                  <a:rPr lang="de-DE" sz="3700" dirty="0"/>
                  <a:t>)</a:t>
                </a:r>
                <a:endParaRPr lang="en-US" sz="3700" dirty="0"/>
              </a:p>
            </p:txBody>
          </p:sp>
        </p:grpSp>
        <p:sp>
          <p:nvSpPr>
            <p:cNvPr id="3" name="TextBox 2"/>
            <p:cNvSpPr txBox="1"/>
            <p:nvPr/>
          </p:nvSpPr>
          <p:spPr>
            <a:xfrm>
              <a:off x="25940766" y="-4936076"/>
              <a:ext cx="720080" cy="13542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dirty="0" smtClean="0"/>
                <a:t>x</a:t>
              </a:r>
              <a:endParaRPr lang="en-US" dirty="0"/>
            </a:p>
          </p:txBody>
        </p:sp>
        <p:cxnSp>
          <p:nvCxnSpPr>
            <p:cNvPr id="31" name="Straight Arrow Connector 30"/>
            <p:cNvCxnSpPr/>
            <p:nvPr/>
          </p:nvCxnSpPr>
          <p:spPr>
            <a:xfrm flipV="1">
              <a:off x="26228798" y="-6606429"/>
              <a:ext cx="0" cy="1991326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TextBox 39"/>
            <p:cNvSpPr txBox="1"/>
            <p:nvPr/>
          </p:nvSpPr>
          <p:spPr>
            <a:xfrm>
              <a:off x="24985619" y="6856814"/>
              <a:ext cx="595107" cy="13542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dirty="0" smtClean="0"/>
                <a:t>z</a:t>
              </a:r>
              <a:endParaRPr lang="en-US" dirty="0"/>
            </a:p>
          </p:txBody>
        </p:sp>
        <p:cxnSp>
          <p:nvCxnSpPr>
            <p:cNvPr id="41" name="Straight Arrow Connector 40"/>
            <p:cNvCxnSpPr/>
            <p:nvPr/>
          </p:nvCxnSpPr>
          <p:spPr>
            <a:xfrm flipV="1">
              <a:off x="25268314" y="5850955"/>
              <a:ext cx="0" cy="1343254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6393919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" name="Group 32"/>
          <p:cNvGrpSpPr/>
          <p:nvPr/>
        </p:nvGrpSpPr>
        <p:grpSpPr>
          <a:xfrm>
            <a:off x="809974" y="-225002"/>
            <a:ext cx="37804200" cy="27367108"/>
            <a:chOff x="809974" y="378347"/>
            <a:chExt cx="37804200" cy="27367108"/>
          </a:xfrm>
        </p:grpSpPr>
        <p:grpSp>
          <p:nvGrpSpPr>
            <p:cNvPr id="2" name="Group 1"/>
            <p:cNvGrpSpPr/>
            <p:nvPr/>
          </p:nvGrpSpPr>
          <p:grpSpPr>
            <a:xfrm>
              <a:off x="809974" y="378347"/>
              <a:ext cx="37804200" cy="27367108"/>
              <a:chOff x="809974" y="378347"/>
              <a:chExt cx="37804200" cy="27367108"/>
            </a:xfrm>
          </p:grpSpPr>
          <p:sp>
            <p:nvSpPr>
              <p:cNvPr id="111" name="Rechteck 149"/>
              <p:cNvSpPr/>
              <p:nvPr/>
            </p:nvSpPr>
            <p:spPr>
              <a:xfrm>
                <a:off x="809974" y="378347"/>
                <a:ext cx="37804200" cy="24626736"/>
              </a:xfrm>
              <a:prstGeom prst="rect">
                <a:avLst/>
              </a:prstGeom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lIns="417643" tIns="208822" rIns="417643" bIns="208822" rtlCol="0" anchor="ctr"/>
              <a:lstStyle/>
              <a:p>
                <a:pPr algn="ctr"/>
                <a:endParaRPr lang="de-DE"/>
              </a:p>
            </p:txBody>
          </p:sp>
          <p:grpSp>
            <p:nvGrpSpPr>
              <p:cNvPr id="6" name="Group 5"/>
              <p:cNvGrpSpPr/>
              <p:nvPr/>
            </p:nvGrpSpPr>
            <p:grpSpPr>
              <a:xfrm>
                <a:off x="962990" y="826992"/>
                <a:ext cx="12798542" cy="11703704"/>
                <a:chOff x="953480" y="890290"/>
                <a:chExt cx="12798542" cy="11703704"/>
              </a:xfrm>
            </p:grpSpPr>
            <p:pic>
              <p:nvPicPr>
                <p:cNvPr id="1035" name="Picture 11"/>
                <p:cNvPicPr>
                  <a:picLocks noChangeAspect="1" noChangeArrowheads="1"/>
                </p:cNvPicPr>
                <p:nvPr/>
              </p:nvPicPr>
              <p:blipFill rotWithShape="1">
                <a:blip r:embed="rId2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sharpenSoften amount="30000"/>
                          </a14:imgEffect>
                          <a14:imgEffect>
                            <a14:brightnessContrast contras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5834" r="15859"/>
                <a:stretch/>
              </p:blipFill>
              <p:spPr bwMode="auto">
                <a:xfrm>
                  <a:off x="1260022" y="932091"/>
                  <a:ext cx="12492000" cy="11430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  <p:sp>
              <p:nvSpPr>
                <p:cNvPr id="4" name="TextBox 3"/>
                <p:cNvSpPr txBox="1"/>
                <p:nvPr/>
              </p:nvSpPr>
              <p:spPr>
                <a:xfrm>
                  <a:off x="1177515" y="890290"/>
                  <a:ext cx="6640359" cy="1129609"/>
                </a:xfrm>
                <a:prstGeom prst="rect">
                  <a:avLst/>
                </a:prstGeom>
                <a:noFill/>
              </p:spPr>
              <p:txBody>
                <a:bodyPr wrap="square" lIns="417643" tIns="208822" rIns="417643" bIns="208822" rtlCol="0">
                  <a:spAutoFit/>
                </a:bodyPr>
                <a:lstStyle/>
                <a:p>
                  <a:r>
                    <a:rPr lang="de-DE" sz="4600" i="1" dirty="0"/>
                    <a:t>H. sapiens</a:t>
                  </a:r>
                  <a:r>
                    <a:rPr lang="de-DE" sz="4600" dirty="0"/>
                    <a:t>: best-</a:t>
                  </a:r>
                  <a:r>
                    <a:rPr lang="de-DE" sz="4600" dirty="0" err="1"/>
                    <a:t>case</a:t>
                  </a:r>
                  <a:endParaRPr lang="en-US" sz="4600" dirty="0"/>
                </a:p>
              </p:txBody>
            </p:sp>
            <p:sp>
              <p:nvSpPr>
                <p:cNvPr id="5" name="TextBox 4"/>
                <p:cNvSpPr txBox="1"/>
                <p:nvPr/>
              </p:nvSpPr>
              <p:spPr>
                <a:xfrm>
                  <a:off x="3966341" y="11602885"/>
                  <a:ext cx="7079362" cy="991109"/>
                </a:xfrm>
                <a:prstGeom prst="rect">
                  <a:avLst/>
                </a:prstGeom>
                <a:noFill/>
              </p:spPr>
              <p:txBody>
                <a:bodyPr wrap="square" lIns="417643" tIns="208822" rIns="417643" bIns="208822" rtlCol="0">
                  <a:spAutoFit/>
                </a:bodyPr>
                <a:lstStyle/>
                <a:p>
                  <a:pPr algn="ctr"/>
                  <a:r>
                    <a:rPr lang="de-DE" sz="3700" dirty="0"/>
                    <a:t>Reference (GRCh38)</a:t>
                  </a:r>
                  <a:endParaRPr lang="en-US" sz="3700" dirty="0"/>
                </a:p>
              </p:txBody>
            </p:sp>
            <p:sp>
              <p:nvSpPr>
                <p:cNvPr id="22" name="TextBox 21"/>
                <p:cNvSpPr txBox="1"/>
                <p:nvPr/>
              </p:nvSpPr>
              <p:spPr>
                <a:xfrm rot="16200000">
                  <a:off x="-1377604" y="5707464"/>
                  <a:ext cx="5670789" cy="1008622"/>
                </a:xfrm>
                <a:prstGeom prst="rect">
                  <a:avLst/>
                </a:prstGeom>
                <a:noFill/>
              </p:spPr>
              <p:txBody>
                <a:bodyPr wrap="square" lIns="417643" tIns="208822" rIns="417643" bIns="208822" rtlCol="0">
                  <a:spAutoFit/>
                </a:bodyPr>
                <a:lstStyle/>
                <a:p>
                  <a:pPr algn="ctr"/>
                  <a:r>
                    <a:rPr lang="de-DE" sz="3700" dirty="0"/>
                    <a:t>CSA (60X SMRT+GRCh38)</a:t>
                  </a:r>
                  <a:endParaRPr lang="en-US" sz="3700" dirty="0"/>
                </a:p>
              </p:txBody>
            </p:sp>
          </p:grpSp>
          <p:grpSp>
            <p:nvGrpSpPr>
              <p:cNvPr id="12" name="Group 11"/>
              <p:cNvGrpSpPr/>
              <p:nvPr/>
            </p:nvGrpSpPr>
            <p:grpSpPr>
              <a:xfrm>
                <a:off x="14289383" y="788738"/>
                <a:ext cx="11313471" cy="11741958"/>
                <a:chOff x="15411880" y="763695"/>
                <a:chExt cx="11313471" cy="11741958"/>
              </a:xfrm>
            </p:grpSpPr>
            <p:grpSp>
              <p:nvGrpSpPr>
                <p:cNvPr id="7" name="Group 6"/>
                <p:cNvGrpSpPr/>
                <p:nvPr/>
              </p:nvGrpSpPr>
              <p:grpSpPr>
                <a:xfrm>
                  <a:off x="15411880" y="763695"/>
                  <a:ext cx="11313471" cy="11490345"/>
                  <a:chOff x="15411880" y="763695"/>
                  <a:chExt cx="11313471" cy="11490345"/>
                </a:xfrm>
              </p:grpSpPr>
              <p:pic>
                <p:nvPicPr>
                  <p:cNvPr id="1036" name="Picture 12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4">
                    <a:extLst>
                      <a:ext uri="{BEBA8EAE-BF5A-486C-A8C5-ECC9F3942E4B}">
                        <a14:imgProps xmlns:a14="http://schemas.microsoft.com/office/drawing/2010/main">
                          <a14:imgLayer r:embed="rId5">
                            <a14:imgEffect>
                              <a14:sharpenSoften amount="30000"/>
                            </a14:imgEffect>
                            <a14:imgEffect>
                              <a14:brightnessContrast contrast="5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9775" r="19795"/>
                  <a:stretch/>
                </p:blipFill>
                <p:spPr bwMode="auto">
                  <a:xfrm>
                    <a:off x="15673351" y="824040"/>
                    <a:ext cx="11052000" cy="11430000"/>
                  </a:xfrm>
                  <a:prstGeom prst="rect">
                    <a:avLst/>
                  </a:prstGeom>
                  <a:noFill/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</a:extLst>
                </p:spPr>
              </p:pic>
              <p:sp>
                <p:nvSpPr>
                  <p:cNvPr id="8" name="TextBox 7"/>
                  <p:cNvSpPr txBox="1"/>
                  <p:nvPr/>
                </p:nvSpPr>
                <p:spPr>
                  <a:xfrm>
                    <a:off x="15673351" y="763695"/>
                    <a:ext cx="7416474" cy="1129609"/>
                  </a:xfrm>
                  <a:prstGeom prst="rect">
                    <a:avLst/>
                  </a:prstGeom>
                  <a:noFill/>
                </p:spPr>
                <p:txBody>
                  <a:bodyPr wrap="square" lIns="417643" tIns="208822" rIns="417643" bIns="208822" rtlCol="0">
                    <a:spAutoFit/>
                  </a:bodyPr>
                  <a:lstStyle/>
                  <a:p>
                    <a:r>
                      <a:rPr lang="de-DE" sz="4600" i="1" dirty="0"/>
                      <a:t>T. </a:t>
                    </a:r>
                    <a:r>
                      <a:rPr lang="de-DE" sz="4600" i="1" dirty="0" err="1"/>
                      <a:t>guttata</a:t>
                    </a:r>
                    <a:r>
                      <a:rPr lang="de-DE" sz="4600" dirty="0"/>
                      <a:t>: best-</a:t>
                    </a:r>
                    <a:r>
                      <a:rPr lang="de-DE" sz="4600" dirty="0" err="1"/>
                      <a:t>case</a:t>
                    </a:r>
                    <a:endParaRPr lang="en-US" sz="4600" dirty="0"/>
                  </a:p>
                </p:txBody>
              </p:sp>
              <p:sp>
                <p:nvSpPr>
                  <p:cNvPr id="24" name="TextBox 23"/>
                  <p:cNvSpPr txBox="1"/>
                  <p:nvPr/>
                </p:nvSpPr>
                <p:spPr>
                  <a:xfrm rot="16200000">
                    <a:off x="12418902" y="5707464"/>
                    <a:ext cx="6994577" cy="1008622"/>
                  </a:xfrm>
                  <a:prstGeom prst="rect">
                    <a:avLst/>
                  </a:prstGeom>
                  <a:noFill/>
                </p:spPr>
                <p:txBody>
                  <a:bodyPr wrap="square" lIns="417643" tIns="208822" rIns="417643" bIns="208822" rtlCol="0">
                    <a:spAutoFit/>
                  </a:bodyPr>
                  <a:lstStyle/>
                  <a:p>
                    <a:pPr algn="ctr"/>
                    <a:r>
                      <a:rPr lang="de-DE" sz="3700" dirty="0"/>
                      <a:t>CSA (96X SMRT+</a:t>
                    </a:r>
                    <a:r>
                      <a:rPr lang="de-DE" sz="3700" i="1" dirty="0"/>
                      <a:t>T</a:t>
                    </a:r>
                    <a:r>
                      <a:rPr lang="de-DE" sz="3700" i="1" dirty="0" smtClean="0"/>
                      <a:t>. </a:t>
                    </a:r>
                    <a:r>
                      <a:rPr lang="de-DE" sz="3700" i="1" dirty="0" err="1" smtClean="0"/>
                      <a:t>guttata</a:t>
                    </a:r>
                    <a:r>
                      <a:rPr lang="de-DE" sz="3700" dirty="0" smtClean="0"/>
                      <a:t> </a:t>
                    </a:r>
                    <a:r>
                      <a:rPr lang="de-DE" sz="3700" dirty="0"/>
                      <a:t>VGP)</a:t>
                    </a:r>
                    <a:endParaRPr lang="en-US" sz="3700" dirty="0"/>
                  </a:p>
                </p:txBody>
              </p:sp>
            </p:grpSp>
            <p:sp>
              <p:nvSpPr>
                <p:cNvPr id="18" name="TextBox 17"/>
                <p:cNvSpPr txBox="1"/>
                <p:nvPr/>
              </p:nvSpPr>
              <p:spPr>
                <a:xfrm>
                  <a:off x="17703181" y="11514544"/>
                  <a:ext cx="7079362" cy="991109"/>
                </a:xfrm>
                <a:prstGeom prst="rect">
                  <a:avLst/>
                </a:prstGeom>
                <a:noFill/>
              </p:spPr>
              <p:txBody>
                <a:bodyPr wrap="square" lIns="417643" tIns="208822" rIns="417643" bIns="208822" rtlCol="0">
                  <a:spAutoFit/>
                </a:bodyPr>
                <a:lstStyle/>
                <a:p>
                  <a:pPr algn="ctr"/>
                  <a:r>
                    <a:rPr lang="de-DE" sz="3700" dirty="0"/>
                    <a:t>Reference (</a:t>
                  </a:r>
                  <a:r>
                    <a:rPr lang="de-DE" sz="3700" i="1" dirty="0"/>
                    <a:t>T</a:t>
                  </a:r>
                  <a:r>
                    <a:rPr lang="de-DE" sz="3700" i="1" dirty="0" smtClean="0"/>
                    <a:t>. </a:t>
                  </a:r>
                  <a:r>
                    <a:rPr lang="de-DE" sz="3700" i="1" dirty="0" err="1" smtClean="0"/>
                    <a:t>guttata</a:t>
                  </a:r>
                  <a:r>
                    <a:rPr lang="de-DE" sz="3700" dirty="0" smtClean="0"/>
                    <a:t> </a:t>
                  </a:r>
                  <a:r>
                    <a:rPr lang="de-DE" sz="3700" dirty="0"/>
                    <a:t>VGP)</a:t>
                  </a:r>
                  <a:endParaRPr lang="en-US" sz="3700" dirty="0"/>
                </a:p>
              </p:txBody>
            </p:sp>
          </p:grpSp>
          <p:grpSp>
            <p:nvGrpSpPr>
              <p:cNvPr id="11" name="Group 10"/>
              <p:cNvGrpSpPr/>
              <p:nvPr/>
            </p:nvGrpSpPr>
            <p:grpSpPr>
              <a:xfrm>
                <a:off x="26228703" y="791463"/>
                <a:ext cx="11870672" cy="11739233"/>
                <a:chOff x="28387206" y="791194"/>
                <a:chExt cx="11870672" cy="11739233"/>
              </a:xfrm>
            </p:grpSpPr>
            <p:grpSp>
              <p:nvGrpSpPr>
                <p:cNvPr id="10" name="Group 9"/>
                <p:cNvGrpSpPr/>
                <p:nvPr/>
              </p:nvGrpSpPr>
              <p:grpSpPr>
                <a:xfrm>
                  <a:off x="28387206" y="791194"/>
                  <a:ext cx="11870672" cy="11462846"/>
                  <a:chOff x="28387206" y="791194"/>
                  <a:chExt cx="11870672" cy="11462846"/>
                </a:xfrm>
              </p:grpSpPr>
              <p:pic>
                <p:nvPicPr>
                  <p:cNvPr id="1037" name="Picture 13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6">
                    <a:extLst>
                      <a:ext uri="{BEBA8EAE-BF5A-486C-A8C5-ECC9F3942E4B}">
                        <a14:imgProps xmlns:a14="http://schemas.microsoft.com/office/drawing/2010/main">
                          <a14:imgLayer r:embed="rId7">
                            <a14:imgEffect>
                              <a14:sharpenSoften amount="30000"/>
                            </a14:imgEffect>
                            <a14:imgEffect>
                              <a14:brightnessContrast contrast="5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8397" r="18217"/>
                  <a:stretch/>
                </p:blipFill>
                <p:spPr bwMode="auto">
                  <a:xfrm>
                    <a:off x="28665878" y="824040"/>
                    <a:ext cx="11592000" cy="11430000"/>
                  </a:xfrm>
                  <a:prstGeom prst="rect">
                    <a:avLst/>
                  </a:prstGeom>
                  <a:noFill/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</a:extLst>
                </p:spPr>
              </p:pic>
              <p:sp>
                <p:nvSpPr>
                  <p:cNvPr id="9" name="TextBox 8"/>
                  <p:cNvSpPr txBox="1"/>
                  <p:nvPr/>
                </p:nvSpPr>
                <p:spPr>
                  <a:xfrm>
                    <a:off x="28657115" y="791194"/>
                    <a:ext cx="9265658" cy="1129609"/>
                  </a:xfrm>
                  <a:prstGeom prst="rect">
                    <a:avLst/>
                  </a:prstGeom>
                  <a:noFill/>
                </p:spPr>
                <p:txBody>
                  <a:bodyPr wrap="square" lIns="417643" tIns="208822" rIns="417643" bIns="208822" rtlCol="0">
                    <a:spAutoFit/>
                  </a:bodyPr>
                  <a:lstStyle/>
                  <a:p>
                    <a:r>
                      <a:rPr lang="de-DE" sz="4600" i="1" dirty="0"/>
                      <a:t>S. </a:t>
                    </a:r>
                    <a:r>
                      <a:rPr lang="de-DE" sz="4600" i="1" dirty="0" err="1"/>
                      <a:t>chuatsi</a:t>
                    </a:r>
                    <a:r>
                      <a:rPr lang="de-DE" sz="4600" dirty="0"/>
                      <a:t>: best-</a:t>
                    </a:r>
                    <a:r>
                      <a:rPr lang="de-DE" sz="4600" dirty="0" err="1"/>
                      <a:t>case</a:t>
                    </a:r>
                    <a:r>
                      <a:rPr lang="de-DE" sz="4600" dirty="0"/>
                      <a:t> </a:t>
                    </a:r>
                    <a:endParaRPr lang="en-US" sz="4600" dirty="0"/>
                  </a:p>
                </p:txBody>
              </p:sp>
              <p:sp>
                <p:nvSpPr>
                  <p:cNvPr id="25" name="TextBox 24"/>
                  <p:cNvSpPr txBox="1"/>
                  <p:nvPr/>
                </p:nvSpPr>
                <p:spPr>
                  <a:xfrm rot="16200000">
                    <a:off x="25394228" y="6034729"/>
                    <a:ext cx="6994577" cy="1008622"/>
                  </a:xfrm>
                  <a:prstGeom prst="rect">
                    <a:avLst/>
                  </a:prstGeom>
                  <a:noFill/>
                </p:spPr>
                <p:txBody>
                  <a:bodyPr wrap="square" lIns="417643" tIns="208822" rIns="417643" bIns="208822" rtlCol="0">
                    <a:spAutoFit/>
                  </a:bodyPr>
                  <a:lstStyle/>
                  <a:p>
                    <a:pPr algn="ctr"/>
                    <a:r>
                      <a:rPr lang="de-DE" sz="3700" dirty="0"/>
                      <a:t>CSA (50X SMRT+ sinChu7)</a:t>
                    </a:r>
                    <a:endParaRPr lang="en-US" sz="3700" dirty="0"/>
                  </a:p>
                </p:txBody>
              </p:sp>
            </p:grpSp>
            <p:sp>
              <p:nvSpPr>
                <p:cNvPr id="20" name="TextBox 19"/>
                <p:cNvSpPr txBox="1"/>
                <p:nvPr/>
              </p:nvSpPr>
              <p:spPr>
                <a:xfrm>
                  <a:off x="31244441" y="11539318"/>
                  <a:ext cx="7079362" cy="991109"/>
                </a:xfrm>
                <a:prstGeom prst="rect">
                  <a:avLst/>
                </a:prstGeom>
                <a:noFill/>
              </p:spPr>
              <p:txBody>
                <a:bodyPr wrap="square" lIns="417643" tIns="208822" rIns="417643" bIns="208822" rtlCol="0">
                  <a:spAutoFit/>
                </a:bodyPr>
                <a:lstStyle/>
                <a:p>
                  <a:pPr algn="ctr"/>
                  <a:r>
                    <a:rPr lang="de-DE" sz="3700" dirty="0"/>
                    <a:t>Reference (sinChu7)</a:t>
                  </a:r>
                  <a:endParaRPr lang="en-US" sz="3700" dirty="0"/>
                </a:p>
              </p:txBody>
            </p:sp>
          </p:grpSp>
          <p:grpSp>
            <p:nvGrpSpPr>
              <p:cNvPr id="29" name="Group 28"/>
              <p:cNvGrpSpPr/>
              <p:nvPr/>
            </p:nvGrpSpPr>
            <p:grpSpPr>
              <a:xfrm>
                <a:off x="14262190" y="13031590"/>
                <a:ext cx="11743628" cy="11685461"/>
                <a:chOff x="15392178" y="13549042"/>
                <a:chExt cx="11743628" cy="11685461"/>
              </a:xfrm>
            </p:grpSpPr>
            <p:pic>
              <p:nvPicPr>
                <p:cNvPr id="1033" name="Picture 9"/>
                <p:cNvPicPr>
                  <a:picLocks noChangeAspect="1" noChangeArrowheads="1"/>
                </p:cNvPicPr>
                <p:nvPr/>
              </p:nvPicPr>
              <p:blipFill rotWithShape="1">
                <a:blip r:embed="rId8">
                  <a:extLst>
                    <a:ext uri="{BEBA8EAE-BF5A-486C-A8C5-ECC9F3942E4B}">
                      <a14:imgProps xmlns:a14="http://schemas.microsoft.com/office/drawing/2010/main">
                        <a14:imgLayer r:embed="rId9">
                          <a14:imgEffect>
                            <a14:sharpenSoften amount="30000"/>
                          </a14:imgEffect>
                          <a14:imgEffect>
                            <a14:brightnessContrast contras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9582" r="19591"/>
                <a:stretch/>
              </p:blipFill>
              <p:spPr bwMode="auto">
                <a:xfrm>
                  <a:off x="15680862" y="13549042"/>
                  <a:ext cx="11124000" cy="11430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  <p:sp>
              <p:nvSpPr>
                <p:cNvPr id="14" name="TextBox 13"/>
                <p:cNvSpPr txBox="1"/>
                <p:nvPr/>
              </p:nvSpPr>
              <p:spPr>
                <a:xfrm>
                  <a:off x="15673983" y="13637073"/>
                  <a:ext cx="11461823" cy="1129609"/>
                </a:xfrm>
                <a:prstGeom prst="rect">
                  <a:avLst/>
                </a:prstGeom>
                <a:noFill/>
              </p:spPr>
              <p:txBody>
                <a:bodyPr wrap="square" lIns="417643" tIns="208822" rIns="417643" bIns="208822" rtlCol="0">
                  <a:spAutoFit/>
                </a:bodyPr>
                <a:lstStyle/>
                <a:p>
                  <a:r>
                    <a:rPr lang="de-DE" sz="4600" i="1" dirty="0"/>
                    <a:t>T. </a:t>
                  </a:r>
                  <a:r>
                    <a:rPr lang="de-DE" sz="4600" i="1" dirty="0" err="1"/>
                    <a:t>guttata</a:t>
                  </a:r>
                  <a:r>
                    <a:rPr lang="de-DE" sz="4600" dirty="0"/>
                    <a:t>: divergent </a:t>
                  </a:r>
                  <a:r>
                    <a:rPr lang="de-DE" sz="4600" dirty="0" err="1"/>
                    <a:t>genome</a:t>
                  </a:r>
                  <a:r>
                    <a:rPr lang="de-DE" sz="4600" dirty="0"/>
                    <a:t> (~65 </a:t>
                  </a:r>
                  <a:r>
                    <a:rPr lang="de-DE" sz="4600" dirty="0" err="1"/>
                    <a:t>Mya</a:t>
                  </a:r>
                  <a:r>
                    <a:rPr lang="de-DE" sz="4600" dirty="0"/>
                    <a:t>) </a:t>
                  </a:r>
                  <a:endParaRPr lang="en-US" sz="4600" dirty="0"/>
                </a:p>
              </p:txBody>
            </p:sp>
            <p:sp>
              <p:nvSpPr>
                <p:cNvPr id="19" name="TextBox 18"/>
                <p:cNvSpPr txBox="1"/>
                <p:nvPr/>
              </p:nvSpPr>
              <p:spPr>
                <a:xfrm>
                  <a:off x="17703181" y="24243394"/>
                  <a:ext cx="7079362" cy="991109"/>
                </a:xfrm>
                <a:prstGeom prst="rect">
                  <a:avLst/>
                </a:prstGeom>
                <a:noFill/>
              </p:spPr>
              <p:txBody>
                <a:bodyPr wrap="square" lIns="417643" tIns="208822" rIns="417643" bIns="208822" rtlCol="0">
                  <a:spAutoFit/>
                </a:bodyPr>
                <a:lstStyle/>
                <a:p>
                  <a:pPr algn="ctr"/>
                  <a:r>
                    <a:rPr lang="de-DE" sz="3700" dirty="0"/>
                    <a:t>Reference (</a:t>
                  </a:r>
                  <a:r>
                    <a:rPr lang="de-DE" sz="3700" i="1" dirty="0"/>
                    <a:t>T</a:t>
                  </a:r>
                  <a:r>
                    <a:rPr lang="de-DE" sz="3700" i="1" dirty="0" smtClean="0"/>
                    <a:t>. </a:t>
                  </a:r>
                  <a:r>
                    <a:rPr lang="de-DE" sz="3700" i="1" dirty="0" err="1" smtClean="0"/>
                    <a:t>guttata</a:t>
                  </a:r>
                  <a:r>
                    <a:rPr lang="de-DE" sz="3700" dirty="0" smtClean="0"/>
                    <a:t> </a:t>
                  </a:r>
                  <a:r>
                    <a:rPr lang="de-DE" sz="3700" dirty="0"/>
                    <a:t>VGP)</a:t>
                  </a:r>
                  <a:endParaRPr lang="en-US" sz="3700" dirty="0"/>
                </a:p>
              </p:txBody>
            </p:sp>
            <p:sp>
              <p:nvSpPr>
                <p:cNvPr id="26" name="TextBox 25"/>
                <p:cNvSpPr txBox="1"/>
                <p:nvPr/>
              </p:nvSpPr>
              <p:spPr>
                <a:xfrm rot="16200000">
                  <a:off x="12399200" y="19086771"/>
                  <a:ext cx="6994577" cy="1008622"/>
                </a:xfrm>
                <a:prstGeom prst="rect">
                  <a:avLst/>
                </a:prstGeom>
                <a:noFill/>
              </p:spPr>
              <p:txBody>
                <a:bodyPr wrap="square" lIns="417643" tIns="208822" rIns="417643" bIns="208822" rtlCol="0">
                  <a:spAutoFit/>
                </a:bodyPr>
                <a:lstStyle/>
                <a:p>
                  <a:pPr algn="ctr"/>
                  <a:r>
                    <a:rPr lang="de-DE" sz="3700" dirty="0"/>
                    <a:t>CSA (96X SMRT+</a:t>
                  </a:r>
                  <a:r>
                    <a:rPr lang="de-DE" sz="3700" i="1" dirty="0"/>
                    <a:t>C. </a:t>
                  </a:r>
                  <a:r>
                    <a:rPr lang="de-DE" sz="3700" i="1" dirty="0" err="1"/>
                    <a:t>anna</a:t>
                  </a:r>
                  <a:r>
                    <a:rPr lang="de-DE" sz="3700" dirty="0"/>
                    <a:t> VGP)</a:t>
                  </a:r>
                  <a:endParaRPr lang="en-US" sz="3700" dirty="0"/>
                </a:p>
              </p:txBody>
            </p:sp>
          </p:grpSp>
          <p:grpSp>
            <p:nvGrpSpPr>
              <p:cNvPr id="16" name="Group 15"/>
              <p:cNvGrpSpPr/>
              <p:nvPr/>
            </p:nvGrpSpPr>
            <p:grpSpPr>
              <a:xfrm>
                <a:off x="953990" y="13027572"/>
                <a:ext cx="12816542" cy="11685461"/>
                <a:chOff x="953480" y="13549042"/>
                <a:chExt cx="12816542" cy="11685461"/>
              </a:xfrm>
            </p:grpSpPr>
            <p:pic>
              <p:nvPicPr>
                <p:cNvPr id="1034" name="Picture 10"/>
                <p:cNvPicPr>
                  <a:picLocks noChangeAspect="1" noChangeArrowheads="1"/>
                </p:cNvPicPr>
                <p:nvPr/>
              </p:nvPicPr>
              <p:blipFill rotWithShape="1">
                <a:blip r:embed="rId10">
                  <a:extLst>
                    <a:ext uri="{BEBA8EAE-BF5A-486C-A8C5-ECC9F3942E4B}">
                      <a14:imgProps xmlns:a14="http://schemas.microsoft.com/office/drawing/2010/main">
                        <a14:imgLayer r:embed="rId11">
                          <a14:imgEffect>
                            <a14:sharpenSoften amount="30000"/>
                          </a14:imgEffect>
                          <a14:imgEffect>
                            <a14:brightnessContrast contras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5639" r="15857"/>
                <a:stretch/>
              </p:blipFill>
              <p:spPr bwMode="auto">
                <a:xfrm>
                  <a:off x="1242022" y="13549042"/>
                  <a:ext cx="12528000" cy="11430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  <p:sp>
              <p:nvSpPr>
                <p:cNvPr id="13" name="TextBox 12"/>
                <p:cNvSpPr txBox="1"/>
                <p:nvPr/>
              </p:nvSpPr>
              <p:spPr>
                <a:xfrm>
                  <a:off x="1177516" y="13637073"/>
                  <a:ext cx="11461823" cy="1129609"/>
                </a:xfrm>
                <a:prstGeom prst="rect">
                  <a:avLst/>
                </a:prstGeom>
                <a:noFill/>
              </p:spPr>
              <p:txBody>
                <a:bodyPr wrap="square" lIns="417643" tIns="208822" rIns="417643" bIns="208822" rtlCol="0">
                  <a:spAutoFit/>
                </a:bodyPr>
                <a:lstStyle/>
                <a:p>
                  <a:r>
                    <a:rPr lang="de-DE" sz="4600" i="1" dirty="0"/>
                    <a:t>H. sapiens</a:t>
                  </a:r>
                  <a:r>
                    <a:rPr lang="de-DE" sz="4600" dirty="0"/>
                    <a:t>: divergent </a:t>
                  </a:r>
                  <a:r>
                    <a:rPr lang="de-DE" sz="4600" dirty="0" err="1"/>
                    <a:t>genome</a:t>
                  </a:r>
                  <a:r>
                    <a:rPr lang="de-DE" sz="4600" dirty="0"/>
                    <a:t> (~15 </a:t>
                  </a:r>
                  <a:r>
                    <a:rPr lang="de-DE" sz="4600" dirty="0" err="1"/>
                    <a:t>Mya</a:t>
                  </a:r>
                  <a:r>
                    <a:rPr lang="de-DE" sz="4600" dirty="0"/>
                    <a:t>) </a:t>
                  </a:r>
                  <a:endParaRPr lang="en-US" sz="4600" dirty="0"/>
                </a:p>
              </p:txBody>
            </p:sp>
            <p:sp>
              <p:nvSpPr>
                <p:cNvPr id="17" name="TextBox 16"/>
                <p:cNvSpPr txBox="1"/>
                <p:nvPr/>
              </p:nvSpPr>
              <p:spPr>
                <a:xfrm>
                  <a:off x="3966341" y="24243394"/>
                  <a:ext cx="7079362" cy="991109"/>
                </a:xfrm>
                <a:prstGeom prst="rect">
                  <a:avLst/>
                </a:prstGeom>
                <a:noFill/>
              </p:spPr>
              <p:txBody>
                <a:bodyPr wrap="square" lIns="417643" tIns="208822" rIns="417643" bIns="208822" rtlCol="0">
                  <a:spAutoFit/>
                </a:bodyPr>
                <a:lstStyle/>
                <a:p>
                  <a:pPr algn="ctr"/>
                  <a:r>
                    <a:rPr lang="de-DE" sz="3700" dirty="0"/>
                    <a:t>Reference (GRCh38)</a:t>
                  </a:r>
                  <a:endParaRPr lang="en-US" sz="3700" dirty="0"/>
                </a:p>
              </p:txBody>
            </p:sp>
            <p:sp>
              <p:nvSpPr>
                <p:cNvPr id="27" name="TextBox 26"/>
                <p:cNvSpPr txBox="1"/>
                <p:nvPr/>
              </p:nvSpPr>
              <p:spPr>
                <a:xfrm rot="16200000">
                  <a:off x="-1377604" y="18759731"/>
                  <a:ext cx="5670789" cy="1008622"/>
                </a:xfrm>
                <a:prstGeom prst="rect">
                  <a:avLst/>
                </a:prstGeom>
                <a:noFill/>
              </p:spPr>
              <p:txBody>
                <a:bodyPr wrap="square" lIns="417643" tIns="208822" rIns="417643" bIns="208822" rtlCol="0">
                  <a:spAutoFit/>
                </a:bodyPr>
                <a:lstStyle/>
                <a:p>
                  <a:pPr algn="ctr"/>
                  <a:r>
                    <a:rPr lang="de-DE" sz="3700" dirty="0"/>
                    <a:t>CSA (60X SMRT+</a:t>
                  </a:r>
                  <a:r>
                    <a:rPr lang="de-DE" sz="3700" i="1" dirty="0"/>
                    <a:t>P. </a:t>
                  </a:r>
                  <a:r>
                    <a:rPr lang="de-DE" sz="3700" i="1" dirty="0" err="1"/>
                    <a:t>abelii</a:t>
                  </a:r>
                  <a:r>
                    <a:rPr lang="de-DE" sz="3700" dirty="0"/>
                    <a:t>)</a:t>
                  </a:r>
                  <a:endParaRPr lang="en-US" sz="3700" dirty="0"/>
                </a:p>
              </p:txBody>
            </p:sp>
          </p:grpSp>
          <p:grpSp>
            <p:nvGrpSpPr>
              <p:cNvPr id="30" name="Group 29"/>
              <p:cNvGrpSpPr/>
              <p:nvPr/>
            </p:nvGrpSpPr>
            <p:grpSpPr>
              <a:xfrm>
                <a:off x="26229053" y="13027572"/>
                <a:ext cx="11869972" cy="11685461"/>
                <a:chOff x="28387906" y="13549042"/>
                <a:chExt cx="11869972" cy="11685461"/>
              </a:xfrm>
            </p:grpSpPr>
            <p:pic>
              <p:nvPicPr>
                <p:cNvPr id="1032" name="Picture 8"/>
                <p:cNvPicPr>
                  <a:picLocks noChangeAspect="1" noChangeArrowheads="1"/>
                </p:cNvPicPr>
                <p:nvPr/>
              </p:nvPicPr>
              <p:blipFill rotWithShape="1">
                <a:blip r:embed="rId12">
                  <a:extLst>
                    <a:ext uri="{BEBA8EAE-BF5A-486C-A8C5-ECC9F3942E4B}">
                      <a14:imgProps xmlns:a14="http://schemas.microsoft.com/office/drawing/2010/main">
                        <a14:imgLayer r:embed="rId13">
                          <a14:imgEffect>
                            <a14:sharpenSoften amount="30000"/>
                          </a14:imgEffect>
                          <a14:imgEffect>
                            <a14:brightnessContrast contras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8212" r="18416"/>
                <a:stretch/>
              </p:blipFill>
              <p:spPr bwMode="auto">
                <a:xfrm>
                  <a:off x="28665878" y="13549042"/>
                  <a:ext cx="11592000" cy="11430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  <p:sp>
              <p:nvSpPr>
                <p:cNvPr id="15" name="TextBox 14"/>
                <p:cNvSpPr txBox="1"/>
                <p:nvPr/>
              </p:nvSpPr>
              <p:spPr>
                <a:xfrm>
                  <a:off x="28575978" y="13664611"/>
                  <a:ext cx="11461823" cy="1129609"/>
                </a:xfrm>
                <a:prstGeom prst="rect">
                  <a:avLst/>
                </a:prstGeom>
                <a:noFill/>
              </p:spPr>
              <p:txBody>
                <a:bodyPr wrap="square" lIns="417643" tIns="208822" rIns="417643" bIns="208822" rtlCol="0">
                  <a:spAutoFit/>
                </a:bodyPr>
                <a:lstStyle/>
                <a:p>
                  <a:r>
                    <a:rPr lang="de-DE" sz="4600" i="1" dirty="0"/>
                    <a:t>S. </a:t>
                  </a:r>
                  <a:r>
                    <a:rPr lang="de-DE" sz="4600" i="1" dirty="0" err="1"/>
                    <a:t>chuatsi</a:t>
                  </a:r>
                  <a:r>
                    <a:rPr lang="de-DE" sz="4600" dirty="0"/>
                    <a:t>: divergent </a:t>
                  </a:r>
                  <a:r>
                    <a:rPr lang="de-DE" sz="4600" dirty="0" err="1"/>
                    <a:t>genome</a:t>
                  </a:r>
                  <a:r>
                    <a:rPr lang="de-DE" sz="4600" dirty="0"/>
                    <a:t> (~65 </a:t>
                  </a:r>
                  <a:r>
                    <a:rPr lang="de-DE" sz="4600" dirty="0" err="1"/>
                    <a:t>Mya</a:t>
                  </a:r>
                  <a:r>
                    <a:rPr lang="de-DE" sz="4600" dirty="0"/>
                    <a:t>) </a:t>
                  </a:r>
                  <a:endParaRPr lang="en-US" sz="4600" dirty="0"/>
                </a:p>
              </p:txBody>
            </p:sp>
            <p:sp>
              <p:nvSpPr>
                <p:cNvPr id="21" name="TextBox 20"/>
                <p:cNvSpPr txBox="1"/>
                <p:nvPr/>
              </p:nvSpPr>
              <p:spPr>
                <a:xfrm>
                  <a:off x="30922197" y="24243394"/>
                  <a:ext cx="7079362" cy="991109"/>
                </a:xfrm>
                <a:prstGeom prst="rect">
                  <a:avLst/>
                </a:prstGeom>
                <a:noFill/>
              </p:spPr>
              <p:txBody>
                <a:bodyPr wrap="square" lIns="417643" tIns="208822" rIns="417643" bIns="208822" rtlCol="0">
                  <a:spAutoFit/>
                </a:bodyPr>
                <a:lstStyle/>
                <a:p>
                  <a:pPr algn="ctr"/>
                  <a:r>
                    <a:rPr lang="de-DE" sz="3700" dirty="0"/>
                    <a:t>Reference (sinChu7)</a:t>
                  </a:r>
                  <a:endParaRPr lang="en-US" sz="3700" dirty="0"/>
                </a:p>
              </p:txBody>
            </p:sp>
            <p:sp>
              <p:nvSpPr>
                <p:cNvPr id="28" name="TextBox 27"/>
                <p:cNvSpPr txBox="1"/>
                <p:nvPr/>
              </p:nvSpPr>
              <p:spPr>
                <a:xfrm rot="16200000">
                  <a:off x="25394928" y="18821347"/>
                  <a:ext cx="6994577" cy="1008622"/>
                </a:xfrm>
                <a:prstGeom prst="rect">
                  <a:avLst/>
                </a:prstGeom>
                <a:noFill/>
              </p:spPr>
              <p:txBody>
                <a:bodyPr wrap="square" lIns="417643" tIns="208822" rIns="417643" bIns="208822" rtlCol="0">
                  <a:spAutoFit/>
                </a:bodyPr>
                <a:lstStyle/>
                <a:p>
                  <a:pPr algn="ctr"/>
                  <a:r>
                    <a:rPr lang="de-DE" sz="3700" dirty="0"/>
                    <a:t>CSA (50X SMRT+ </a:t>
                  </a:r>
                  <a:r>
                    <a:rPr lang="de-DE" sz="3700" i="1" dirty="0"/>
                    <a:t>P. </a:t>
                  </a:r>
                  <a:r>
                    <a:rPr lang="de-DE" sz="3700" i="1" dirty="0" err="1"/>
                    <a:t>flavescens</a:t>
                  </a:r>
                  <a:r>
                    <a:rPr lang="de-DE" sz="3700" dirty="0"/>
                    <a:t>)</a:t>
                  </a:r>
                  <a:endParaRPr lang="en-US" sz="3700" dirty="0"/>
                </a:p>
              </p:txBody>
            </p:sp>
          </p:grpSp>
          <p:sp>
            <p:nvSpPr>
              <p:cNvPr id="112" name="Rectangle 111"/>
              <p:cNvSpPr/>
              <p:nvPr/>
            </p:nvSpPr>
            <p:spPr>
              <a:xfrm>
                <a:off x="809974" y="25437131"/>
                <a:ext cx="37804200" cy="230832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GB" sz="7200" b="1" dirty="0"/>
                  <a:t>Figure </a:t>
                </a:r>
                <a:r>
                  <a:rPr lang="en-GB" sz="7200" b="1" dirty="0" smtClean="0"/>
                  <a:t>2: </a:t>
                </a:r>
                <a:r>
                  <a:rPr lang="en-GB" sz="7200" dirty="0" smtClean="0"/>
                  <a:t>Dot plots of CSA results against reference genomes under best-case (top row) and diverged reference scenarios (bottom row) for mammal, bird and fish genomes.</a:t>
                </a:r>
                <a:endParaRPr lang="en-US" sz="7200" dirty="0"/>
              </a:p>
            </p:txBody>
          </p:sp>
        </p:grpSp>
        <p:sp>
          <p:nvSpPr>
            <p:cNvPr id="3" name="TextBox 2"/>
            <p:cNvSpPr txBox="1"/>
            <p:nvPr/>
          </p:nvSpPr>
          <p:spPr>
            <a:xfrm>
              <a:off x="12922176" y="15569782"/>
              <a:ext cx="720080" cy="13542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dirty="0" smtClean="0"/>
                <a:t>x</a:t>
              </a:r>
              <a:endParaRPr lang="en-US" dirty="0"/>
            </a:p>
          </p:txBody>
        </p:sp>
        <p:cxnSp>
          <p:nvCxnSpPr>
            <p:cNvPr id="31" name="Straight Arrow Connector 30"/>
            <p:cNvCxnSpPr/>
            <p:nvPr/>
          </p:nvCxnSpPr>
          <p:spPr>
            <a:xfrm flipV="1">
              <a:off x="13267358" y="13915851"/>
              <a:ext cx="0" cy="1991326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TextBox 39"/>
            <p:cNvSpPr txBox="1"/>
            <p:nvPr/>
          </p:nvSpPr>
          <p:spPr>
            <a:xfrm>
              <a:off x="24779117" y="15569782"/>
              <a:ext cx="595107" cy="13542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dirty="0" smtClean="0"/>
                <a:t>z</a:t>
              </a:r>
              <a:endParaRPr lang="en-US" dirty="0"/>
            </a:p>
          </p:txBody>
        </p:sp>
        <p:cxnSp>
          <p:nvCxnSpPr>
            <p:cNvPr id="41" name="Straight Arrow Connector 40"/>
            <p:cNvCxnSpPr/>
            <p:nvPr/>
          </p:nvCxnSpPr>
          <p:spPr>
            <a:xfrm flipV="1">
              <a:off x="25061812" y="14563923"/>
              <a:ext cx="0" cy="1343254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85154449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809974" y="378347"/>
            <a:ext cx="37228136" cy="16089728"/>
            <a:chOff x="809974" y="378347"/>
            <a:chExt cx="37228136" cy="16089728"/>
          </a:xfrm>
        </p:grpSpPr>
        <p:sp>
          <p:nvSpPr>
            <p:cNvPr id="18" name="Rechteck 149"/>
            <p:cNvSpPr/>
            <p:nvPr/>
          </p:nvSpPr>
          <p:spPr>
            <a:xfrm>
              <a:off x="809974" y="378347"/>
              <a:ext cx="37228136" cy="12313368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lIns="417643" tIns="208822" rIns="417643" bIns="208822" rtlCol="0" anchor="ctr"/>
            <a:lstStyle/>
            <a:p>
              <a:pPr algn="ctr"/>
              <a:endParaRPr lang="de-DE"/>
            </a:p>
          </p:txBody>
        </p:sp>
        <p:grpSp>
          <p:nvGrpSpPr>
            <p:cNvPr id="2" name="Group 1"/>
            <p:cNvGrpSpPr/>
            <p:nvPr/>
          </p:nvGrpSpPr>
          <p:grpSpPr>
            <a:xfrm>
              <a:off x="881983" y="890290"/>
              <a:ext cx="11829870" cy="11712414"/>
              <a:chOff x="881983" y="890290"/>
              <a:chExt cx="11829870" cy="11712414"/>
            </a:xfrm>
          </p:grpSpPr>
          <p:pic>
            <p:nvPicPr>
              <p:cNvPr id="2051" name="Picture 3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sharpenSoften amount="30000"/>
                        </a14:imgEffect>
                        <a14:imgEffect>
                          <a14:brightnessContrast contras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475" r="18534"/>
              <a:stretch/>
            </p:blipFill>
            <p:spPr bwMode="auto">
              <a:xfrm>
                <a:off x="1191853" y="890290"/>
                <a:ext cx="11520000" cy="1143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sp>
            <p:nvSpPr>
              <p:cNvPr id="4" name="TextBox 3"/>
              <p:cNvSpPr txBox="1"/>
              <p:nvPr/>
            </p:nvSpPr>
            <p:spPr>
              <a:xfrm>
                <a:off x="1177515" y="890290"/>
                <a:ext cx="6640359" cy="1129609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r>
                  <a:rPr lang="de-DE" sz="4600" i="1" dirty="0" smtClean="0"/>
                  <a:t>P. </a:t>
                </a:r>
                <a:r>
                  <a:rPr lang="de-DE" sz="4600" i="1" dirty="0" err="1" smtClean="0"/>
                  <a:t>fluviatilis</a:t>
                </a:r>
                <a:r>
                  <a:rPr lang="de-DE" sz="4600" dirty="0" smtClean="0"/>
                  <a:t>: </a:t>
                </a:r>
                <a:r>
                  <a:rPr lang="de-DE" sz="4600" dirty="0"/>
                  <a:t>best-</a:t>
                </a:r>
                <a:r>
                  <a:rPr lang="de-DE" sz="4600" dirty="0" err="1"/>
                  <a:t>case</a:t>
                </a:r>
                <a:endParaRPr lang="en-US" sz="4600" dirty="0"/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>
                <a:off x="3412172" y="11611595"/>
                <a:ext cx="7079362" cy="991109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pPr algn="ctr"/>
                <a:r>
                  <a:rPr lang="de-DE" sz="3700" dirty="0"/>
                  <a:t>Reference </a:t>
                </a:r>
                <a:r>
                  <a:rPr lang="de-DE" sz="3700" dirty="0" smtClean="0"/>
                  <a:t>(</a:t>
                </a:r>
                <a:r>
                  <a:rPr lang="de-DE" sz="3700" i="1" dirty="0" smtClean="0"/>
                  <a:t>P. </a:t>
                </a:r>
                <a:r>
                  <a:rPr lang="de-DE" sz="3700" i="1" dirty="0" err="1" smtClean="0"/>
                  <a:t>fluviatilis</a:t>
                </a:r>
                <a:r>
                  <a:rPr lang="de-DE" sz="3700" i="1" dirty="0" smtClean="0"/>
                  <a:t> </a:t>
                </a:r>
                <a:r>
                  <a:rPr lang="de-DE" sz="3700" dirty="0" smtClean="0"/>
                  <a:t>Hi-C)</a:t>
                </a:r>
                <a:endParaRPr lang="en-US" sz="3700" dirty="0"/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 rot="16200000">
                <a:off x="-2114851" y="6109736"/>
                <a:ext cx="6984777" cy="991109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pPr algn="ctr"/>
                <a:r>
                  <a:rPr lang="de-DE" sz="3700" dirty="0"/>
                  <a:t>CSA (</a:t>
                </a:r>
                <a:r>
                  <a:rPr lang="de-DE" sz="3700" dirty="0" smtClean="0"/>
                  <a:t>67X ONT+ </a:t>
                </a:r>
                <a:r>
                  <a:rPr lang="de-DE" sz="3700" i="1" dirty="0" err="1" smtClean="0"/>
                  <a:t>P.fluviatilis</a:t>
                </a:r>
                <a:r>
                  <a:rPr lang="de-DE" sz="3700" dirty="0" smtClean="0"/>
                  <a:t> Hi-C)</a:t>
                </a:r>
                <a:endParaRPr lang="en-US" sz="3700" dirty="0"/>
              </a:p>
            </p:txBody>
          </p:sp>
        </p:grpSp>
        <p:grpSp>
          <p:nvGrpSpPr>
            <p:cNvPr id="3" name="Group 2"/>
            <p:cNvGrpSpPr/>
            <p:nvPr/>
          </p:nvGrpSpPr>
          <p:grpSpPr>
            <a:xfrm>
              <a:off x="13339366" y="890289"/>
              <a:ext cx="11828450" cy="11712415"/>
              <a:chOff x="13138924" y="890289"/>
              <a:chExt cx="11828450" cy="11712415"/>
            </a:xfrm>
          </p:grpSpPr>
          <p:pic>
            <p:nvPicPr>
              <p:cNvPr id="2050" name="Picture 2"/>
              <p:cNvPicPr>
                <a:picLocks noChangeAspect="1" noChangeArrowheads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harpenSoften amount="30000"/>
                        </a14:imgEffect>
                        <a14:imgEffect>
                          <a14:brightnessContrast contras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390" r="18412"/>
              <a:stretch/>
            </p:blipFill>
            <p:spPr bwMode="auto">
              <a:xfrm>
                <a:off x="13411374" y="890290"/>
                <a:ext cx="11556000" cy="1143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sp>
            <p:nvSpPr>
              <p:cNvPr id="29" name="TextBox 28"/>
              <p:cNvSpPr txBox="1"/>
              <p:nvPr/>
            </p:nvSpPr>
            <p:spPr>
              <a:xfrm>
                <a:off x="15649693" y="11611595"/>
                <a:ext cx="7079362" cy="991109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pPr algn="ctr"/>
                <a:r>
                  <a:rPr lang="de-DE" sz="3700" dirty="0"/>
                  <a:t>Reference </a:t>
                </a:r>
                <a:r>
                  <a:rPr lang="de-DE" sz="3700" dirty="0" smtClean="0"/>
                  <a:t>(</a:t>
                </a:r>
                <a:r>
                  <a:rPr lang="de-DE" sz="3700" i="1" dirty="0" smtClean="0"/>
                  <a:t>P. </a:t>
                </a:r>
                <a:r>
                  <a:rPr lang="de-DE" sz="3700" i="1" dirty="0" err="1" smtClean="0"/>
                  <a:t>fluviatilis</a:t>
                </a:r>
                <a:r>
                  <a:rPr lang="de-DE" sz="3700" i="1" dirty="0" smtClean="0"/>
                  <a:t> </a:t>
                </a:r>
                <a:r>
                  <a:rPr lang="de-DE" sz="3700" dirty="0" smtClean="0"/>
                  <a:t>Hi-C)</a:t>
                </a:r>
                <a:endParaRPr lang="en-US" sz="3700" dirty="0"/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13411374" y="890289"/>
                <a:ext cx="8064896" cy="1837495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r>
                  <a:rPr lang="de-DE" sz="4600" i="1" dirty="0" smtClean="0"/>
                  <a:t>P. </a:t>
                </a:r>
                <a:r>
                  <a:rPr lang="de-DE" sz="4600" i="1" dirty="0" err="1" smtClean="0"/>
                  <a:t>fluviatilis</a:t>
                </a:r>
                <a:r>
                  <a:rPr lang="de-DE" sz="4600" dirty="0" smtClean="0"/>
                  <a:t>: 10X </a:t>
                </a:r>
                <a:r>
                  <a:rPr lang="de-DE" sz="4600" dirty="0" err="1" smtClean="0"/>
                  <a:t>Genomics</a:t>
                </a:r>
                <a:r>
                  <a:rPr lang="de-DE" sz="4600" dirty="0" smtClean="0"/>
                  <a:t> + </a:t>
                </a:r>
                <a:r>
                  <a:rPr lang="de-DE" sz="4600" dirty="0" err="1" smtClean="0"/>
                  <a:t>diverged</a:t>
                </a:r>
                <a:r>
                  <a:rPr lang="de-DE" sz="4600" dirty="0" smtClean="0"/>
                  <a:t> </a:t>
                </a:r>
                <a:r>
                  <a:rPr lang="de-DE" sz="4600" dirty="0" err="1" smtClean="0"/>
                  <a:t>references</a:t>
                </a:r>
                <a:endParaRPr lang="en-US" sz="4600" dirty="0"/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 rot="16200000">
                <a:off x="10635674" y="5603633"/>
                <a:ext cx="6566996" cy="1560496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pPr algn="ctr"/>
                <a:r>
                  <a:rPr lang="de-DE" sz="3700" dirty="0"/>
                  <a:t>CSA (</a:t>
                </a:r>
                <a:r>
                  <a:rPr lang="de-DE" sz="3700" dirty="0" smtClean="0"/>
                  <a:t>67X ONT+ 10X </a:t>
                </a:r>
                <a:r>
                  <a:rPr lang="de-DE" sz="3700" dirty="0" err="1" smtClean="0"/>
                  <a:t>Genomics</a:t>
                </a:r>
                <a:r>
                  <a:rPr lang="de-DE" sz="3700" dirty="0" smtClean="0"/>
                  <a:t> + </a:t>
                </a:r>
                <a:r>
                  <a:rPr lang="de-DE" sz="3700" i="1" dirty="0" smtClean="0"/>
                  <a:t>P. </a:t>
                </a:r>
                <a:r>
                  <a:rPr lang="de-DE" sz="3700" i="1" dirty="0" err="1" smtClean="0"/>
                  <a:t>flavescens</a:t>
                </a:r>
                <a:r>
                  <a:rPr lang="de-DE" sz="3700" dirty="0" smtClean="0"/>
                  <a:t> + </a:t>
                </a:r>
                <a:r>
                  <a:rPr lang="de-DE" sz="3700" i="1" dirty="0" smtClean="0"/>
                  <a:t>S. </a:t>
                </a:r>
                <a:r>
                  <a:rPr lang="de-DE" sz="3700" i="1" dirty="0" err="1" smtClean="0"/>
                  <a:t>chuatsi</a:t>
                </a:r>
                <a:r>
                  <a:rPr lang="de-DE" sz="3700" dirty="0" smtClean="0"/>
                  <a:t>)</a:t>
                </a:r>
                <a:endParaRPr lang="en-US" sz="3700" dirty="0"/>
              </a:p>
            </p:txBody>
          </p:sp>
        </p:grpSp>
        <p:grpSp>
          <p:nvGrpSpPr>
            <p:cNvPr id="6" name="Group 5"/>
            <p:cNvGrpSpPr/>
            <p:nvPr/>
          </p:nvGrpSpPr>
          <p:grpSpPr>
            <a:xfrm>
              <a:off x="25813753" y="624375"/>
              <a:ext cx="11827029" cy="11963471"/>
              <a:chOff x="25813753" y="624375"/>
              <a:chExt cx="11827029" cy="11963471"/>
            </a:xfrm>
          </p:grpSpPr>
          <p:pic>
            <p:nvPicPr>
              <p:cNvPr id="2052" name="Picture 4"/>
              <p:cNvPicPr>
                <a:picLocks noChangeAspect="1" noChangeArrowheads="1"/>
              </p:cNvPicPr>
              <p:nvPr/>
            </p:nvPicPr>
            <p:blipFill rotWithShape="1"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sharpenSoften amount="30000"/>
                        </a14:imgEffect>
                        <a14:imgEffect>
                          <a14:brightnessContrast contras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391" r="18412"/>
              <a:stretch/>
            </p:blipFill>
            <p:spPr bwMode="auto">
              <a:xfrm>
                <a:off x="26084782" y="860284"/>
                <a:ext cx="11556000" cy="1143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sp>
            <p:nvSpPr>
              <p:cNvPr id="33" name="TextBox 32"/>
              <p:cNvSpPr txBox="1"/>
              <p:nvPr/>
            </p:nvSpPr>
            <p:spPr>
              <a:xfrm rot="16200000">
                <a:off x="20328393" y="6109735"/>
                <a:ext cx="11961829" cy="991109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pPr algn="ctr"/>
                <a:r>
                  <a:rPr lang="de-DE" sz="3700" dirty="0"/>
                  <a:t>CSA (</a:t>
                </a:r>
                <a:r>
                  <a:rPr lang="de-DE" sz="3700" dirty="0" smtClean="0"/>
                  <a:t>67X ONT+ </a:t>
                </a:r>
                <a:r>
                  <a:rPr lang="de-DE" sz="3700" i="1" dirty="0" smtClean="0"/>
                  <a:t>P. </a:t>
                </a:r>
                <a:r>
                  <a:rPr lang="de-DE" sz="3700" i="1" dirty="0" err="1" smtClean="0"/>
                  <a:t>flavescens</a:t>
                </a:r>
                <a:r>
                  <a:rPr lang="de-DE" sz="3700" dirty="0" smtClean="0"/>
                  <a:t> + </a:t>
                </a:r>
                <a:r>
                  <a:rPr lang="de-DE" sz="3700" i="1" dirty="0" smtClean="0"/>
                  <a:t>S. </a:t>
                </a:r>
                <a:r>
                  <a:rPr lang="de-DE" sz="3700" i="1" dirty="0" err="1" smtClean="0"/>
                  <a:t>chuatsi</a:t>
                </a:r>
                <a:r>
                  <a:rPr lang="de-DE" sz="3700" dirty="0" smtClean="0"/>
                  <a:t>)</a:t>
                </a:r>
                <a:endParaRPr lang="en-US" sz="3700" dirty="0"/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26084781" y="902848"/>
                <a:ext cx="9001001" cy="1837495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r>
                  <a:rPr lang="de-DE" sz="4600" i="1" dirty="0" smtClean="0"/>
                  <a:t>P. </a:t>
                </a:r>
                <a:r>
                  <a:rPr lang="de-DE" sz="4600" i="1" dirty="0" err="1" smtClean="0"/>
                  <a:t>fluviatilis</a:t>
                </a:r>
                <a:r>
                  <a:rPr lang="de-DE" sz="4600" dirty="0" smtClean="0"/>
                  <a:t>: </a:t>
                </a:r>
                <a:r>
                  <a:rPr lang="de-DE" sz="4600" dirty="0" err="1" smtClean="0"/>
                  <a:t>diverged</a:t>
                </a:r>
                <a:r>
                  <a:rPr lang="de-DE" sz="4600" dirty="0" smtClean="0"/>
                  <a:t> </a:t>
                </a:r>
                <a:r>
                  <a:rPr lang="de-DE" sz="4600" dirty="0" err="1" smtClean="0"/>
                  <a:t>references</a:t>
                </a:r>
                <a:r>
                  <a:rPr lang="de-DE" sz="4600" dirty="0" smtClean="0"/>
                  <a:t> (~15 </a:t>
                </a:r>
                <a:r>
                  <a:rPr lang="de-DE" sz="4600" dirty="0" err="1" smtClean="0"/>
                  <a:t>Mya</a:t>
                </a:r>
                <a:r>
                  <a:rPr lang="de-DE" sz="4600" dirty="0" smtClean="0"/>
                  <a:t>, ~65 </a:t>
                </a:r>
                <a:r>
                  <a:rPr lang="de-DE" sz="4600" dirty="0" err="1" smtClean="0"/>
                  <a:t>Mya</a:t>
                </a:r>
                <a:r>
                  <a:rPr lang="de-DE" sz="4600" dirty="0" smtClean="0"/>
                  <a:t>)</a:t>
                </a:r>
                <a:endParaRPr lang="en-US" sz="4600" dirty="0"/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28323101" y="11596737"/>
                <a:ext cx="7079362" cy="991109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pPr algn="ctr"/>
                <a:r>
                  <a:rPr lang="de-DE" sz="3700" dirty="0"/>
                  <a:t>Reference </a:t>
                </a:r>
                <a:r>
                  <a:rPr lang="de-DE" sz="3700" dirty="0" smtClean="0"/>
                  <a:t>(</a:t>
                </a:r>
                <a:r>
                  <a:rPr lang="de-DE" sz="3700" i="1" dirty="0" smtClean="0"/>
                  <a:t>P. </a:t>
                </a:r>
                <a:r>
                  <a:rPr lang="de-DE" sz="3700" i="1" dirty="0" err="1" smtClean="0"/>
                  <a:t>fluviatilis</a:t>
                </a:r>
                <a:r>
                  <a:rPr lang="de-DE" sz="3700" i="1" dirty="0" smtClean="0"/>
                  <a:t> </a:t>
                </a:r>
                <a:r>
                  <a:rPr lang="de-DE" sz="3700" dirty="0" smtClean="0"/>
                  <a:t>Hi-C)</a:t>
                </a:r>
                <a:endParaRPr lang="en-US" sz="3700" dirty="0"/>
              </a:p>
            </p:txBody>
          </p:sp>
        </p:grpSp>
        <p:sp>
          <p:nvSpPr>
            <p:cNvPr id="17" name="Rectangle 16"/>
            <p:cNvSpPr/>
            <p:nvPr/>
          </p:nvSpPr>
          <p:spPr>
            <a:xfrm>
              <a:off x="1191853" y="13051755"/>
              <a:ext cx="36448929" cy="341632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7200" b="1" dirty="0"/>
                <a:t>Figure </a:t>
              </a:r>
              <a:r>
                <a:rPr lang="en-GB" sz="7200" b="1" dirty="0" smtClean="0"/>
                <a:t>3: </a:t>
              </a:r>
              <a:r>
                <a:rPr lang="en-GB" sz="7200" dirty="0" smtClean="0"/>
                <a:t>Dot plots of CSA results against reference genome for assembly of </a:t>
              </a:r>
              <a:r>
                <a:rPr lang="en-GB" sz="7200" i="1" dirty="0" err="1" smtClean="0"/>
                <a:t>Perca</a:t>
              </a:r>
              <a:r>
                <a:rPr lang="en-GB" sz="7200" i="1" dirty="0" smtClean="0"/>
                <a:t> </a:t>
              </a:r>
              <a:r>
                <a:rPr lang="en-GB" sz="7200" i="1" dirty="0" err="1" smtClean="0"/>
                <a:t>fluviatilis</a:t>
              </a:r>
              <a:r>
                <a:rPr lang="en-GB" sz="7200" dirty="0" smtClean="0"/>
                <a:t> Oxford Nanopore data sequentially supported by 10X Genomics and two diverged references genomes.</a:t>
              </a:r>
              <a:endParaRPr lang="en-US" sz="7200" dirty="0"/>
            </a:p>
          </p:txBody>
        </p:sp>
      </p:grpSp>
    </p:spTree>
    <p:extLst>
      <p:ext uri="{BB962C8B-B14F-4D97-AF65-F5344CB8AC3E}">
        <p14:creationId xmlns:p14="http://schemas.microsoft.com/office/powerpoint/2010/main" val="18693387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796927" y="2394571"/>
            <a:ext cx="24855807" cy="14751684"/>
            <a:chOff x="796927" y="2394571"/>
            <a:chExt cx="24855807" cy="14751684"/>
          </a:xfrm>
        </p:grpSpPr>
        <p:sp>
          <p:nvSpPr>
            <p:cNvPr id="14" name="Rechteck 149"/>
            <p:cNvSpPr/>
            <p:nvPr/>
          </p:nvSpPr>
          <p:spPr>
            <a:xfrm>
              <a:off x="809974" y="2394571"/>
              <a:ext cx="24842760" cy="12166361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lIns="417643" tIns="208822" rIns="417643" bIns="208822" rtlCol="0" anchor="ctr"/>
            <a:lstStyle/>
            <a:p>
              <a:pPr algn="ctr"/>
              <a:endParaRPr lang="de-DE"/>
            </a:p>
          </p:txBody>
        </p:sp>
        <p:grpSp>
          <p:nvGrpSpPr>
            <p:cNvPr id="5" name="Group 4"/>
            <p:cNvGrpSpPr/>
            <p:nvPr/>
          </p:nvGrpSpPr>
          <p:grpSpPr>
            <a:xfrm>
              <a:off x="809974" y="2757603"/>
              <a:ext cx="11870672" cy="11739233"/>
              <a:chOff x="28387206" y="791194"/>
              <a:chExt cx="11870672" cy="11739233"/>
            </a:xfrm>
          </p:grpSpPr>
          <p:grpSp>
            <p:nvGrpSpPr>
              <p:cNvPr id="6" name="Group 5"/>
              <p:cNvGrpSpPr/>
              <p:nvPr/>
            </p:nvGrpSpPr>
            <p:grpSpPr>
              <a:xfrm>
                <a:off x="28387206" y="791194"/>
                <a:ext cx="11870672" cy="11462846"/>
                <a:chOff x="28387206" y="791194"/>
                <a:chExt cx="11870672" cy="11462846"/>
              </a:xfrm>
            </p:grpSpPr>
            <p:pic>
              <p:nvPicPr>
                <p:cNvPr id="8" name="Picture 13"/>
                <p:cNvPicPr>
                  <a:picLocks noChangeAspect="1" noChangeArrowheads="1"/>
                </p:cNvPicPr>
                <p:nvPr/>
              </p:nvPicPr>
              <p:blipFill rotWithShape="1">
                <a:blip r:embed="rId2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sharpenSoften amount="30000"/>
                          </a14:imgEffect>
                          <a14:imgEffect>
                            <a14:brightnessContrast contras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8397" r="18217"/>
                <a:stretch/>
              </p:blipFill>
              <p:spPr bwMode="auto">
                <a:xfrm>
                  <a:off x="28665878" y="824040"/>
                  <a:ext cx="11592000" cy="11430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  <p:sp>
              <p:nvSpPr>
                <p:cNvPr id="9" name="TextBox 8"/>
                <p:cNvSpPr txBox="1"/>
                <p:nvPr/>
              </p:nvSpPr>
              <p:spPr>
                <a:xfrm>
                  <a:off x="28657115" y="791194"/>
                  <a:ext cx="9265658" cy="1129609"/>
                </a:xfrm>
                <a:prstGeom prst="rect">
                  <a:avLst/>
                </a:prstGeom>
                <a:noFill/>
              </p:spPr>
              <p:txBody>
                <a:bodyPr wrap="square" lIns="417643" tIns="208822" rIns="417643" bIns="208822" rtlCol="0">
                  <a:spAutoFit/>
                </a:bodyPr>
                <a:lstStyle/>
                <a:p>
                  <a:r>
                    <a:rPr lang="de-DE" sz="4600" i="1" dirty="0"/>
                    <a:t>S. </a:t>
                  </a:r>
                  <a:r>
                    <a:rPr lang="de-DE" sz="4600" i="1" dirty="0" err="1"/>
                    <a:t>chuatsi</a:t>
                  </a:r>
                  <a:r>
                    <a:rPr lang="de-DE" sz="4600" dirty="0"/>
                    <a:t>: best-</a:t>
                  </a:r>
                  <a:r>
                    <a:rPr lang="de-DE" sz="4600" dirty="0" err="1"/>
                    <a:t>case</a:t>
                  </a:r>
                  <a:r>
                    <a:rPr lang="de-DE" sz="4600" dirty="0"/>
                    <a:t> </a:t>
                  </a:r>
                  <a:endParaRPr lang="en-US" sz="4600" dirty="0"/>
                </a:p>
              </p:txBody>
            </p:sp>
            <p:sp>
              <p:nvSpPr>
                <p:cNvPr id="10" name="TextBox 9"/>
                <p:cNvSpPr txBox="1"/>
                <p:nvPr/>
              </p:nvSpPr>
              <p:spPr>
                <a:xfrm rot="16200000">
                  <a:off x="25394228" y="6034729"/>
                  <a:ext cx="6994577" cy="1008622"/>
                </a:xfrm>
                <a:prstGeom prst="rect">
                  <a:avLst/>
                </a:prstGeom>
                <a:noFill/>
              </p:spPr>
              <p:txBody>
                <a:bodyPr wrap="square" lIns="417643" tIns="208822" rIns="417643" bIns="208822" rtlCol="0">
                  <a:spAutoFit/>
                </a:bodyPr>
                <a:lstStyle/>
                <a:p>
                  <a:pPr algn="ctr"/>
                  <a:r>
                    <a:rPr lang="de-DE" sz="3700" dirty="0"/>
                    <a:t>CSA (50X SMRT+ sinChu7)</a:t>
                  </a:r>
                  <a:endParaRPr lang="en-US" sz="3700" dirty="0"/>
                </a:p>
              </p:txBody>
            </p:sp>
          </p:grpSp>
          <p:sp>
            <p:nvSpPr>
              <p:cNvPr id="7" name="TextBox 6"/>
              <p:cNvSpPr txBox="1"/>
              <p:nvPr/>
            </p:nvSpPr>
            <p:spPr>
              <a:xfrm>
                <a:off x="31244441" y="11539318"/>
                <a:ext cx="7079362" cy="991109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pPr algn="ctr"/>
                <a:r>
                  <a:rPr lang="de-DE" sz="3700" dirty="0"/>
                  <a:t>Reference (sinChu7)</a:t>
                </a:r>
                <a:endParaRPr lang="en-US" sz="3700" dirty="0"/>
              </a:p>
            </p:txBody>
          </p:sp>
        </p:grpSp>
        <p:grpSp>
          <p:nvGrpSpPr>
            <p:cNvPr id="4" name="Group 3"/>
            <p:cNvGrpSpPr/>
            <p:nvPr/>
          </p:nvGrpSpPr>
          <p:grpSpPr>
            <a:xfrm>
              <a:off x="13315676" y="2757602"/>
              <a:ext cx="11878700" cy="11739234"/>
              <a:chOff x="15608946" y="2757602"/>
              <a:chExt cx="11878700" cy="11739234"/>
            </a:xfrm>
          </p:grpSpPr>
          <p:pic>
            <p:nvPicPr>
              <p:cNvPr id="2050" name="Picture 2"/>
              <p:cNvPicPr>
                <a:picLocks noChangeAspect="1" noChangeArrowheads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harpenSoften amount="30000"/>
                        </a14:imgEffect>
                        <a14:imgEffect>
                          <a14:brightnessContrast contras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197" r="18222"/>
              <a:stretch/>
            </p:blipFill>
            <p:spPr bwMode="auto">
              <a:xfrm>
                <a:off x="15859646" y="2757602"/>
                <a:ext cx="11628000" cy="1143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sp>
            <p:nvSpPr>
              <p:cNvPr id="11" name="TextBox 10"/>
              <p:cNvSpPr txBox="1"/>
              <p:nvPr/>
            </p:nvSpPr>
            <p:spPr>
              <a:xfrm>
                <a:off x="15840694" y="2790449"/>
                <a:ext cx="11396216" cy="1129609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r>
                  <a:rPr lang="de-DE" sz="4600" i="1" dirty="0"/>
                  <a:t>S. </a:t>
                </a:r>
                <a:r>
                  <a:rPr lang="de-DE" sz="4600" i="1" dirty="0" err="1"/>
                  <a:t>chuatsi</a:t>
                </a:r>
                <a:r>
                  <a:rPr lang="de-DE" sz="4600" dirty="0"/>
                  <a:t>: </a:t>
                </a:r>
                <a:r>
                  <a:rPr lang="de-DE" sz="4600" dirty="0" err="1" smtClean="0"/>
                  <a:t>draft</a:t>
                </a:r>
                <a:r>
                  <a:rPr lang="de-DE" sz="4600" dirty="0" smtClean="0"/>
                  <a:t> </a:t>
                </a:r>
                <a:r>
                  <a:rPr lang="de-DE" sz="4600" dirty="0" err="1" smtClean="0"/>
                  <a:t>ctg</a:t>
                </a:r>
                <a:r>
                  <a:rPr lang="de-DE" sz="4600" dirty="0" smtClean="0"/>
                  <a:t>. </a:t>
                </a:r>
                <a:r>
                  <a:rPr lang="de-DE" sz="4600" dirty="0" err="1" smtClean="0"/>
                  <a:t>reference</a:t>
                </a:r>
                <a:r>
                  <a:rPr lang="de-DE" sz="4600" dirty="0" smtClean="0"/>
                  <a:t> (~65 </a:t>
                </a:r>
                <a:r>
                  <a:rPr lang="de-DE" sz="4600" dirty="0" err="1" smtClean="0"/>
                  <a:t>Mya</a:t>
                </a:r>
                <a:r>
                  <a:rPr lang="de-DE" sz="4600" dirty="0" smtClean="0"/>
                  <a:t>) </a:t>
                </a:r>
                <a:endParaRPr lang="en-US" sz="4600" dirty="0"/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 rot="16200000">
                <a:off x="10482662" y="7883887"/>
                <a:ext cx="11243678" cy="991109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pPr algn="ctr"/>
                <a:r>
                  <a:rPr lang="de-DE" sz="3700" dirty="0"/>
                  <a:t>CSA (50X SMRT+ </a:t>
                </a:r>
                <a:r>
                  <a:rPr lang="de-DE" sz="3700" i="1" dirty="0" err="1" smtClean="0"/>
                  <a:t>P.fluviatilis</a:t>
                </a:r>
                <a:r>
                  <a:rPr lang="de-DE" sz="3700" dirty="0" smtClean="0"/>
                  <a:t> </a:t>
                </a:r>
                <a:r>
                  <a:rPr lang="de-DE" sz="3700" dirty="0" err="1" smtClean="0"/>
                  <a:t>ctg</a:t>
                </a:r>
                <a:r>
                  <a:rPr lang="de-DE" sz="3700" dirty="0" smtClean="0"/>
                  <a:t>. N50: 2.8 </a:t>
                </a:r>
                <a:r>
                  <a:rPr lang="de-DE" sz="3700" dirty="0" err="1" smtClean="0"/>
                  <a:t>Mbp</a:t>
                </a:r>
                <a:r>
                  <a:rPr lang="de-DE" sz="3700" dirty="0" smtClean="0"/>
                  <a:t>)</a:t>
                </a:r>
                <a:endParaRPr lang="en-US" sz="3700" dirty="0"/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18133965" y="13505727"/>
                <a:ext cx="7079362" cy="991109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pPr algn="ctr"/>
                <a:r>
                  <a:rPr lang="de-DE" sz="3700" dirty="0"/>
                  <a:t>Reference (sinChu7)</a:t>
                </a:r>
                <a:endParaRPr lang="en-US" sz="3700" dirty="0"/>
              </a:p>
            </p:txBody>
          </p:sp>
        </p:grpSp>
        <p:sp>
          <p:nvSpPr>
            <p:cNvPr id="15" name="Rectangle 14"/>
            <p:cNvSpPr/>
            <p:nvPr/>
          </p:nvSpPr>
          <p:spPr>
            <a:xfrm>
              <a:off x="796927" y="14560932"/>
              <a:ext cx="24855807" cy="258532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5400" b="1" dirty="0"/>
                <a:t>Figure 4</a:t>
              </a:r>
              <a:r>
                <a:rPr lang="en-GB" sz="5400" b="1" dirty="0" smtClean="0"/>
                <a:t>: </a:t>
              </a:r>
              <a:r>
                <a:rPr lang="en-GB" sz="5400" dirty="0" smtClean="0"/>
                <a:t>Dot plots of CSA results against reference genome for assembly of </a:t>
              </a:r>
              <a:r>
                <a:rPr lang="en-GB" sz="5400" i="1" dirty="0" err="1" smtClean="0"/>
                <a:t>Siniperca</a:t>
              </a:r>
              <a:r>
                <a:rPr lang="en-GB" sz="5400" i="1" dirty="0" smtClean="0"/>
                <a:t> </a:t>
              </a:r>
              <a:r>
                <a:rPr lang="en-GB" sz="5400" i="1" dirty="0" err="1" smtClean="0"/>
                <a:t>chuatsi</a:t>
              </a:r>
              <a:r>
                <a:rPr lang="en-GB" sz="5400" i="1" dirty="0" smtClean="0"/>
                <a:t> </a:t>
              </a:r>
              <a:r>
                <a:rPr lang="en-GB" sz="5400" dirty="0" smtClean="0"/>
                <a:t>supported by </a:t>
              </a:r>
              <a:r>
                <a:rPr lang="en-GB" sz="5400" dirty="0" err="1" smtClean="0"/>
                <a:t>contigs</a:t>
              </a:r>
              <a:r>
                <a:rPr lang="en-GB" sz="5400" dirty="0" smtClean="0"/>
                <a:t> of a diverged draft genome assembly in comparison to the best case CSA assembly.</a:t>
              </a:r>
              <a:endParaRPr lang="en-US" sz="5400" dirty="0"/>
            </a:p>
          </p:txBody>
        </p:sp>
      </p:grpSp>
    </p:spTree>
    <p:extLst>
      <p:ext uri="{BB962C8B-B14F-4D97-AF65-F5344CB8AC3E}">
        <p14:creationId xmlns:p14="http://schemas.microsoft.com/office/powerpoint/2010/main" val="284935606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619474" y="568846"/>
            <a:ext cx="39676408" cy="27392633"/>
            <a:chOff x="619474" y="568846"/>
            <a:chExt cx="39676408" cy="27392633"/>
          </a:xfrm>
        </p:grpSpPr>
        <p:sp>
          <p:nvSpPr>
            <p:cNvPr id="34" name="Rechteck 149"/>
            <p:cNvSpPr/>
            <p:nvPr/>
          </p:nvSpPr>
          <p:spPr>
            <a:xfrm>
              <a:off x="619474" y="568846"/>
              <a:ext cx="39676408" cy="24655311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lIns="417643" tIns="208822" rIns="417643" bIns="208822" rtlCol="0" anchor="ctr"/>
            <a:lstStyle/>
            <a:p>
              <a:pPr algn="ctr"/>
              <a:endParaRPr lang="de-DE"/>
            </a:p>
          </p:txBody>
        </p:sp>
        <p:grpSp>
          <p:nvGrpSpPr>
            <p:cNvPr id="14" name="Group 13"/>
            <p:cNvGrpSpPr/>
            <p:nvPr/>
          </p:nvGrpSpPr>
          <p:grpSpPr>
            <a:xfrm>
              <a:off x="682961" y="1020271"/>
              <a:ext cx="39299365" cy="24013387"/>
              <a:chOff x="682961" y="1020271"/>
              <a:chExt cx="39299365" cy="24013387"/>
            </a:xfrm>
          </p:grpSpPr>
          <p:grpSp>
            <p:nvGrpSpPr>
              <p:cNvPr id="7" name="Group 6"/>
              <p:cNvGrpSpPr/>
              <p:nvPr/>
            </p:nvGrpSpPr>
            <p:grpSpPr>
              <a:xfrm>
                <a:off x="700961" y="1026419"/>
                <a:ext cx="12763029" cy="11725529"/>
                <a:chOff x="682961" y="1026419"/>
                <a:chExt cx="12763029" cy="11725529"/>
              </a:xfrm>
            </p:grpSpPr>
            <p:pic>
              <p:nvPicPr>
                <p:cNvPr id="1026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2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sharpenSoften amount="30000"/>
                          </a14:imgEffect>
                          <a14:imgEffect>
                            <a14:brightnessContrast contras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5845" r="15846"/>
                <a:stretch/>
              </p:blipFill>
              <p:spPr bwMode="auto">
                <a:xfrm>
                  <a:off x="953990" y="1026419"/>
                  <a:ext cx="12492000" cy="11430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  <p:sp>
              <p:nvSpPr>
                <p:cNvPr id="20" name="TextBox 19"/>
                <p:cNvSpPr txBox="1"/>
                <p:nvPr/>
              </p:nvSpPr>
              <p:spPr>
                <a:xfrm>
                  <a:off x="953990" y="1026419"/>
                  <a:ext cx="8496944" cy="1837495"/>
                </a:xfrm>
                <a:prstGeom prst="rect">
                  <a:avLst/>
                </a:prstGeom>
                <a:noFill/>
              </p:spPr>
              <p:txBody>
                <a:bodyPr wrap="square" lIns="417643" tIns="208822" rIns="417643" bIns="208822" rtlCol="0">
                  <a:spAutoFit/>
                </a:bodyPr>
                <a:lstStyle/>
                <a:p>
                  <a:r>
                    <a:rPr lang="de-DE" sz="4600" i="1" dirty="0"/>
                    <a:t>H. sapiens</a:t>
                  </a:r>
                  <a:r>
                    <a:rPr lang="de-DE" sz="4600" dirty="0"/>
                    <a:t>: </a:t>
                  </a:r>
                  <a:r>
                    <a:rPr lang="de-DE" sz="4600" dirty="0" err="1" smtClean="0"/>
                    <a:t>low</a:t>
                  </a:r>
                  <a:r>
                    <a:rPr lang="de-DE" sz="4600" dirty="0" smtClean="0"/>
                    <a:t> </a:t>
                  </a:r>
                  <a:r>
                    <a:rPr lang="de-DE" sz="4600" dirty="0" err="1" smtClean="0"/>
                    <a:t>coverage</a:t>
                  </a:r>
                  <a:r>
                    <a:rPr lang="de-DE" sz="4600" dirty="0" smtClean="0"/>
                    <a:t> (30X) +</a:t>
                  </a:r>
                </a:p>
                <a:p>
                  <a:r>
                    <a:rPr lang="de-DE" sz="4600" dirty="0" err="1"/>
                    <a:t>b</a:t>
                  </a:r>
                  <a:r>
                    <a:rPr lang="de-DE" sz="4600" dirty="0" err="1" smtClean="0"/>
                    <a:t>est</a:t>
                  </a:r>
                  <a:r>
                    <a:rPr lang="de-DE" sz="4600" dirty="0" smtClean="0"/>
                    <a:t> </a:t>
                  </a:r>
                  <a:r>
                    <a:rPr lang="de-DE" sz="4600" dirty="0" err="1" smtClean="0"/>
                    <a:t>reference</a:t>
                  </a:r>
                  <a:endParaRPr lang="en-US" sz="4600" dirty="0"/>
                </a:p>
              </p:txBody>
            </p:sp>
            <p:sp>
              <p:nvSpPr>
                <p:cNvPr id="24" name="TextBox 23"/>
                <p:cNvSpPr txBox="1"/>
                <p:nvPr/>
              </p:nvSpPr>
              <p:spPr>
                <a:xfrm>
                  <a:off x="3660309" y="11760839"/>
                  <a:ext cx="7079362" cy="991109"/>
                </a:xfrm>
                <a:prstGeom prst="rect">
                  <a:avLst/>
                </a:prstGeom>
                <a:noFill/>
              </p:spPr>
              <p:txBody>
                <a:bodyPr wrap="square" lIns="417643" tIns="208822" rIns="417643" bIns="208822" rtlCol="0">
                  <a:spAutoFit/>
                </a:bodyPr>
                <a:lstStyle/>
                <a:p>
                  <a:pPr algn="ctr"/>
                  <a:r>
                    <a:rPr lang="de-DE" sz="3700" dirty="0"/>
                    <a:t>Reference (GRCh38)</a:t>
                  </a:r>
                  <a:endParaRPr lang="en-US" sz="3700" dirty="0"/>
                </a:p>
              </p:txBody>
            </p:sp>
            <p:sp>
              <p:nvSpPr>
                <p:cNvPr id="27" name="TextBox 26"/>
                <p:cNvSpPr txBox="1"/>
                <p:nvPr/>
              </p:nvSpPr>
              <p:spPr>
                <a:xfrm rot="16200000">
                  <a:off x="-1656879" y="6245865"/>
                  <a:ext cx="5670789" cy="991109"/>
                </a:xfrm>
                <a:prstGeom prst="rect">
                  <a:avLst/>
                </a:prstGeom>
                <a:noFill/>
              </p:spPr>
              <p:txBody>
                <a:bodyPr wrap="square" lIns="417643" tIns="208822" rIns="417643" bIns="208822" rtlCol="0">
                  <a:spAutoFit/>
                </a:bodyPr>
                <a:lstStyle/>
                <a:p>
                  <a:pPr algn="ctr"/>
                  <a:r>
                    <a:rPr lang="de-DE" sz="3700" dirty="0"/>
                    <a:t>CSA </a:t>
                  </a:r>
                  <a:r>
                    <a:rPr lang="de-DE" sz="3700" dirty="0" smtClean="0"/>
                    <a:t>(30X </a:t>
                  </a:r>
                  <a:r>
                    <a:rPr lang="de-DE" sz="3700" dirty="0"/>
                    <a:t>SMRT+GRCh38)</a:t>
                  </a:r>
                  <a:endParaRPr lang="en-US" sz="3700" dirty="0"/>
                </a:p>
              </p:txBody>
            </p:sp>
          </p:grpSp>
          <p:grpSp>
            <p:nvGrpSpPr>
              <p:cNvPr id="9" name="Group 8"/>
              <p:cNvGrpSpPr/>
              <p:nvPr/>
            </p:nvGrpSpPr>
            <p:grpSpPr>
              <a:xfrm>
                <a:off x="14092396" y="1020272"/>
                <a:ext cx="12691029" cy="11743451"/>
                <a:chOff x="13500385" y="1020272"/>
                <a:chExt cx="12691029" cy="11743451"/>
              </a:xfrm>
            </p:grpSpPr>
            <p:pic>
              <p:nvPicPr>
                <p:cNvPr id="1027" name="Picture 3"/>
                <p:cNvPicPr>
                  <a:picLocks noChangeAspect="1" noChangeArrowheads="1"/>
                </p:cNvPicPr>
                <p:nvPr/>
              </p:nvPicPr>
              <p:blipFill rotWithShape="1">
                <a:blip r:embed="rId4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sharpenSoften amount="30000"/>
                          </a14:imgEffect>
                          <a14:imgEffect>
                            <a14:brightnessContrast contras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6029" r="16048"/>
                <a:stretch/>
              </p:blipFill>
              <p:spPr bwMode="auto">
                <a:xfrm>
                  <a:off x="13771414" y="1026419"/>
                  <a:ext cx="12420000" cy="11430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  <p:sp>
              <p:nvSpPr>
                <p:cNvPr id="21" name="TextBox 20"/>
                <p:cNvSpPr txBox="1"/>
                <p:nvPr/>
              </p:nvSpPr>
              <p:spPr>
                <a:xfrm>
                  <a:off x="13771414" y="1020272"/>
                  <a:ext cx="8568952" cy="2545381"/>
                </a:xfrm>
                <a:prstGeom prst="rect">
                  <a:avLst/>
                </a:prstGeom>
                <a:noFill/>
              </p:spPr>
              <p:txBody>
                <a:bodyPr wrap="square" lIns="417643" tIns="208822" rIns="417643" bIns="208822" rtlCol="0">
                  <a:spAutoFit/>
                </a:bodyPr>
                <a:lstStyle/>
                <a:p>
                  <a:r>
                    <a:rPr lang="de-DE" sz="4600" i="1" dirty="0"/>
                    <a:t>H. sapiens</a:t>
                  </a:r>
                  <a:r>
                    <a:rPr lang="de-DE" sz="4600" dirty="0"/>
                    <a:t>: </a:t>
                  </a:r>
                  <a:r>
                    <a:rPr lang="de-DE" sz="4600" dirty="0" err="1" smtClean="0"/>
                    <a:t>low</a:t>
                  </a:r>
                  <a:r>
                    <a:rPr lang="de-DE" sz="4600" dirty="0" smtClean="0"/>
                    <a:t> </a:t>
                  </a:r>
                  <a:r>
                    <a:rPr lang="de-DE" sz="4600" dirty="0" err="1" smtClean="0"/>
                    <a:t>coverage</a:t>
                  </a:r>
                  <a:r>
                    <a:rPr lang="de-DE" sz="4600" dirty="0" smtClean="0"/>
                    <a:t> (</a:t>
                  </a:r>
                  <a:r>
                    <a:rPr lang="de-DE" sz="4600" dirty="0"/>
                    <a:t>20X) +</a:t>
                  </a:r>
                </a:p>
                <a:p>
                  <a:r>
                    <a:rPr lang="de-DE" sz="4600" dirty="0" err="1"/>
                    <a:t>best</a:t>
                  </a:r>
                  <a:r>
                    <a:rPr lang="de-DE" sz="4600" dirty="0"/>
                    <a:t> </a:t>
                  </a:r>
                  <a:r>
                    <a:rPr lang="de-DE" sz="4600" dirty="0" err="1"/>
                    <a:t>reference</a:t>
                  </a:r>
                  <a:endParaRPr lang="en-US" sz="4600" dirty="0"/>
                </a:p>
                <a:p>
                  <a:endParaRPr lang="en-US" sz="4600" dirty="0"/>
                </a:p>
              </p:txBody>
            </p:sp>
            <p:sp>
              <p:nvSpPr>
                <p:cNvPr id="25" name="TextBox 24"/>
                <p:cNvSpPr txBox="1"/>
                <p:nvPr/>
              </p:nvSpPr>
              <p:spPr>
                <a:xfrm>
                  <a:off x="16441733" y="11772614"/>
                  <a:ext cx="7079362" cy="991109"/>
                </a:xfrm>
                <a:prstGeom prst="rect">
                  <a:avLst/>
                </a:prstGeom>
                <a:noFill/>
              </p:spPr>
              <p:txBody>
                <a:bodyPr wrap="square" lIns="417643" tIns="208822" rIns="417643" bIns="208822" rtlCol="0">
                  <a:spAutoFit/>
                </a:bodyPr>
                <a:lstStyle/>
                <a:p>
                  <a:pPr algn="ctr"/>
                  <a:r>
                    <a:rPr lang="de-DE" sz="3700" dirty="0"/>
                    <a:t>Reference (GRCh38)</a:t>
                  </a:r>
                  <a:endParaRPr lang="en-US" sz="3700" dirty="0"/>
                </a:p>
              </p:txBody>
            </p:sp>
            <p:sp>
              <p:nvSpPr>
                <p:cNvPr id="28" name="TextBox 27"/>
                <p:cNvSpPr txBox="1"/>
                <p:nvPr/>
              </p:nvSpPr>
              <p:spPr>
                <a:xfrm rot="16200000">
                  <a:off x="11160545" y="6246580"/>
                  <a:ext cx="5670789" cy="991109"/>
                </a:xfrm>
                <a:prstGeom prst="rect">
                  <a:avLst/>
                </a:prstGeom>
                <a:noFill/>
              </p:spPr>
              <p:txBody>
                <a:bodyPr wrap="square" lIns="417643" tIns="208822" rIns="417643" bIns="208822" rtlCol="0">
                  <a:spAutoFit/>
                </a:bodyPr>
                <a:lstStyle/>
                <a:p>
                  <a:pPr algn="ctr"/>
                  <a:r>
                    <a:rPr lang="de-DE" sz="3700" dirty="0"/>
                    <a:t>CSA </a:t>
                  </a:r>
                  <a:r>
                    <a:rPr lang="de-DE" sz="3700" dirty="0" smtClean="0"/>
                    <a:t>(20X </a:t>
                  </a:r>
                  <a:r>
                    <a:rPr lang="de-DE" sz="3700" dirty="0"/>
                    <a:t>SMRT+GRCh38)</a:t>
                  </a:r>
                  <a:endParaRPr lang="en-US" sz="3700" dirty="0"/>
                </a:p>
              </p:txBody>
            </p:sp>
          </p:grpSp>
          <p:grpSp>
            <p:nvGrpSpPr>
              <p:cNvPr id="8" name="Group 7"/>
              <p:cNvGrpSpPr/>
              <p:nvPr/>
            </p:nvGrpSpPr>
            <p:grpSpPr>
              <a:xfrm>
                <a:off x="27348334" y="1020271"/>
                <a:ext cx="12619029" cy="11741307"/>
                <a:chOff x="26245801" y="1020271"/>
                <a:chExt cx="12619029" cy="11741307"/>
              </a:xfrm>
            </p:grpSpPr>
            <p:pic>
              <p:nvPicPr>
                <p:cNvPr id="1028" name="Picture 4"/>
                <p:cNvPicPr>
                  <a:picLocks noChangeAspect="1" noChangeArrowheads="1"/>
                </p:cNvPicPr>
                <p:nvPr/>
              </p:nvPicPr>
              <p:blipFill rotWithShape="1">
                <a:blip r:embed="rId6">
                  <a:extLst>
                    <a:ext uri="{BEBA8EAE-BF5A-486C-A8C5-ECC9F3942E4B}">
                      <a14:imgProps xmlns:a14="http://schemas.microsoft.com/office/drawing/2010/main">
                        <a14:imgLayer r:embed="rId7">
                          <a14:imgEffect>
                            <a14:sharpenSoften amount="30000"/>
                          </a14:imgEffect>
                          <a14:imgEffect>
                            <a14:brightnessContrast contras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6211" r="16254"/>
                <a:stretch/>
              </p:blipFill>
              <p:spPr bwMode="auto">
                <a:xfrm>
                  <a:off x="26516830" y="1026419"/>
                  <a:ext cx="12348000" cy="11430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  <p:sp>
              <p:nvSpPr>
                <p:cNvPr id="23" name="TextBox 22"/>
                <p:cNvSpPr txBox="1"/>
                <p:nvPr/>
              </p:nvSpPr>
              <p:spPr>
                <a:xfrm>
                  <a:off x="26516830" y="1020271"/>
                  <a:ext cx="8689222" cy="2545381"/>
                </a:xfrm>
                <a:prstGeom prst="rect">
                  <a:avLst/>
                </a:prstGeom>
                <a:noFill/>
              </p:spPr>
              <p:txBody>
                <a:bodyPr wrap="square" lIns="417643" tIns="208822" rIns="417643" bIns="208822" rtlCol="0">
                  <a:spAutoFit/>
                </a:bodyPr>
                <a:lstStyle/>
                <a:p>
                  <a:r>
                    <a:rPr lang="de-DE" sz="4600" i="1" dirty="0"/>
                    <a:t>H. sapiens</a:t>
                  </a:r>
                  <a:r>
                    <a:rPr lang="de-DE" sz="4600" dirty="0"/>
                    <a:t>: </a:t>
                  </a:r>
                  <a:r>
                    <a:rPr lang="de-DE" sz="4600" dirty="0" err="1" smtClean="0"/>
                    <a:t>low</a:t>
                  </a:r>
                  <a:r>
                    <a:rPr lang="de-DE" sz="4600" dirty="0" smtClean="0"/>
                    <a:t> </a:t>
                  </a:r>
                  <a:r>
                    <a:rPr lang="de-DE" sz="4600" dirty="0" err="1" smtClean="0"/>
                    <a:t>coverage</a:t>
                  </a:r>
                  <a:r>
                    <a:rPr lang="de-DE" sz="4600" dirty="0" smtClean="0"/>
                    <a:t> (</a:t>
                  </a:r>
                  <a:r>
                    <a:rPr lang="de-DE" sz="4600" dirty="0"/>
                    <a:t>15X) +</a:t>
                  </a:r>
                </a:p>
                <a:p>
                  <a:r>
                    <a:rPr lang="de-DE" sz="4600" dirty="0" err="1"/>
                    <a:t>best</a:t>
                  </a:r>
                  <a:r>
                    <a:rPr lang="de-DE" sz="4600" dirty="0"/>
                    <a:t> </a:t>
                  </a:r>
                  <a:r>
                    <a:rPr lang="de-DE" sz="4600" dirty="0" err="1"/>
                    <a:t>reference</a:t>
                  </a:r>
                  <a:endParaRPr lang="en-US" sz="4600" dirty="0"/>
                </a:p>
                <a:p>
                  <a:endParaRPr lang="en-US" sz="4600" dirty="0"/>
                </a:p>
              </p:txBody>
            </p:sp>
            <p:sp>
              <p:nvSpPr>
                <p:cNvPr id="26" name="TextBox 25"/>
                <p:cNvSpPr txBox="1"/>
                <p:nvPr/>
              </p:nvSpPr>
              <p:spPr>
                <a:xfrm>
                  <a:off x="29151149" y="11770469"/>
                  <a:ext cx="7079362" cy="991109"/>
                </a:xfrm>
                <a:prstGeom prst="rect">
                  <a:avLst/>
                </a:prstGeom>
                <a:noFill/>
              </p:spPr>
              <p:txBody>
                <a:bodyPr wrap="square" lIns="417643" tIns="208822" rIns="417643" bIns="208822" rtlCol="0">
                  <a:spAutoFit/>
                </a:bodyPr>
                <a:lstStyle/>
                <a:p>
                  <a:pPr algn="ctr"/>
                  <a:r>
                    <a:rPr lang="de-DE" sz="3700" dirty="0"/>
                    <a:t>Reference (GRCh38)</a:t>
                  </a:r>
                  <a:endParaRPr lang="en-US" sz="3700" dirty="0"/>
                </a:p>
              </p:txBody>
            </p:sp>
            <p:sp>
              <p:nvSpPr>
                <p:cNvPr id="32" name="TextBox 31"/>
                <p:cNvSpPr txBox="1"/>
                <p:nvPr/>
              </p:nvSpPr>
              <p:spPr>
                <a:xfrm rot="16200000">
                  <a:off x="23905961" y="6245864"/>
                  <a:ext cx="5670789" cy="991109"/>
                </a:xfrm>
                <a:prstGeom prst="rect">
                  <a:avLst/>
                </a:prstGeom>
                <a:noFill/>
              </p:spPr>
              <p:txBody>
                <a:bodyPr wrap="square" lIns="417643" tIns="208822" rIns="417643" bIns="208822" rtlCol="0">
                  <a:spAutoFit/>
                </a:bodyPr>
                <a:lstStyle/>
                <a:p>
                  <a:pPr algn="ctr"/>
                  <a:r>
                    <a:rPr lang="de-DE" sz="3700" dirty="0"/>
                    <a:t>CSA </a:t>
                  </a:r>
                  <a:r>
                    <a:rPr lang="de-DE" sz="3700" dirty="0" smtClean="0"/>
                    <a:t>(15X </a:t>
                  </a:r>
                  <a:r>
                    <a:rPr lang="de-DE" sz="3700" dirty="0"/>
                    <a:t>SMRT+GRCh38)</a:t>
                  </a:r>
                  <a:endParaRPr lang="en-US" sz="3700" dirty="0"/>
                </a:p>
              </p:txBody>
            </p:sp>
          </p:grpSp>
          <p:grpSp>
            <p:nvGrpSpPr>
              <p:cNvPr id="10" name="Group 9"/>
              <p:cNvGrpSpPr/>
              <p:nvPr/>
            </p:nvGrpSpPr>
            <p:grpSpPr>
              <a:xfrm>
                <a:off x="682961" y="13339787"/>
                <a:ext cx="12799029" cy="11693871"/>
                <a:chOff x="682961" y="13339787"/>
                <a:chExt cx="12799029" cy="11693871"/>
              </a:xfrm>
            </p:grpSpPr>
            <p:pic>
              <p:nvPicPr>
                <p:cNvPr id="1029" name="Picture 5"/>
                <p:cNvPicPr>
                  <a:picLocks noChangeAspect="1" noChangeArrowheads="1"/>
                </p:cNvPicPr>
                <p:nvPr/>
              </p:nvPicPr>
              <p:blipFill rotWithShape="1">
                <a:blip r:embed="rId8">
                  <a:extLst>
                    <a:ext uri="{BEBA8EAE-BF5A-486C-A8C5-ECC9F3942E4B}">
                      <a14:imgProps xmlns:a14="http://schemas.microsoft.com/office/drawing/2010/main">
                        <a14:imgLayer r:embed="rId9">
                          <a14:imgEffect>
                            <a14:sharpenSoften amount="30000"/>
                          </a14:imgEffect>
                          <a14:imgEffect>
                            <a14:brightnessContrast contras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5644" r="15655"/>
                <a:stretch/>
              </p:blipFill>
              <p:spPr bwMode="auto">
                <a:xfrm>
                  <a:off x="917990" y="13339787"/>
                  <a:ext cx="12564000" cy="11430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  <p:sp>
              <p:nvSpPr>
                <p:cNvPr id="36" name="TextBox 35"/>
                <p:cNvSpPr txBox="1"/>
                <p:nvPr/>
              </p:nvSpPr>
              <p:spPr>
                <a:xfrm>
                  <a:off x="3660309" y="24042549"/>
                  <a:ext cx="7079362" cy="991109"/>
                </a:xfrm>
                <a:prstGeom prst="rect">
                  <a:avLst/>
                </a:prstGeom>
                <a:noFill/>
              </p:spPr>
              <p:txBody>
                <a:bodyPr wrap="square" lIns="417643" tIns="208822" rIns="417643" bIns="208822" rtlCol="0">
                  <a:spAutoFit/>
                </a:bodyPr>
                <a:lstStyle/>
                <a:p>
                  <a:pPr algn="ctr"/>
                  <a:r>
                    <a:rPr lang="de-DE" sz="3700" dirty="0"/>
                    <a:t>Reference (GRCh38)</a:t>
                  </a:r>
                  <a:endParaRPr lang="en-US" sz="3700" dirty="0"/>
                </a:p>
              </p:txBody>
            </p:sp>
            <p:sp>
              <p:nvSpPr>
                <p:cNvPr id="37" name="TextBox 36"/>
                <p:cNvSpPr txBox="1"/>
                <p:nvPr/>
              </p:nvSpPr>
              <p:spPr>
                <a:xfrm>
                  <a:off x="917990" y="13339787"/>
                  <a:ext cx="8496944" cy="1837495"/>
                </a:xfrm>
                <a:prstGeom prst="rect">
                  <a:avLst/>
                </a:prstGeom>
                <a:noFill/>
              </p:spPr>
              <p:txBody>
                <a:bodyPr wrap="square" lIns="417643" tIns="208822" rIns="417643" bIns="208822" rtlCol="0">
                  <a:spAutoFit/>
                </a:bodyPr>
                <a:lstStyle/>
                <a:p>
                  <a:r>
                    <a:rPr lang="de-DE" sz="4600" i="1" dirty="0"/>
                    <a:t>H. sapiens</a:t>
                  </a:r>
                  <a:r>
                    <a:rPr lang="de-DE" sz="4600" dirty="0"/>
                    <a:t>: </a:t>
                  </a:r>
                  <a:r>
                    <a:rPr lang="de-DE" sz="4600" dirty="0" err="1" smtClean="0"/>
                    <a:t>low</a:t>
                  </a:r>
                  <a:r>
                    <a:rPr lang="de-DE" sz="4600" dirty="0" smtClean="0"/>
                    <a:t> </a:t>
                  </a:r>
                  <a:r>
                    <a:rPr lang="de-DE" sz="4600" dirty="0" err="1" smtClean="0"/>
                    <a:t>coverage</a:t>
                  </a:r>
                  <a:r>
                    <a:rPr lang="de-DE" sz="4600" dirty="0" smtClean="0"/>
                    <a:t> (30X) + </a:t>
                  </a:r>
                  <a:r>
                    <a:rPr lang="de-DE" sz="4600" dirty="0" err="1" smtClean="0"/>
                    <a:t>diverged</a:t>
                  </a:r>
                  <a:r>
                    <a:rPr lang="de-DE" sz="4600" dirty="0" smtClean="0"/>
                    <a:t> </a:t>
                  </a:r>
                  <a:r>
                    <a:rPr lang="de-DE" sz="4600" dirty="0" err="1"/>
                    <a:t>r</a:t>
                  </a:r>
                  <a:r>
                    <a:rPr lang="de-DE" sz="4600" dirty="0" err="1" smtClean="0"/>
                    <a:t>eference</a:t>
                  </a:r>
                  <a:r>
                    <a:rPr lang="de-DE" sz="4600" dirty="0" smtClean="0"/>
                    <a:t> (~15MYA)</a:t>
                  </a:r>
                  <a:endParaRPr lang="en-US" sz="4600" dirty="0"/>
                </a:p>
              </p:txBody>
            </p:sp>
            <p:sp>
              <p:nvSpPr>
                <p:cNvPr id="38" name="TextBox 37"/>
                <p:cNvSpPr txBox="1"/>
                <p:nvPr/>
              </p:nvSpPr>
              <p:spPr>
                <a:xfrm rot="16200000">
                  <a:off x="-1656879" y="18559232"/>
                  <a:ext cx="5670789" cy="991109"/>
                </a:xfrm>
                <a:prstGeom prst="rect">
                  <a:avLst/>
                </a:prstGeom>
                <a:noFill/>
              </p:spPr>
              <p:txBody>
                <a:bodyPr wrap="square" lIns="417643" tIns="208822" rIns="417643" bIns="208822" rtlCol="0">
                  <a:spAutoFit/>
                </a:bodyPr>
                <a:lstStyle/>
                <a:p>
                  <a:pPr algn="ctr"/>
                  <a:r>
                    <a:rPr lang="de-DE" sz="3700" dirty="0"/>
                    <a:t>CSA </a:t>
                  </a:r>
                  <a:r>
                    <a:rPr lang="de-DE" sz="3700" dirty="0" smtClean="0"/>
                    <a:t>(30X SMRT + </a:t>
                  </a:r>
                  <a:r>
                    <a:rPr lang="de-DE" sz="3700" i="1" dirty="0" err="1" smtClean="0"/>
                    <a:t>P.abelii</a:t>
                  </a:r>
                  <a:r>
                    <a:rPr lang="de-DE" sz="3700" dirty="0" smtClean="0"/>
                    <a:t>)</a:t>
                  </a:r>
                  <a:endParaRPr lang="en-US" sz="3700" dirty="0"/>
                </a:p>
              </p:txBody>
            </p:sp>
          </p:grpSp>
          <p:grpSp>
            <p:nvGrpSpPr>
              <p:cNvPr id="12" name="Group 11"/>
              <p:cNvGrpSpPr/>
              <p:nvPr/>
            </p:nvGrpSpPr>
            <p:grpSpPr>
              <a:xfrm>
                <a:off x="14062182" y="13339786"/>
                <a:ext cx="12751457" cy="11693872"/>
                <a:chOff x="13511957" y="13339786"/>
                <a:chExt cx="12751457" cy="11693872"/>
              </a:xfrm>
            </p:grpSpPr>
            <p:pic>
              <p:nvPicPr>
                <p:cNvPr id="1030" name="Picture 6"/>
                <p:cNvPicPr>
                  <a:picLocks noChangeAspect="1" noChangeArrowheads="1"/>
                </p:cNvPicPr>
                <p:nvPr/>
              </p:nvPicPr>
              <p:blipFill rotWithShape="1">
                <a:blip r:embed="rId10">
                  <a:extLst>
                    <a:ext uri="{BEBA8EAE-BF5A-486C-A8C5-ECC9F3942E4B}">
                      <a14:imgProps xmlns:a14="http://schemas.microsoft.com/office/drawing/2010/main">
                        <a14:imgLayer r:embed="rId11">
                          <a14:imgEffect>
                            <a14:sharpenSoften amount="30000"/>
                          </a14:imgEffect>
                          <a14:imgEffect>
                            <a14:brightnessContrast contras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5845" r="15847"/>
                <a:stretch/>
              </p:blipFill>
              <p:spPr bwMode="auto">
                <a:xfrm>
                  <a:off x="13771414" y="13339786"/>
                  <a:ext cx="12492000" cy="11430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  <p:sp>
              <p:nvSpPr>
                <p:cNvPr id="39" name="TextBox 38"/>
                <p:cNvSpPr txBox="1"/>
                <p:nvPr/>
              </p:nvSpPr>
              <p:spPr>
                <a:xfrm>
                  <a:off x="16441733" y="24042549"/>
                  <a:ext cx="7079362" cy="991109"/>
                </a:xfrm>
                <a:prstGeom prst="rect">
                  <a:avLst/>
                </a:prstGeom>
                <a:noFill/>
              </p:spPr>
              <p:txBody>
                <a:bodyPr wrap="square" lIns="417643" tIns="208822" rIns="417643" bIns="208822" rtlCol="0">
                  <a:spAutoFit/>
                </a:bodyPr>
                <a:lstStyle/>
                <a:p>
                  <a:pPr algn="ctr"/>
                  <a:r>
                    <a:rPr lang="de-DE" sz="3700" dirty="0"/>
                    <a:t>Reference (GRCh38)</a:t>
                  </a:r>
                  <a:endParaRPr lang="en-US" sz="3700" dirty="0"/>
                </a:p>
              </p:txBody>
            </p:sp>
            <p:sp>
              <p:nvSpPr>
                <p:cNvPr id="40" name="TextBox 39"/>
                <p:cNvSpPr txBox="1"/>
                <p:nvPr/>
              </p:nvSpPr>
              <p:spPr>
                <a:xfrm>
                  <a:off x="13764073" y="13357224"/>
                  <a:ext cx="8496944" cy="1837495"/>
                </a:xfrm>
                <a:prstGeom prst="rect">
                  <a:avLst/>
                </a:prstGeom>
                <a:noFill/>
              </p:spPr>
              <p:txBody>
                <a:bodyPr wrap="square" lIns="417643" tIns="208822" rIns="417643" bIns="208822" rtlCol="0">
                  <a:spAutoFit/>
                </a:bodyPr>
                <a:lstStyle/>
                <a:p>
                  <a:r>
                    <a:rPr lang="de-DE" sz="4600" i="1" dirty="0"/>
                    <a:t>H. sapiens</a:t>
                  </a:r>
                  <a:r>
                    <a:rPr lang="de-DE" sz="4600" dirty="0"/>
                    <a:t>: </a:t>
                  </a:r>
                  <a:r>
                    <a:rPr lang="de-DE" sz="4600" dirty="0" err="1" smtClean="0"/>
                    <a:t>low</a:t>
                  </a:r>
                  <a:r>
                    <a:rPr lang="de-DE" sz="4600" dirty="0" smtClean="0"/>
                    <a:t> </a:t>
                  </a:r>
                  <a:r>
                    <a:rPr lang="de-DE" sz="4600" dirty="0" err="1" smtClean="0"/>
                    <a:t>coverage</a:t>
                  </a:r>
                  <a:r>
                    <a:rPr lang="de-DE" sz="4600" dirty="0" smtClean="0"/>
                    <a:t> (20X) + </a:t>
                  </a:r>
                  <a:r>
                    <a:rPr lang="de-DE" sz="4600" dirty="0" err="1" smtClean="0"/>
                    <a:t>diverged</a:t>
                  </a:r>
                  <a:r>
                    <a:rPr lang="de-DE" sz="4600" dirty="0" smtClean="0"/>
                    <a:t> </a:t>
                  </a:r>
                  <a:r>
                    <a:rPr lang="de-DE" sz="4600" dirty="0" err="1"/>
                    <a:t>r</a:t>
                  </a:r>
                  <a:r>
                    <a:rPr lang="de-DE" sz="4600" dirty="0" err="1" smtClean="0"/>
                    <a:t>eference</a:t>
                  </a:r>
                  <a:r>
                    <a:rPr lang="de-DE" sz="4600" dirty="0" smtClean="0"/>
                    <a:t> (~15MYA)</a:t>
                  </a:r>
                  <a:endParaRPr lang="en-US" sz="4600" dirty="0"/>
                </a:p>
              </p:txBody>
            </p:sp>
            <p:sp>
              <p:nvSpPr>
                <p:cNvPr id="41" name="TextBox 40"/>
                <p:cNvSpPr txBox="1"/>
                <p:nvPr/>
              </p:nvSpPr>
              <p:spPr>
                <a:xfrm rot="16200000">
                  <a:off x="11172117" y="18559232"/>
                  <a:ext cx="5670789" cy="991109"/>
                </a:xfrm>
                <a:prstGeom prst="rect">
                  <a:avLst/>
                </a:prstGeom>
                <a:noFill/>
              </p:spPr>
              <p:txBody>
                <a:bodyPr wrap="square" lIns="417643" tIns="208822" rIns="417643" bIns="208822" rtlCol="0">
                  <a:spAutoFit/>
                </a:bodyPr>
                <a:lstStyle/>
                <a:p>
                  <a:pPr algn="ctr"/>
                  <a:r>
                    <a:rPr lang="de-DE" sz="3700" dirty="0"/>
                    <a:t>CSA </a:t>
                  </a:r>
                  <a:r>
                    <a:rPr lang="de-DE" sz="3700" dirty="0" smtClean="0"/>
                    <a:t>(</a:t>
                  </a:r>
                  <a:r>
                    <a:rPr lang="de-DE" sz="3700" dirty="0"/>
                    <a:t>2</a:t>
                  </a:r>
                  <a:r>
                    <a:rPr lang="de-DE" sz="3700" dirty="0" smtClean="0"/>
                    <a:t>0X SMRT + </a:t>
                  </a:r>
                  <a:r>
                    <a:rPr lang="de-DE" sz="3700" i="1" dirty="0" err="1" smtClean="0"/>
                    <a:t>P.abelii</a:t>
                  </a:r>
                  <a:r>
                    <a:rPr lang="de-DE" sz="3700" dirty="0" smtClean="0"/>
                    <a:t>)</a:t>
                  </a:r>
                  <a:endParaRPr lang="en-US" sz="3700" dirty="0"/>
                </a:p>
              </p:txBody>
            </p:sp>
          </p:grpSp>
          <p:grpSp>
            <p:nvGrpSpPr>
              <p:cNvPr id="13" name="Group 12"/>
              <p:cNvGrpSpPr/>
              <p:nvPr/>
            </p:nvGrpSpPr>
            <p:grpSpPr>
              <a:xfrm>
                <a:off x="27333370" y="13339786"/>
                <a:ext cx="12648956" cy="11690220"/>
                <a:chOff x="26444822" y="13339786"/>
                <a:chExt cx="12648956" cy="11690220"/>
              </a:xfrm>
            </p:grpSpPr>
            <p:grpSp>
              <p:nvGrpSpPr>
                <p:cNvPr id="11" name="Group 10"/>
                <p:cNvGrpSpPr/>
                <p:nvPr/>
              </p:nvGrpSpPr>
              <p:grpSpPr>
                <a:xfrm>
                  <a:off x="26709108" y="13339786"/>
                  <a:ext cx="12384670" cy="11690220"/>
                  <a:chOff x="26709108" y="13339786"/>
                  <a:chExt cx="12384670" cy="11690220"/>
                </a:xfrm>
              </p:grpSpPr>
              <p:pic>
                <p:nvPicPr>
                  <p:cNvPr id="1032" name="Picture 8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12">
                    <a:extLst>
                      <a:ext uri="{BEBA8EAE-BF5A-486C-A8C5-ECC9F3942E4B}">
                        <a14:imgProps xmlns:a14="http://schemas.microsoft.com/office/drawing/2010/main">
                          <a14:imgLayer r:embed="rId13">
                            <a14:imgEffect>
                              <a14:sharpenSoften amount="30000"/>
                            </a14:imgEffect>
                            <a14:imgEffect>
                              <a14:brightnessContrast contrast="5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6231" r="16051"/>
                  <a:stretch/>
                </p:blipFill>
                <p:spPr bwMode="auto">
                  <a:xfrm>
                    <a:off x="26709778" y="13339786"/>
                    <a:ext cx="12384000" cy="11430000"/>
                  </a:xfrm>
                  <a:prstGeom prst="rect">
                    <a:avLst/>
                  </a:prstGeom>
                  <a:noFill/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</a:extLst>
                </p:spPr>
              </p:pic>
              <p:sp>
                <p:nvSpPr>
                  <p:cNvPr id="43" name="TextBox 42"/>
                  <p:cNvSpPr txBox="1"/>
                  <p:nvPr/>
                </p:nvSpPr>
                <p:spPr>
                  <a:xfrm>
                    <a:off x="29362097" y="24038897"/>
                    <a:ext cx="7079362" cy="991109"/>
                  </a:xfrm>
                  <a:prstGeom prst="rect">
                    <a:avLst/>
                  </a:prstGeom>
                  <a:noFill/>
                </p:spPr>
                <p:txBody>
                  <a:bodyPr wrap="square" lIns="417643" tIns="208822" rIns="417643" bIns="208822" rtlCol="0">
                    <a:spAutoFit/>
                  </a:bodyPr>
                  <a:lstStyle/>
                  <a:p>
                    <a:pPr algn="ctr"/>
                    <a:r>
                      <a:rPr lang="de-DE" sz="3700" dirty="0"/>
                      <a:t>Reference (GRCh38)</a:t>
                    </a:r>
                    <a:endParaRPr lang="en-US" sz="3700" dirty="0"/>
                  </a:p>
                </p:txBody>
              </p:sp>
              <p:sp>
                <p:nvSpPr>
                  <p:cNvPr id="45" name="TextBox 44"/>
                  <p:cNvSpPr txBox="1"/>
                  <p:nvPr/>
                </p:nvSpPr>
                <p:spPr>
                  <a:xfrm>
                    <a:off x="26709108" y="13339786"/>
                    <a:ext cx="8496944" cy="1837495"/>
                  </a:xfrm>
                  <a:prstGeom prst="rect">
                    <a:avLst/>
                  </a:prstGeom>
                  <a:noFill/>
                </p:spPr>
                <p:txBody>
                  <a:bodyPr wrap="square" lIns="417643" tIns="208822" rIns="417643" bIns="208822" rtlCol="0">
                    <a:spAutoFit/>
                  </a:bodyPr>
                  <a:lstStyle/>
                  <a:p>
                    <a:r>
                      <a:rPr lang="de-DE" sz="4600" i="1" dirty="0"/>
                      <a:t>H. sapiens</a:t>
                    </a:r>
                    <a:r>
                      <a:rPr lang="de-DE" sz="4600" dirty="0"/>
                      <a:t>: </a:t>
                    </a:r>
                    <a:r>
                      <a:rPr lang="de-DE" sz="4600" dirty="0" err="1" smtClean="0"/>
                      <a:t>low</a:t>
                    </a:r>
                    <a:r>
                      <a:rPr lang="de-DE" sz="4600" dirty="0" smtClean="0"/>
                      <a:t> </a:t>
                    </a:r>
                    <a:r>
                      <a:rPr lang="de-DE" sz="4600" dirty="0" err="1" smtClean="0"/>
                      <a:t>coverage</a:t>
                    </a:r>
                    <a:r>
                      <a:rPr lang="de-DE" sz="4600" dirty="0" smtClean="0"/>
                      <a:t> (15X) + </a:t>
                    </a:r>
                    <a:r>
                      <a:rPr lang="de-DE" sz="4600" dirty="0" err="1" smtClean="0"/>
                      <a:t>diverged</a:t>
                    </a:r>
                    <a:r>
                      <a:rPr lang="de-DE" sz="4600" dirty="0" smtClean="0"/>
                      <a:t> </a:t>
                    </a:r>
                    <a:r>
                      <a:rPr lang="de-DE" sz="4600" dirty="0" err="1"/>
                      <a:t>r</a:t>
                    </a:r>
                    <a:r>
                      <a:rPr lang="de-DE" sz="4600" dirty="0" err="1" smtClean="0"/>
                      <a:t>eference</a:t>
                    </a:r>
                    <a:r>
                      <a:rPr lang="de-DE" sz="4600" dirty="0" smtClean="0"/>
                      <a:t> (~15MYA)</a:t>
                    </a:r>
                    <a:endParaRPr lang="en-US" sz="4600" dirty="0"/>
                  </a:p>
                </p:txBody>
              </p:sp>
            </p:grpSp>
            <p:sp>
              <p:nvSpPr>
                <p:cNvPr id="44" name="TextBox 43"/>
                <p:cNvSpPr txBox="1"/>
                <p:nvPr/>
              </p:nvSpPr>
              <p:spPr>
                <a:xfrm rot="16200000">
                  <a:off x="24104982" y="18559232"/>
                  <a:ext cx="5670789" cy="991109"/>
                </a:xfrm>
                <a:prstGeom prst="rect">
                  <a:avLst/>
                </a:prstGeom>
                <a:noFill/>
              </p:spPr>
              <p:txBody>
                <a:bodyPr wrap="square" lIns="417643" tIns="208822" rIns="417643" bIns="208822" rtlCol="0">
                  <a:spAutoFit/>
                </a:bodyPr>
                <a:lstStyle/>
                <a:p>
                  <a:pPr algn="ctr"/>
                  <a:r>
                    <a:rPr lang="de-DE" sz="3700" dirty="0"/>
                    <a:t>CSA </a:t>
                  </a:r>
                  <a:r>
                    <a:rPr lang="de-DE" sz="3700" dirty="0" smtClean="0"/>
                    <a:t>(15X SMRT + </a:t>
                  </a:r>
                  <a:r>
                    <a:rPr lang="de-DE" sz="3700" i="1" dirty="0" err="1" smtClean="0"/>
                    <a:t>P.abelii</a:t>
                  </a:r>
                  <a:r>
                    <a:rPr lang="de-DE" sz="3700" dirty="0" smtClean="0"/>
                    <a:t>)</a:t>
                  </a:r>
                  <a:endParaRPr lang="en-US" sz="3700" dirty="0"/>
                </a:p>
              </p:txBody>
            </p:sp>
          </p:grpSp>
        </p:grpSp>
        <p:sp>
          <p:nvSpPr>
            <p:cNvPr id="35" name="Rectangle 34"/>
            <p:cNvSpPr/>
            <p:nvPr/>
          </p:nvSpPr>
          <p:spPr>
            <a:xfrm>
              <a:off x="619474" y="25653155"/>
              <a:ext cx="39676408" cy="230832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7200" b="1" dirty="0"/>
                <a:t>Figure </a:t>
              </a:r>
              <a:r>
                <a:rPr lang="en-GB" sz="7200" b="1" dirty="0" smtClean="0"/>
                <a:t>5: </a:t>
              </a:r>
              <a:r>
                <a:rPr lang="en-GB" sz="7200" dirty="0" smtClean="0"/>
                <a:t>Dot plots of CSA results against reference genome for reduced coverage data (</a:t>
              </a:r>
              <a:r>
                <a:rPr lang="en-GB" sz="7200" i="1" dirty="0" smtClean="0"/>
                <a:t>Homo sapiens</a:t>
              </a:r>
              <a:r>
                <a:rPr lang="en-GB" sz="7200" dirty="0" smtClean="0"/>
                <a:t>), using either the best reference or a diverged reference to support CSA.</a:t>
              </a:r>
              <a:endParaRPr lang="en-US" sz="7200" dirty="0"/>
            </a:p>
          </p:txBody>
        </p:sp>
      </p:grpSp>
    </p:spTree>
    <p:extLst>
      <p:ext uri="{BB962C8B-B14F-4D97-AF65-F5344CB8AC3E}">
        <p14:creationId xmlns:p14="http://schemas.microsoft.com/office/powerpoint/2010/main" val="285926692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oup 21"/>
          <p:cNvGrpSpPr/>
          <p:nvPr/>
        </p:nvGrpSpPr>
        <p:grpSpPr>
          <a:xfrm>
            <a:off x="2414425" y="2520917"/>
            <a:ext cx="26399967" cy="25948519"/>
            <a:chOff x="2414425" y="2520917"/>
            <a:chExt cx="26399967" cy="25948519"/>
          </a:xfrm>
        </p:grpSpPr>
        <p:sp>
          <p:nvSpPr>
            <p:cNvPr id="18" name="Rechteck 149"/>
            <p:cNvSpPr/>
            <p:nvPr/>
          </p:nvSpPr>
          <p:spPr>
            <a:xfrm>
              <a:off x="2426807" y="2520917"/>
              <a:ext cx="26387585" cy="24179702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lIns="417643" tIns="208822" rIns="417643" bIns="208822" rtlCol="0" anchor="ctr"/>
            <a:lstStyle/>
            <a:p>
              <a:pPr algn="ctr"/>
              <a:endParaRPr lang="de-DE"/>
            </a:p>
          </p:txBody>
        </p:sp>
        <p:grpSp>
          <p:nvGrpSpPr>
            <p:cNvPr id="13" name="Group 12"/>
            <p:cNvGrpSpPr/>
            <p:nvPr/>
          </p:nvGrpSpPr>
          <p:grpSpPr>
            <a:xfrm>
              <a:off x="2610174" y="14895633"/>
              <a:ext cx="12707280" cy="11693626"/>
              <a:chOff x="15763941" y="2983390"/>
              <a:chExt cx="12707280" cy="11693626"/>
            </a:xfrm>
          </p:grpSpPr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sharpenSoften amount="30000"/>
                        </a14:imgEffect>
                        <a14:imgEffect>
                          <a14:brightnessContrast contras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816" r="15880"/>
              <a:stretch/>
            </p:blipFill>
            <p:spPr bwMode="auto">
              <a:xfrm>
                <a:off x="15979221" y="2983390"/>
                <a:ext cx="12492000" cy="1143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5" name="TextBox 4"/>
              <p:cNvSpPr txBox="1"/>
              <p:nvPr/>
            </p:nvSpPr>
            <p:spPr>
              <a:xfrm>
                <a:off x="15979221" y="3079586"/>
                <a:ext cx="11461823" cy="1129609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r>
                  <a:rPr lang="de-DE" sz="4600" i="1" dirty="0"/>
                  <a:t>H. sapiens</a:t>
                </a:r>
                <a:r>
                  <a:rPr lang="de-DE" sz="4600" dirty="0"/>
                  <a:t>: divergent </a:t>
                </a:r>
                <a:r>
                  <a:rPr lang="de-DE" sz="4600" dirty="0" err="1"/>
                  <a:t>genome</a:t>
                </a:r>
                <a:r>
                  <a:rPr lang="de-DE" sz="4600" dirty="0"/>
                  <a:t> </a:t>
                </a:r>
                <a:r>
                  <a:rPr lang="de-DE" sz="4600" dirty="0" smtClean="0"/>
                  <a:t>(~90 </a:t>
                </a:r>
                <a:r>
                  <a:rPr lang="de-DE" sz="4600" dirty="0" err="1"/>
                  <a:t>Mya</a:t>
                </a:r>
                <a:r>
                  <a:rPr lang="de-DE" sz="4600" dirty="0"/>
                  <a:t>) </a:t>
                </a:r>
                <a:endParaRPr lang="en-US" sz="4600" dirty="0"/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18768046" y="13685907"/>
                <a:ext cx="7079362" cy="991109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pPr algn="ctr"/>
                <a:r>
                  <a:rPr lang="de-DE" sz="3700" dirty="0"/>
                  <a:t>Reference (GRCh38)</a:t>
                </a:r>
                <a:endParaRPr lang="en-US" sz="3700" dirty="0"/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 rot="16200000">
                <a:off x="12767109" y="8183914"/>
                <a:ext cx="6984774" cy="991109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pPr algn="ctr"/>
                <a:r>
                  <a:rPr lang="de-DE" sz="3700" dirty="0"/>
                  <a:t>CSA (60X </a:t>
                </a:r>
                <a:r>
                  <a:rPr lang="de-DE" sz="3700" dirty="0" smtClean="0"/>
                  <a:t>SMRT+</a:t>
                </a:r>
                <a:r>
                  <a:rPr lang="de-DE" sz="3700" i="1" dirty="0"/>
                  <a:t>L</a:t>
                </a:r>
                <a:r>
                  <a:rPr lang="de-DE" sz="3700" i="1" dirty="0" smtClean="0"/>
                  <a:t>. </a:t>
                </a:r>
                <a:r>
                  <a:rPr lang="de-DE" sz="3700" i="1" dirty="0" err="1" smtClean="0"/>
                  <a:t>canadensis</a:t>
                </a:r>
                <a:r>
                  <a:rPr lang="de-DE" sz="3700" dirty="0" smtClean="0"/>
                  <a:t>)</a:t>
                </a:r>
                <a:endParaRPr lang="en-US" sz="3700" dirty="0"/>
              </a:p>
            </p:txBody>
          </p:sp>
        </p:grpSp>
        <p:grpSp>
          <p:nvGrpSpPr>
            <p:cNvPr id="9" name="Group 8"/>
            <p:cNvGrpSpPr/>
            <p:nvPr/>
          </p:nvGrpSpPr>
          <p:grpSpPr>
            <a:xfrm>
              <a:off x="15608645" y="2898627"/>
              <a:ext cx="12743280" cy="11681758"/>
              <a:chOff x="2106118" y="2995258"/>
              <a:chExt cx="12743280" cy="11681758"/>
            </a:xfrm>
          </p:grpSpPr>
          <p:pic>
            <p:nvPicPr>
              <p:cNvPr id="1027" name="Picture 3"/>
              <p:cNvPicPr>
                <a:picLocks noChangeAspect="1" noChangeArrowheads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harpenSoften amount="30000"/>
                        </a14:imgEffect>
                        <a14:imgEffect>
                          <a14:brightnessContrast contras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831" r="15664"/>
              <a:stretch/>
            </p:blipFill>
            <p:spPr bwMode="auto">
              <a:xfrm>
                <a:off x="2321398" y="2995258"/>
                <a:ext cx="12528000" cy="1143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0" name="TextBox 9"/>
              <p:cNvSpPr txBox="1"/>
              <p:nvPr/>
            </p:nvSpPr>
            <p:spPr>
              <a:xfrm>
                <a:off x="2321398" y="3079586"/>
                <a:ext cx="11461823" cy="1129609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r>
                  <a:rPr lang="de-DE" sz="4600" i="1" dirty="0"/>
                  <a:t>H. sapiens</a:t>
                </a:r>
                <a:r>
                  <a:rPr lang="de-DE" sz="4600" dirty="0"/>
                  <a:t>: divergent </a:t>
                </a:r>
                <a:r>
                  <a:rPr lang="de-DE" sz="4600" dirty="0" err="1"/>
                  <a:t>genome</a:t>
                </a:r>
                <a:r>
                  <a:rPr lang="de-DE" sz="4600" dirty="0"/>
                  <a:t> </a:t>
                </a:r>
                <a:r>
                  <a:rPr lang="de-DE" sz="4600" dirty="0" smtClean="0"/>
                  <a:t>(~43 </a:t>
                </a:r>
                <a:r>
                  <a:rPr lang="de-DE" sz="4600" dirty="0" err="1"/>
                  <a:t>Mya</a:t>
                </a:r>
                <a:r>
                  <a:rPr lang="de-DE" sz="4600" dirty="0"/>
                  <a:t>) </a:t>
                </a:r>
                <a:endParaRPr lang="en-US" sz="4600" dirty="0"/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5110223" y="13685907"/>
                <a:ext cx="7079362" cy="991109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pPr algn="ctr"/>
                <a:r>
                  <a:rPr lang="de-DE" sz="3700" dirty="0"/>
                  <a:t>Reference (GRCh38)</a:t>
                </a:r>
                <a:endParaRPr lang="en-US" sz="3700" dirty="0"/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 rot="16200000">
                <a:off x="-890714" y="8183914"/>
                <a:ext cx="6984774" cy="991109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pPr algn="ctr"/>
                <a:r>
                  <a:rPr lang="de-DE" sz="3700" dirty="0"/>
                  <a:t>CSA (60X </a:t>
                </a:r>
                <a:r>
                  <a:rPr lang="de-DE" sz="3700" dirty="0" smtClean="0"/>
                  <a:t>SMRT+</a:t>
                </a:r>
                <a:r>
                  <a:rPr lang="de-DE" sz="3700" i="1" dirty="0" smtClean="0"/>
                  <a:t>C. </a:t>
                </a:r>
                <a:r>
                  <a:rPr lang="de-DE" sz="3700" i="1" dirty="0" err="1" smtClean="0"/>
                  <a:t>jacchus</a:t>
                </a:r>
                <a:r>
                  <a:rPr lang="de-DE" sz="3700" dirty="0" smtClean="0"/>
                  <a:t>)</a:t>
                </a:r>
                <a:endParaRPr lang="en-US" sz="3700" dirty="0"/>
              </a:p>
            </p:txBody>
          </p:sp>
        </p:grpSp>
        <p:grpSp>
          <p:nvGrpSpPr>
            <p:cNvPr id="14" name="Group 13"/>
            <p:cNvGrpSpPr/>
            <p:nvPr/>
          </p:nvGrpSpPr>
          <p:grpSpPr>
            <a:xfrm>
              <a:off x="15582979" y="14882878"/>
              <a:ext cx="12794612" cy="11706381"/>
              <a:chOff x="28910096" y="2970635"/>
              <a:chExt cx="12794612" cy="11706381"/>
            </a:xfrm>
          </p:grpSpPr>
          <p:pic>
            <p:nvPicPr>
              <p:cNvPr id="1028" name="Picture 4"/>
              <p:cNvPicPr>
                <a:picLocks noChangeAspect="1" noChangeArrowheads="1"/>
              </p:cNvPicPr>
              <p:nvPr/>
            </p:nvPicPr>
            <p:blipFill rotWithShape="1"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sharpenSoften amount="30000"/>
                        </a14:imgEffect>
                        <a14:imgEffect>
                          <a14:brightnessContrast contras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844" r="15651"/>
              <a:stretch/>
            </p:blipFill>
            <p:spPr bwMode="auto">
              <a:xfrm>
                <a:off x="29176708" y="2970635"/>
                <a:ext cx="12528000" cy="1143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5" name="TextBox 14"/>
              <p:cNvSpPr txBox="1"/>
              <p:nvPr/>
            </p:nvSpPr>
            <p:spPr>
              <a:xfrm>
                <a:off x="29357952" y="3079586"/>
                <a:ext cx="11461823" cy="1129609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r>
                  <a:rPr lang="de-DE" sz="4600" i="1" dirty="0"/>
                  <a:t>H. sapiens</a:t>
                </a:r>
                <a:r>
                  <a:rPr lang="de-DE" sz="4600" dirty="0"/>
                  <a:t>: divergent </a:t>
                </a:r>
                <a:r>
                  <a:rPr lang="de-DE" sz="4600" dirty="0" err="1"/>
                  <a:t>genome</a:t>
                </a:r>
                <a:r>
                  <a:rPr lang="de-DE" sz="4600" dirty="0"/>
                  <a:t> </a:t>
                </a:r>
                <a:r>
                  <a:rPr lang="de-DE" sz="4600" dirty="0" smtClean="0"/>
                  <a:t>(~180 </a:t>
                </a:r>
                <a:r>
                  <a:rPr lang="de-DE" sz="4600" dirty="0" err="1"/>
                  <a:t>Mya</a:t>
                </a:r>
                <a:r>
                  <a:rPr lang="de-DE" sz="4600" dirty="0"/>
                  <a:t>) </a:t>
                </a:r>
                <a:endParaRPr lang="en-US" sz="4600" dirty="0"/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32146777" y="13685907"/>
                <a:ext cx="7079362" cy="991109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pPr algn="ctr"/>
                <a:r>
                  <a:rPr lang="de-DE" sz="3700" dirty="0"/>
                  <a:t>Reference (GRCh38)</a:t>
                </a:r>
                <a:endParaRPr lang="en-US" sz="3700" dirty="0"/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 rot="16200000">
                <a:off x="25913264" y="8183914"/>
                <a:ext cx="6984774" cy="991109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pPr algn="ctr"/>
                <a:r>
                  <a:rPr lang="de-DE" sz="3700" dirty="0"/>
                  <a:t>CSA (60X </a:t>
                </a:r>
                <a:r>
                  <a:rPr lang="de-DE" sz="3700" dirty="0" smtClean="0"/>
                  <a:t>SMRT+</a:t>
                </a:r>
                <a:r>
                  <a:rPr lang="de-DE" sz="3700" i="1" dirty="0" smtClean="0"/>
                  <a:t>O. </a:t>
                </a:r>
                <a:r>
                  <a:rPr lang="de-DE" sz="3700" i="1" dirty="0" err="1" smtClean="0"/>
                  <a:t>anatinus</a:t>
                </a:r>
                <a:r>
                  <a:rPr lang="de-DE" sz="3700" dirty="0" smtClean="0"/>
                  <a:t>)</a:t>
                </a:r>
                <a:endParaRPr lang="en-US" sz="3700" dirty="0"/>
              </a:p>
            </p:txBody>
          </p:sp>
        </p:grpSp>
        <p:grpSp>
          <p:nvGrpSpPr>
            <p:cNvPr id="21" name="Group 20"/>
            <p:cNvGrpSpPr/>
            <p:nvPr/>
          </p:nvGrpSpPr>
          <p:grpSpPr>
            <a:xfrm>
              <a:off x="2682182" y="2826619"/>
              <a:ext cx="12637866" cy="11720301"/>
              <a:chOff x="2957601" y="3093884"/>
              <a:chExt cx="12637866" cy="11720301"/>
            </a:xfrm>
          </p:grpSpPr>
          <p:pic>
            <p:nvPicPr>
              <p:cNvPr id="1031" name="Picture 7"/>
              <p:cNvPicPr>
                <a:picLocks noChangeAspect="1" noChangeArrowheads="1"/>
              </p:cNvPicPr>
              <p:nvPr/>
            </p:nvPicPr>
            <p:blipFill rotWithShape="1">
              <a:blip r:embed="rId8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sharpenSoften amount="30000"/>
                        </a14:imgEffect>
                        <a14:imgEffect>
                          <a14:brightnessContrast contras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029" r="16058"/>
              <a:stretch/>
            </p:blipFill>
            <p:spPr bwMode="auto">
              <a:xfrm>
                <a:off x="3175467" y="3093884"/>
                <a:ext cx="12420000" cy="1143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33" name="TextBox 32"/>
              <p:cNvSpPr txBox="1"/>
              <p:nvPr/>
            </p:nvSpPr>
            <p:spPr>
              <a:xfrm>
                <a:off x="3316897" y="3188411"/>
                <a:ext cx="11461823" cy="1129609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r>
                  <a:rPr lang="de-DE" sz="4600" i="1" dirty="0"/>
                  <a:t>H. sapiens</a:t>
                </a:r>
                <a:r>
                  <a:rPr lang="de-DE" sz="4600" dirty="0"/>
                  <a:t>: </a:t>
                </a:r>
                <a:r>
                  <a:rPr lang="de-DE" sz="4600" dirty="0" smtClean="0"/>
                  <a:t>Ultra </a:t>
                </a:r>
                <a:r>
                  <a:rPr lang="de-DE" sz="4600" dirty="0" err="1" smtClean="0"/>
                  <a:t>long</a:t>
                </a:r>
                <a:r>
                  <a:rPr lang="de-DE" sz="4600" dirty="0" smtClean="0"/>
                  <a:t> </a:t>
                </a:r>
                <a:r>
                  <a:rPr lang="de-DE" sz="4600" dirty="0" err="1" smtClean="0"/>
                  <a:t>read</a:t>
                </a:r>
                <a:r>
                  <a:rPr lang="de-DE" sz="4600" dirty="0" smtClean="0"/>
                  <a:t> </a:t>
                </a:r>
                <a:r>
                  <a:rPr lang="de-DE" sz="4600" dirty="0" err="1" smtClean="0"/>
                  <a:t>assembly</a:t>
                </a:r>
                <a:r>
                  <a:rPr lang="de-DE" sz="4600" dirty="0" smtClean="0"/>
                  <a:t> </a:t>
                </a:r>
                <a:endParaRPr lang="en-US" sz="4600" dirty="0"/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5929198" y="13823076"/>
                <a:ext cx="7079362" cy="991109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pPr algn="ctr"/>
                <a:r>
                  <a:rPr lang="de-DE" sz="3700" dirty="0"/>
                  <a:t>Reference (GRCh38)</a:t>
                </a:r>
                <a:endParaRPr lang="en-US" sz="3700" dirty="0"/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 rot="16200000">
                <a:off x="-39231" y="8247058"/>
                <a:ext cx="6984774" cy="991109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pPr algn="ctr"/>
                <a:r>
                  <a:rPr lang="de-DE" sz="3700" dirty="0"/>
                  <a:t>CSA </a:t>
                </a:r>
                <a:r>
                  <a:rPr lang="de-DE" sz="3700" dirty="0" smtClean="0"/>
                  <a:t>(50X ONT+ GRCh38)</a:t>
                </a:r>
                <a:endParaRPr lang="en-US" sz="3700" dirty="0"/>
              </a:p>
            </p:txBody>
          </p:sp>
        </p:grpSp>
        <p:sp>
          <p:nvSpPr>
            <p:cNvPr id="37" name="Rectangle 36"/>
            <p:cNvSpPr/>
            <p:nvPr/>
          </p:nvSpPr>
          <p:spPr>
            <a:xfrm>
              <a:off x="2414425" y="26715110"/>
              <a:ext cx="24855807" cy="175432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5400" b="1" dirty="0" smtClean="0"/>
                <a:t>Supplementary Figure </a:t>
              </a:r>
              <a:r>
                <a:rPr lang="en-GB" sz="5400" b="1" dirty="0"/>
                <a:t>1</a:t>
              </a:r>
              <a:r>
                <a:rPr lang="en-GB" sz="5400" b="1" dirty="0" smtClean="0"/>
                <a:t>: </a:t>
              </a:r>
              <a:r>
                <a:rPr lang="en-GB" sz="5400" dirty="0"/>
                <a:t>A</a:t>
              </a:r>
              <a:r>
                <a:rPr lang="en-GB" sz="5400" dirty="0" smtClean="0"/>
                <a:t>dditional dot plots for </a:t>
              </a:r>
              <a:r>
                <a:rPr lang="en-GB" sz="5400" i="1" dirty="0" smtClean="0"/>
                <a:t>H. sapiens</a:t>
              </a:r>
              <a:r>
                <a:rPr lang="en-GB" sz="5400" dirty="0" smtClean="0"/>
                <a:t> CSA assemblies using ONT ultra long reads, or SMRT reads and more diverged reference genomes.</a:t>
              </a:r>
              <a:endParaRPr lang="en-US" sz="5400" dirty="0"/>
            </a:p>
          </p:txBody>
        </p:sp>
      </p:grpSp>
    </p:spTree>
    <p:extLst>
      <p:ext uri="{BB962C8B-B14F-4D97-AF65-F5344CB8AC3E}">
        <p14:creationId xmlns:p14="http://schemas.microsoft.com/office/powerpoint/2010/main" val="362821290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998003" y="2553574"/>
            <a:ext cx="24855807" cy="14529819"/>
            <a:chOff x="1998003" y="2553574"/>
            <a:chExt cx="24855807" cy="14529819"/>
          </a:xfrm>
        </p:grpSpPr>
        <p:sp>
          <p:nvSpPr>
            <p:cNvPr id="18" name="Rechteck 149"/>
            <p:cNvSpPr/>
            <p:nvPr/>
          </p:nvSpPr>
          <p:spPr>
            <a:xfrm>
              <a:off x="1998003" y="2553574"/>
              <a:ext cx="24590836" cy="12773926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lIns="417643" tIns="208822" rIns="417643" bIns="208822" rtlCol="0" anchor="ctr"/>
            <a:lstStyle/>
            <a:p>
              <a:pPr algn="ctr"/>
              <a:endParaRPr lang="de-DE"/>
            </a:p>
          </p:txBody>
        </p:sp>
        <p:grpSp>
          <p:nvGrpSpPr>
            <p:cNvPr id="19" name="Group 18"/>
            <p:cNvGrpSpPr/>
            <p:nvPr/>
          </p:nvGrpSpPr>
          <p:grpSpPr>
            <a:xfrm>
              <a:off x="2564234" y="3083247"/>
              <a:ext cx="11503968" cy="11786527"/>
              <a:chOff x="16177541" y="15889900"/>
              <a:chExt cx="11503968" cy="11786527"/>
            </a:xfrm>
          </p:grpSpPr>
          <p:pic>
            <p:nvPicPr>
              <p:cNvPr id="1029" name="Picture 5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sharpenSoften amount="30000"/>
                        </a14:imgEffect>
                        <a14:imgEffect>
                          <a14:brightnessContrast contras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619" r="19751"/>
              <a:stretch/>
            </p:blipFill>
            <p:spPr bwMode="auto">
              <a:xfrm>
                <a:off x="16365988" y="15983628"/>
                <a:ext cx="11088000" cy="1143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3" name="TextBox 22"/>
              <p:cNvSpPr txBox="1"/>
              <p:nvPr/>
            </p:nvSpPr>
            <p:spPr>
              <a:xfrm>
                <a:off x="16219686" y="15889900"/>
                <a:ext cx="11461823" cy="1129609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r>
                  <a:rPr lang="de-DE" sz="4600" i="1" dirty="0"/>
                  <a:t>T. </a:t>
                </a:r>
                <a:r>
                  <a:rPr lang="de-DE" sz="4600" i="1" dirty="0" err="1"/>
                  <a:t>guttata</a:t>
                </a:r>
                <a:r>
                  <a:rPr lang="de-DE" sz="4600" dirty="0"/>
                  <a:t>: divergent </a:t>
                </a:r>
                <a:r>
                  <a:rPr lang="de-DE" sz="4600" dirty="0" err="1"/>
                  <a:t>genome</a:t>
                </a:r>
                <a:r>
                  <a:rPr lang="de-DE" sz="4600" dirty="0"/>
                  <a:t> </a:t>
                </a:r>
                <a:r>
                  <a:rPr lang="de-DE" sz="4600" dirty="0" smtClean="0"/>
                  <a:t>(~90 </a:t>
                </a:r>
                <a:r>
                  <a:rPr lang="de-DE" sz="4600" dirty="0" err="1"/>
                  <a:t>Mya</a:t>
                </a:r>
                <a:r>
                  <a:rPr lang="de-DE" sz="4600" dirty="0"/>
                  <a:t>) </a:t>
                </a:r>
                <a:endParaRPr lang="en-US" sz="4600" dirty="0"/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18383036" y="26685318"/>
                <a:ext cx="7079362" cy="991109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pPr algn="ctr"/>
                <a:r>
                  <a:rPr lang="de-DE" sz="3700" dirty="0"/>
                  <a:t>Reference (</a:t>
                </a:r>
                <a:r>
                  <a:rPr lang="de-DE" sz="3700" i="1" dirty="0"/>
                  <a:t>T</a:t>
                </a:r>
                <a:r>
                  <a:rPr lang="de-DE" sz="3700" i="1" dirty="0" smtClean="0"/>
                  <a:t>. </a:t>
                </a:r>
                <a:r>
                  <a:rPr lang="de-DE" sz="3700" i="1" dirty="0" err="1" smtClean="0"/>
                  <a:t>guttata</a:t>
                </a:r>
                <a:r>
                  <a:rPr lang="de-DE" sz="3700" dirty="0" smtClean="0"/>
                  <a:t> </a:t>
                </a:r>
                <a:r>
                  <a:rPr lang="de-DE" sz="3700" dirty="0"/>
                  <a:t>VGP)</a:t>
                </a:r>
                <a:endParaRPr lang="en-US" sz="3700" dirty="0"/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 rot="16200000">
                <a:off x="13184563" y="21194317"/>
                <a:ext cx="6994577" cy="1008622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pPr algn="ctr"/>
                <a:r>
                  <a:rPr lang="de-DE" sz="3700" dirty="0"/>
                  <a:t>CSA (96X </a:t>
                </a:r>
                <a:r>
                  <a:rPr lang="de-DE" sz="3700" dirty="0" smtClean="0"/>
                  <a:t>SMRT+</a:t>
                </a:r>
                <a:r>
                  <a:rPr lang="de-DE" sz="3700" i="1" dirty="0" smtClean="0"/>
                  <a:t>G. </a:t>
                </a:r>
                <a:r>
                  <a:rPr lang="de-DE" sz="3700" i="1" dirty="0" err="1" smtClean="0"/>
                  <a:t>gallus</a:t>
                </a:r>
                <a:r>
                  <a:rPr lang="de-DE" sz="3700" dirty="0" smtClean="0"/>
                  <a:t>)</a:t>
                </a:r>
                <a:endParaRPr lang="en-US" sz="3700" dirty="0"/>
              </a:p>
            </p:txBody>
          </p:sp>
        </p:grpSp>
        <p:grpSp>
          <p:nvGrpSpPr>
            <p:cNvPr id="20" name="Group 19"/>
            <p:cNvGrpSpPr/>
            <p:nvPr/>
          </p:nvGrpSpPr>
          <p:grpSpPr>
            <a:xfrm>
              <a:off x="14445554" y="3083247"/>
              <a:ext cx="11639228" cy="11786527"/>
              <a:chOff x="29823105" y="15889900"/>
              <a:chExt cx="11639228" cy="11786527"/>
            </a:xfrm>
          </p:grpSpPr>
          <p:pic>
            <p:nvPicPr>
              <p:cNvPr id="1030" name="Picture 6"/>
              <p:cNvPicPr>
                <a:picLocks noChangeAspect="1" noChangeArrowheads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harpenSoften amount="30000"/>
                        </a14:imgEffect>
                        <a14:imgEffect>
                          <a14:brightnessContrast contras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581" r="19589"/>
              <a:stretch/>
            </p:blipFill>
            <p:spPr bwMode="auto">
              <a:xfrm>
                <a:off x="30100590" y="15983628"/>
                <a:ext cx="11124000" cy="1143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7" name="TextBox 26"/>
              <p:cNvSpPr txBox="1"/>
              <p:nvPr/>
            </p:nvSpPr>
            <p:spPr>
              <a:xfrm>
                <a:off x="30000510" y="15889900"/>
                <a:ext cx="11461823" cy="1129609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r>
                  <a:rPr lang="de-DE" sz="4600" i="1" dirty="0"/>
                  <a:t>T. </a:t>
                </a:r>
                <a:r>
                  <a:rPr lang="de-DE" sz="4600" i="1" dirty="0" err="1"/>
                  <a:t>guttata</a:t>
                </a:r>
                <a:r>
                  <a:rPr lang="de-DE" sz="4600" dirty="0"/>
                  <a:t>: divergent </a:t>
                </a:r>
                <a:r>
                  <a:rPr lang="de-DE" sz="4600" dirty="0" err="1"/>
                  <a:t>genome</a:t>
                </a:r>
                <a:r>
                  <a:rPr lang="de-DE" sz="4600" dirty="0"/>
                  <a:t> </a:t>
                </a:r>
                <a:r>
                  <a:rPr lang="de-DE" sz="4600" dirty="0" smtClean="0"/>
                  <a:t>(~240 </a:t>
                </a:r>
                <a:r>
                  <a:rPr lang="de-DE" sz="4600" dirty="0" err="1"/>
                  <a:t>Mya</a:t>
                </a:r>
                <a:r>
                  <a:rPr lang="de-DE" sz="4600" dirty="0"/>
                  <a:t>) </a:t>
                </a:r>
                <a:endParaRPr lang="en-US" sz="4600" dirty="0"/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32019844" y="26685318"/>
                <a:ext cx="7079362" cy="991109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pPr algn="ctr"/>
                <a:r>
                  <a:rPr lang="de-DE" sz="3700" dirty="0"/>
                  <a:t>Reference (</a:t>
                </a:r>
                <a:r>
                  <a:rPr lang="de-DE" sz="3700" i="1" dirty="0"/>
                  <a:t>T</a:t>
                </a:r>
                <a:r>
                  <a:rPr lang="de-DE" sz="3700" i="1" dirty="0" smtClean="0"/>
                  <a:t>. </a:t>
                </a:r>
                <a:r>
                  <a:rPr lang="de-DE" sz="3700" i="1" dirty="0" err="1" smtClean="0"/>
                  <a:t>guttata</a:t>
                </a:r>
                <a:r>
                  <a:rPr lang="de-DE" sz="3700" dirty="0" smtClean="0"/>
                  <a:t> </a:t>
                </a:r>
                <a:r>
                  <a:rPr lang="de-DE" sz="3700" dirty="0"/>
                  <a:t>VGP)</a:t>
                </a:r>
                <a:endParaRPr lang="en-US" sz="3700" dirty="0"/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 rot="16200000">
                <a:off x="26250208" y="21203074"/>
                <a:ext cx="8136903" cy="991109"/>
              </a:xfrm>
              <a:prstGeom prst="rect">
                <a:avLst/>
              </a:prstGeom>
              <a:noFill/>
            </p:spPr>
            <p:txBody>
              <a:bodyPr wrap="square" lIns="417643" tIns="208822" rIns="417643" bIns="208822" rtlCol="0">
                <a:spAutoFit/>
              </a:bodyPr>
              <a:lstStyle/>
              <a:p>
                <a:pPr algn="ctr"/>
                <a:r>
                  <a:rPr lang="de-DE" sz="3700" dirty="0"/>
                  <a:t>CSA (96X </a:t>
                </a:r>
                <a:r>
                  <a:rPr lang="de-DE" sz="3700" dirty="0" smtClean="0"/>
                  <a:t>SMRT+</a:t>
                </a:r>
                <a:r>
                  <a:rPr lang="de-DE" sz="3700" i="1" dirty="0"/>
                  <a:t>A</a:t>
                </a:r>
                <a:r>
                  <a:rPr lang="de-DE" sz="3700" i="1" dirty="0" smtClean="0"/>
                  <a:t>. </a:t>
                </a:r>
                <a:r>
                  <a:rPr lang="de-DE" sz="3700" i="1" dirty="0" err="1" smtClean="0"/>
                  <a:t>mississipiensis</a:t>
                </a:r>
                <a:r>
                  <a:rPr lang="de-DE" sz="3700" dirty="0" smtClean="0"/>
                  <a:t>)</a:t>
                </a:r>
                <a:endParaRPr lang="en-US" sz="3700" dirty="0"/>
              </a:p>
            </p:txBody>
          </p:sp>
        </p:grpSp>
        <p:sp>
          <p:nvSpPr>
            <p:cNvPr id="30" name="Rectangle 29"/>
            <p:cNvSpPr/>
            <p:nvPr/>
          </p:nvSpPr>
          <p:spPr>
            <a:xfrm>
              <a:off x="1998003" y="15329067"/>
              <a:ext cx="24855807" cy="175432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5400" b="1" dirty="0" smtClean="0"/>
                <a:t>Supplementary Figure </a:t>
              </a:r>
              <a:r>
                <a:rPr lang="en-GB" sz="5400" b="1" dirty="0"/>
                <a:t>2</a:t>
              </a:r>
              <a:r>
                <a:rPr lang="en-GB" sz="5400" b="1" dirty="0" smtClean="0"/>
                <a:t>: </a:t>
              </a:r>
              <a:r>
                <a:rPr lang="en-GB" sz="5400" dirty="0"/>
                <a:t>A</a:t>
              </a:r>
              <a:r>
                <a:rPr lang="en-GB" sz="5400" dirty="0" smtClean="0"/>
                <a:t>dditional dot plots for </a:t>
              </a:r>
              <a:r>
                <a:rPr lang="en-GB" sz="5400" i="1" dirty="0" smtClean="0"/>
                <a:t>T. </a:t>
              </a:r>
              <a:r>
                <a:rPr lang="en-GB" sz="5400" i="1" dirty="0" err="1" smtClean="0"/>
                <a:t>guttata</a:t>
              </a:r>
              <a:r>
                <a:rPr lang="en-GB" sz="5400" i="1" dirty="0" smtClean="0"/>
                <a:t> </a:t>
              </a:r>
              <a:r>
                <a:rPr lang="en-GB" sz="5400" dirty="0" smtClean="0"/>
                <a:t>CSA assemblies using SMRT reads and more diverged reference genomes.</a:t>
              </a:r>
              <a:endParaRPr lang="en-US" sz="5400" dirty="0"/>
            </a:p>
          </p:txBody>
        </p:sp>
      </p:grpSp>
    </p:spTree>
    <p:extLst>
      <p:ext uri="{BB962C8B-B14F-4D97-AF65-F5344CB8AC3E}">
        <p14:creationId xmlns:p14="http://schemas.microsoft.com/office/powerpoint/2010/main" val="361777809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Rectangle 29"/>
          <p:cNvSpPr/>
          <p:nvPr/>
        </p:nvSpPr>
        <p:spPr>
          <a:xfrm>
            <a:off x="1998003" y="15329067"/>
            <a:ext cx="24855807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5400" b="1" dirty="0" smtClean="0"/>
              <a:t>Supplementary Figure </a:t>
            </a:r>
            <a:r>
              <a:rPr lang="en-GB" sz="5400" b="1" dirty="0"/>
              <a:t>3</a:t>
            </a:r>
            <a:r>
              <a:rPr lang="en-GB" sz="5400" b="1" dirty="0" smtClean="0"/>
              <a:t>: </a:t>
            </a:r>
            <a:r>
              <a:rPr lang="en-GB" sz="5400" dirty="0"/>
              <a:t>Additional dot </a:t>
            </a:r>
            <a:r>
              <a:rPr lang="en-GB" sz="5400" dirty="0" smtClean="0"/>
              <a:t>plot for </a:t>
            </a:r>
            <a:r>
              <a:rPr lang="en-GB" sz="5400" i="1" dirty="0"/>
              <a:t>H. sapiens</a:t>
            </a:r>
            <a:r>
              <a:rPr lang="en-GB" sz="5400" dirty="0"/>
              <a:t> CSA </a:t>
            </a:r>
            <a:r>
              <a:rPr lang="en-GB" sz="5400" dirty="0" smtClean="0"/>
              <a:t>assembly </a:t>
            </a:r>
            <a:r>
              <a:rPr lang="en-GB" sz="5400" dirty="0"/>
              <a:t>using ONT </a:t>
            </a:r>
            <a:r>
              <a:rPr lang="en-GB" sz="5400" dirty="0" smtClean="0"/>
              <a:t>ultra </a:t>
            </a:r>
            <a:r>
              <a:rPr lang="en-GB" sz="5400" dirty="0"/>
              <a:t>long </a:t>
            </a:r>
            <a:r>
              <a:rPr lang="en-GB" sz="5400" dirty="0" smtClean="0"/>
              <a:t>reads</a:t>
            </a:r>
            <a:r>
              <a:rPr lang="en-GB" sz="5400" dirty="0"/>
              <a:t> </a:t>
            </a:r>
            <a:r>
              <a:rPr lang="en-GB" sz="5400" dirty="0" smtClean="0"/>
              <a:t>and a diverged reference genome(</a:t>
            </a:r>
            <a:r>
              <a:rPr lang="en-GB" sz="5400" i="1" dirty="0" smtClean="0"/>
              <a:t>P. </a:t>
            </a:r>
            <a:r>
              <a:rPr lang="en-GB" sz="5400" i="1" dirty="0" err="1" smtClean="0"/>
              <a:t>abelii</a:t>
            </a:r>
            <a:r>
              <a:rPr lang="en-GB" sz="5400" dirty="0" smtClean="0"/>
              <a:t>).</a:t>
            </a:r>
            <a:endParaRPr lang="en-US" sz="5400" dirty="0"/>
          </a:p>
        </p:txBody>
      </p:sp>
      <p:grpSp>
        <p:nvGrpSpPr>
          <p:cNvPr id="3" name="Gruppieren 2"/>
          <p:cNvGrpSpPr/>
          <p:nvPr/>
        </p:nvGrpSpPr>
        <p:grpSpPr>
          <a:xfrm>
            <a:off x="1998003" y="2553574"/>
            <a:ext cx="12997547" cy="12010349"/>
            <a:chOff x="1998003" y="2553574"/>
            <a:chExt cx="12997547" cy="12010349"/>
          </a:xfrm>
        </p:grpSpPr>
        <p:sp>
          <p:nvSpPr>
            <p:cNvPr id="18" name="Rechteck 149"/>
            <p:cNvSpPr/>
            <p:nvPr/>
          </p:nvSpPr>
          <p:spPr>
            <a:xfrm>
              <a:off x="1998003" y="2553574"/>
              <a:ext cx="12997547" cy="12010349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lIns="417643" tIns="208822" rIns="417643" bIns="208822" rtlCol="0" anchor="ctr"/>
            <a:lstStyle/>
            <a:p>
              <a:pPr algn="ctr"/>
              <a:endParaRPr lang="de-DE"/>
            </a:p>
          </p:txBody>
        </p:sp>
        <p:pic>
          <p:nvPicPr>
            <p:cNvPr id="15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84001" y="2898627"/>
              <a:ext cx="12496800" cy="1143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6" name="TextBox 34"/>
            <p:cNvSpPr txBox="1"/>
            <p:nvPr/>
          </p:nvSpPr>
          <p:spPr>
            <a:xfrm rot="16200000">
              <a:off x="-873712" y="7979793"/>
              <a:ext cx="6984774" cy="991109"/>
            </a:xfrm>
            <a:prstGeom prst="rect">
              <a:avLst/>
            </a:prstGeom>
            <a:noFill/>
          </p:spPr>
          <p:txBody>
            <a:bodyPr wrap="square" lIns="417643" tIns="208822" rIns="417643" bIns="208822" rtlCol="0">
              <a:spAutoFit/>
            </a:bodyPr>
            <a:lstStyle/>
            <a:p>
              <a:pPr algn="ctr"/>
              <a:r>
                <a:rPr lang="de-DE" sz="3700" dirty="0"/>
                <a:t>CSA </a:t>
              </a:r>
              <a:r>
                <a:rPr lang="de-DE" sz="3700" dirty="0" smtClean="0"/>
                <a:t>(50X ONT+ </a:t>
              </a:r>
              <a:r>
                <a:rPr lang="de-DE" sz="3700" i="1" dirty="0" err="1" smtClean="0"/>
                <a:t>P.abelii</a:t>
              </a:r>
              <a:r>
                <a:rPr lang="de-DE" sz="3700" dirty="0" smtClean="0"/>
                <a:t>)</a:t>
              </a:r>
              <a:endParaRPr lang="en-US" sz="3700" dirty="0"/>
            </a:p>
          </p:txBody>
        </p:sp>
        <p:sp>
          <p:nvSpPr>
            <p:cNvPr id="17" name="TextBox 32"/>
            <p:cNvSpPr txBox="1"/>
            <p:nvPr/>
          </p:nvSpPr>
          <p:spPr>
            <a:xfrm>
              <a:off x="1998003" y="2921146"/>
              <a:ext cx="12782798" cy="1837495"/>
            </a:xfrm>
            <a:prstGeom prst="rect">
              <a:avLst/>
            </a:prstGeom>
            <a:noFill/>
          </p:spPr>
          <p:txBody>
            <a:bodyPr wrap="square" lIns="417643" tIns="208822" rIns="417643" bIns="208822" rtlCol="0">
              <a:spAutoFit/>
            </a:bodyPr>
            <a:lstStyle/>
            <a:p>
              <a:r>
                <a:rPr lang="de-DE" sz="4600" i="1" dirty="0"/>
                <a:t>H. sapiens</a:t>
              </a:r>
              <a:r>
                <a:rPr lang="de-DE" sz="4600" dirty="0"/>
                <a:t>: </a:t>
              </a:r>
              <a:r>
                <a:rPr lang="de-DE" sz="4600" dirty="0" smtClean="0"/>
                <a:t>Ultra </a:t>
              </a:r>
              <a:r>
                <a:rPr lang="de-DE" sz="4600" dirty="0" err="1" smtClean="0"/>
                <a:t>long</a:t>
              </a:r>
              <a:r>
                <a:rPr lang="de-DE" sz="4600" dirty="0" smtClean="0"/>
                <a:t> </a:t>
              </a:r>
              <a:r>
                <a:rPr lang="de-DE" sz="4600" dirty="0" err="1" smtClean="0"/>
                <a:t>read</a:t>
              </a:r>
              <a:r>
                <a:rPr lang="de-DE" sz="4600" dirty="0" smtClean="0"/>
                <a:t> </a:t>
              </a:r>
              <a:r>
                <a:rPr lang="de-DE" sz="4600" dirty="0" err="1" smtClean="0"/>
                <a:t>assembly</a:t>
              </a:r>
              <a:r>
                <a:rPr lang="de-DE" sz="4600" dirty="0" smtClean="0"/>
                <a:t> </a:t>
              </a:r>
            </a:p>
            <a:p>
              <a:r>
                <a:rPr lang="de-DE" sz="4600" dirty="0" smtClean="0"/>
                <a:t>                     + div. </a:t>
              </a:r>
              <a:r>
                <a:rPr lang="de-DE" sz="4600" dirty="0" err="1" smtClean="0"/>
                <a:t>reference</a:t>
              </a:r>
              <a:r>
                <a:rPr lang="de-DE" sz="4600" dirty="0" smtClean="0"/>
                <a:t> </a:t>
              </a:r>
              <a:endParaRPr lang="en-US" sz="4600" dirty="0"/>
            </a:p>
          </p:txBody>
        </p:sp>
        <p:sp>
          <p:nvSpPr>
            <p:cNvPr id="21" name="TextBox 33"/>
            <p:cNvSpPr txBox="1"/>
            <p:nvPr/>
          </p:nvSpPr>
          <p:spPr>
            <a:xfrm>
              <a:off x="4963860" y="13555811"/>
              <a:ext cx="7079362" cy="991109"/>
            </a:xfrm>
            <a:prstGeom prst="rect">
              <a:avLst/>
            </a:prstGeom>
            <a:noFill/>
          </p:spPr>
          <p:txBody>
            <a:bodyPr wrap="square" lIns="417643" tIns="208822" rIns="417643" bIns="208822" rtlCol="0">
              <a:spAutoFit/>
            </a:bodyPr>
            <a:lstStyle/>
            <a:p>
              <a:pPr algn="ctr"/>
              <a:r>
                <a:rPr lang="de-DE" sz="3700" dirty="0"/>
                <a:t>Reference (GRCh38)</a:t>
              </a:r>
              <a:endParaRPr lang="en-US" sz="3700" dirty="0"/>
            </a:p>
          </p:txBody>
        </p:sp>
      </p:grpSp>
    </p:spTree>
    <p:extLst>
      <p:ext uri="{BB962C8B-B14F-4D97-AF65-F5344CB8AC3E}">
        <p14:creationId xmlns:p14="http://schemas.microsoft.com/office/powerpoint/2010/main" val="10557704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09</Words>
  <Application>Microsoft Office PowerPoint</Application>
  <PresentationFormat>Benutzerdefiniert</PresentationFormat>
  <Paragraphs>157</Paragraphs>
  <Slides>9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9</vt:i4>
      </vt:variant>
    </vt:vector>
  </HeadingPairs>
  <TitlesOfParts>
    <vt:vector size="10" baseType="lpstr">
      <vt:lpstr>Office Them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iner Kuhl</dc:creator>
  <cp:lastModifiedBy>Heiner Kuhl</cp:lastModifiedBy>
  <cp:revision>73</cp:revision>
  <cp:lastPrinted>2019-08-27T14:42:03Z</cp:lastPrinted>
  <dcterms:created xsi:type="dcterms:W3CDTF">2019-08-27T13:45:05Z</dcterms:created>
  <dcterms:modified xsi:type="dcterms:W3CDTF">2020-02-19T14:58:23Z</dcterms:modified>
</cp:coreProperties>
</file>